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68" r:id="rId4"/>
    <p:sldId id="265" r:id="rId5"/>
    <p:sldId id="267" r:id="rId6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70" autoAdjust="0"/>
    <p:restoredTop sz="94660"/>
  </p:normalViewPr>
  <p:slideViewPr>
    <p:cSldViewPr snapToGrid="0" showGuides="1">
      <p:cViewPr>
        <p:scale>
          <a:sx n="125" d="100"/>
          <a:sy n="125" d="100"/>
        </p:scale>
        <p:origin x="-144" y="13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6E96D-EC94-4830-B35D-D29097624A2A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8A227-60D5-42BB-A3F4-2F4A3B2D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714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6E96D-EC94-4830-B35D-D29097624A2A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8A227-60D5-42BB-A3F4-2F4A3B2D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428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6E96D-EC94-4830-B35D-D29097624A2A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8A227-60D5-42BB-A3F4-2F4A3B2D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4938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6E96D-EC94-4830-B35D-D29097624A2A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8A227-60D5-42BB-A3F4-2F4A3B2D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9193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6E96D-EC94-4830-B35D-D29097624A2A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8A227-60D5-42BB-A3F4-2F4A3B2D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8920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6E96D-EC94-4830-B35D-D29097624A2A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8A227-60D5-42BB-A3F4-2F4A3B2D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263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7"/>
            <a:ext cx="8543925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4"/>
            <a:ext cx="4190702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6"/>
            <a:ext cx="4190702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4" y="1681164"/>
            <a:ext cx="4211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4" y="2505076"/>
            <a:ext cx="4211340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6E96D-EC94-4830-B35D-D29097624A2A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8A227-60D5-42BB-A3F4-2F4A3B2D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7696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6E96D-EC94-4830-B35D-D29097624A2A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8A227-60D5-42BB-A3F4-2F4A3B2D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4846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6E96D-EC94-4830-B35D-D29097624A2A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8A227-60D5-42BB-A3F4-2F4A3B2D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682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7"/>
            <a:ext cx="5014913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6E96D-EC94-4830-B35D-D29097624A2A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8A227-60D5-42BB-A3F4-2F4A3B2D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6267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7"/>
            <a:ext cx="5014913" cy="4873625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56E96D-EC94-4830-B35D-D29097624A2A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8A227-60D5-42BB-A3F4-2F4A3B2D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725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56E96D-EC94-4830-B35D-D29097624A2A}" type="datetimeFigureOut">
              <a:rPr lang="en-US" smtClean="0"/>
              <a:t>5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58A227-60D5-42BB-A3F4-2F4A3B2D8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736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61752" y="3749201"/>
            <a:ext cx="887128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 smtClean="0">
                <a:latin typeface="Helvetica" pitchFamily="34" charset="0"/>
              </a:rPr>
              <a:t> Fig S1: Genes targeted for detection by PCR and qPCR experiments</a:t>
            </a:r>
            <a:r>
              <a:rPr lang="en-US" sz="800" dirty="0" smtClean="0">
                <a:latin typeface="Helvetica" pitchFamily="34" charset="0"/>
              </a:rPr>
              <a:t>. </a:t>
            </a:r>
            <a:endParaRPr lang="en-US" sz="800" dirty="0">
              <a:latin typeface="Helvetica" pitchFamily="34" charset="0"/>
            </a:endParaRPr>
          </a:p>
        </p:txBody>
      </p:sp>
      <p:pic>
        <p:nvPicPr>
          <p:cNvPr id="5" name="Picture 2" descr="H:\TransgeneSens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1" t="23651" r="7451" b="29564"/>
          <a:stretch/>
        </p:blipFill>
        <p:spPr bwMode="auto">
          <a:xfrm>
            <a:off x="1020022" y="673556"/>
            <a:ext cx="8320000" cy="8871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ZoneTexte 5"/>
          <p:cNvSpPr txBox="1"/>
          <p:nvPr/>
        </p:nvSpPr>
        <p:spPr>
          <a:xfrm>
            <a:off x="1099414" y="507386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  <a:endParaRPr lang="en-US" dirty="0"/>
          </a:p>
        </p:txBody>
      </p:sp>
      <p:sp>
        <p:nvSpPr>
          <p:cNvPr id="8" name="ZoneTexte 7"/>
          <p:cNvSpPr txBox="1"/>
          <p:nvPr/>
        </p:nvSpPr>
        <p:spPr>
          <a:xfrm>
            <a:off x="921227" y="152425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</a:t>
            </a:r>
            <a:endParaRPr lang="en-US" dirty="0"/>
          </a:p>
        </p:txBody>
      </p:sp>
      <p:graphicFrame>
        <p:nvGraphicFramePr>
          <p:cNvPr id="10" name="Tableau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0840158"/>
              </p:ext>
            </p:extLst>
          </p:nvPr>
        </p:nvGraphicFramePr>
        <p:xfrm>
          <a:off x="1011240" y="1734069"/>
          <a:ext cx="8319997" cy="1694930"/>
        </p:xfrm>
        <a:graphic>
          <a:graphicData uri="http://schemas.openxmlformats.org/drawingml/2006/table">
            <a:tbl>
              <a:tblPr/>
              <a:tblGrid>
                <a:gridCol w="865502"/>
                <a:gridCol w="865502"/>
                <a:gridCol w="865502"/>
                <a:gridCol w="2261483"/>
                <a:gridCol w="865502"/>
                <a:gridCol w="865502"/>
                <a:gridCol w="865502"/>
                <a:gridCol w="865502"/>
              </a:tblGrid>
              <a:tr h="19633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 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R type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imer name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imer sequence 5'-3'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 (°C)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 (s)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duct (pb)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017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S rRNA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ular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AGTTTGATCCTGGCTCAG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00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017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GGAGGTGATCCAGCCGCA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017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ptII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ular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6-nptIIs1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GCAGGTTCTCCGGCC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0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is study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017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8-nptIIr1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GCGATACCGTAAAGCACG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633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Large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ular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LargeF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CAAATGTTTGAACGATCGGGGAT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2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is study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017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LargeR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CCATTCGACCACCAAGCG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017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S rRNA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PCR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338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CCTACGGGAGGCAGCAG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6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017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ub518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TACCGCGGCTGCTGG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017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S rRNA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PCR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Sf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CCTGTTAACTTTCGATGGTA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1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is study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017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Sr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GAGCTTTTTAACTGCAGCAAC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017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ptIIsens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PCR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ptIIsensF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AGATGGATTGCACGCAGG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0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is study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017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ptIIsensR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TGACAAAAAGAACCGGGCG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017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Short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PCR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ShortF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ATCATCGCAAGACCGGCA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9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is study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017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ShortR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GATATCTTGCTGCGTTCG</a:t>
                      </a: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78" marR="8378" marT="4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84551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043664" y="3902380"/>
            <a:ext cx="7818672" cy="2339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800" b="1" dirty="0" smtClean="0">
                <a:latin typeface="Helvetica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 S2 : Microbial diversity</a:t>
            </a:r>
            <a:r>
              <a:rPr lang="en-US" sz="800" dirty="0" smtClean="0">
                <a:latin typeface="Helvetica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800" b="1" dirty="0" smtClean="0">
                <a:latin typeface="Helvetica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parison between leaf (</a:t>
            </a:r>
            <a:r>
              <a:rPr lang="en-US" sz="800" b="1" dirty="0" err="1" smtClean="0">
                <a:latin typeface="Helvetica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Aseq</a:t>
            </a:r>
            <a:r>
              <a:rPr lang="en-US" sz="800" b="1" dirty="0" smtClean="0">
                <a:latin typeface="Helvetica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2x150) and soil samples (</a:t>
            </a:r>
            <a:r>
              <a:rPr lang="en-US" sz="800" b="1" dirty="0" err="1" smtClean="0">
                <a:latin typeface="Helvetica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seq</a:t>
            </a:r>
            <a:r>
              <a:rPr lang="en-US" sz="800" b="1" dirty="0" smtClean="0">
                <a:latin typeface="Helvetica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equencing).</a:t>
            </a:r>
            <a:r>
              <a:rPr lang="en-US" sz="800" dirty="0" smtClean="0">
                <a:latin typeface="Helvetica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800" dirty="0">
              <a:latin typeface="Helvetica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3000" y="995205"/>
            <a:ext cx="8320000" cy="28407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59074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e 28"/>
          <p:cNvGrpSpPr/>
          <p:nvPr/>
        </p:nvGrpSpPr>
        <p:grpSpPr>
          <a:xfrm>
            <a:off x="437806" y="680062"/>
            <a:ext cx="2855170" cy="5195034"/>
            <a:chOff x="437806" y="450208"/>
            <a:chExt cx="2855170" cy="5195034"/>
          </a:xfrm>
        </p:grpSpPr>
        <p:cxnSp>
          <p:nvCxnSpPr>
            <p:cNvPr id="5" name="Connecteur droit 4"/>
            <p:cNvCxnSpPr/>
            <p:nvPr/>
          </p:nvCxnSpPr>
          <p:spPr>
            <a:xfrm>
              <a:off x="2884896" y="925574"/>
              <a:ext cx="0" cy="97975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ZoneTexte 5"/>
            <p:cNvSpPr txBox="1"/>
            <p:nvPr/>
          </p:nvSpPr>
          <p:spPr>
            <a:xfrm>
              <a:off x="2879384" y="1254766"/>
              <a:ext cx="210314" cy="2040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26" dirty="0">
                  <a:latin typeface="Helvetica" pitchFamily="34" charset="0"/>
                </a:rPr>
                <a:t>I</a:t>
              </a:r>
            </a:p>
          </p:txBody>
        </p:sp>
        <p:cxnSp>
          <p:nvCxnSpPr>
            <p:cNvPr id="7" name="Connecteur droit 6"/>
            <p:cNvCxnSpPr/>
            <p:nvPr/>
          </p:nvCxnSpPr>
          <p:spPr>
            <a:xfrm>
              <a:off x="2884896" y="1955412"/>
              <a:ext cx="0" cy="117570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ZoneTexte 7"/>
            <p:cNvSpPr txBox="1"/>
            <p:nvPr/>
          </p:nvSpPr>
          <p:spPr>
            <a:xfrm>
              <a:off x="2879384" y="2318385"/>
              <a:ext cx="235962" cy="2040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26" dirty="0">
                  <a:latin typeface="Helvetica" pitchFamily="34" charset="0"/>
                </a:rPr>
                <a:t>II</a:t>
              </a:r>
            </a:p>
          </p:txBody>
        </p:sp>
        <p:cxnSp>
          <p:nvCxnSpPr>
            <p:cNvPr id="9" name="Connecteur droit 8"/>
            <p:cNvCxnSpPr/>
            <p:nvPr/>
          </p:nvCxnSpPr>
          <p:spPr>
            <a:xfrm>
              <a:off x="2885355" y="3163192"/>
              <a:ext cx="0" cy="248205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ZoneTexte 9"/>
            <p:cNvSpPr txBox="1"/>
            <p:nvPr/>
          </p:nvSpPr>
          <p:spPr>
            <a:xfrm>
              <a:off x="2879844" y="4140805"/>
              <a:ext cx="261610" cy="2040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26" dirty="0">
                  <a:latin typeface="Helvetica" pitchFamily="34" charset="0"/>
                </a:rPr>
                <a:t>III</a:t>
              </a:r>
            </a:p>
          </p:txBody>
        </p:sp>
        <p:cxnSp>
          <p:nvCxnSpPr>
            <p:cNvPr id="11" name="Connecteur droit 10"/>
            <p:cNvCxnSpPr/>
            <p:nvPr/>
          </p:nvCxnSpPr>
          <p:spPr>
            <a:xfrm>
              <a:off x="3057714" y="542376"/>
              <a:ext cx="0" cy="35924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ZoneTexte 11"/>
            <p:cNvSpPr txBox="1"/>
            <p:nvPr/>
          </p:nvSpPr>
          <p:spPr>
            <a:xfrm>
              <a:off x="3052204" y="601125"/>
              <a:ext cx="240772" cy="2040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26" dirty="0">
                  <a:latin typeface="Helvetica" pitchFamily="34" charset="0"/>
                </a:rPr>
                <a:t>T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437806" y="450208"/>
              <a:ext cx="235962" cy="2040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26" dirty="0">
                  <a:latin typeface="Helvetica" pitchFamily="34" charset="0"/>
                </a:rPr>
                <a:t>a</a:t>
              </a:r>
            </a:p>
          </p:txBody>
        </p:sp>
      </p:grpSp>
      <p:grpSp>
        <p:nvGrpSpPr>
          <p:cNvPr id="28" name="Groupe 27"/>
          <p:cNvGrpSpPr/>
          <p:nvPr/>
        </p:nvGrpSpPr>
        <p:grpSpPr>
          <a:xfrm>
            <a:off x="3708470" y="737489"/>
            <a:ext cx="2657563" cy="3376467"/>
            <a:chOff x="3449966" y="483489"/>
            <a:chExt cx="2657563" cy="3376467"/>
          </a:xfrm>
        </p:grpSpPr>
        <p:cxnSp>
          <p:nvCxnSpPr>
            <p:cNvPr id="15" name="Connecteur droit 14"/>
            <p:cNvCxnSpPr/>
            <p:nvPr/>
          </p:nvCxnSpPr>
          <p:spPr>
            <a:xfrm>
              <a:off x="5850971" y="740011"/>
              <a:ext cx="0" cy="39190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ZoneTexte 15"/>
            <p:cNvSpPr txBox="1"/>
            <p:nvPr/>
          </p:nvSpPr>
          <p:spPr>
            <a:xfrm>
              <a:off x="5845460" y="819224"/>
              <a:ext cx="210314" cy="2040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26" dirty="0">
                  <a:latin typeface="Helvetica" pitchFamily="34" charset="0"/>
                </a:rPr>
                <a:t>I</a:t>
              </a:r>
            </a:p>
          </p:txBody>
        </p:sp>
        <p:cxnSp>
          <p:nvCxnSpPr>
            <p:cNvPr id="17" name="Connecteur droit 16"/>
            <p:cNvCxnSpPr/>
            <p:nvPr/>
          </p:nvCxnSpPr>
          <p:spPr>
            <a:xfrm>
              <a:off x="5850971" y="1183767"/>
              <a:ext cx="0" cy="42456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ZoneTexte 17"/>
            <p:cNvSpPr txBox="1"/>
            <p:nvPr/>
          </p:nvSpPr>
          <p:spPr>
            <a:xfrm>
              <a:off x="5845460" y="1294938"/>
              <a:ext cx="235962" cy="2040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26" dirty="0">
                  <a:latin typeface="Helvetica" pitchFamily="34" charset="0"/>
                </a:rPr>
                <a:t>II</a:t>
              </a:r>
            </a:p>
          </p:txBody>
        </p:sp>
        <p:cxnSp>
          <p:nvCxnSpPr>
            <p:cNvPr id="19" name="Connecteur droit 18"/>
            <p:cNvCxnSpPr/>
            <p:nvPr/>
          </p:nvCxnSpPr>
          <p:spPr>
            <a:xfrm>
              <a:off x="5851430" y="1639174"/>
              <a:ext cx="0" cy="22207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ZoneTexte 19"/>
            <p:cNvSpPr txBox="1"/>
            <p:nvPr/>
          </p:nvSpPr>
          <p:spPr>
            <a:xfrm>
              <a:off x="5845919" y="2677602"/>
              <a:ext cx="261610" cy="2040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26" dirty="0">
                  <a:latin typeface="Helvetica" pitchFamily="34" charset="0"/>
                </a:rPr>
                <a:t>III</a:t>
              </a:r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3449966" y="483489"/>
              <a:ext cx="235962" cy="2040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26" dirty="0">
                  <a:latin typeface="Helvetica" pitchFamily="34" charset="0"/>
                </a:rPr>
                <a:t>b</a:t>
              </a:r>
            </a:p>
          </p:txBody>
        </p:sp>
      </p:grpSp>
      <p:grpSp>
        <p:nvGrpSpPr>
          <p:cNvPr id="27" name="Groupe 26"/>
          <p:cNvGrpSpPr/>
          <p:nvPr/>
        </p:nvGrpSpPr>
        <p:grpSpPr>
          <a:xfrm>
            <a:off x="6981679" y="697615"/>
            <a:ext cx="2132576" cy="3765676"/>
            <a:chOff x="6981679" y="653433"/>
            <a:chExt cx="2132576" cy="3765676"/>
          </a:xfrm>
        </p:grpSpPr>
        <p:sp>
          <p:nvSpPr>
            <p:cNvPr id="23" name="ZoneTexte 22"/>
            <p:cNvSpPr txBox="1"/>
            <p:nvPr/>
          </p:nvSpPr>
          <p:spPr>
            <a:xfrm>
              <a:off x="8903941" y="3343816"/>
              <a:ext cx="210314" cy="2040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26" dirty="0">
                  <a:latin typeface="Helvetica" pitchFamily="34" charset="0"/>
                </a:rPr>
                <a:t>I</a:t>
              </a:r>
            </a:p>
          </p:txBody>
        </p:sp>
        <p:cxnSp>
          <p:nvCxnSpPr>
            <p:cNvPr id="24" name="Connecteur droit 23"/>
            <p:cNvCxnSpPr/>
            <p:nvPr/>
          </p:nvCxnSpPr>
          <p:spPr>
            <a:xfrm>
              <a:off x="8909911" y="2720864"/>
              <a:ext cx="0" cy="169824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ZoneTexte 24"/>
            <p:cNvSpPr txBox="1"/>
            <p:nvPr/>
          </p:nvSpPr>
          <p:spPr>
            <a:xfrm>
              <a:off x="6981679" y="653433"/>
              <a:ext cx="231154" cy="2040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26" dirty="0">
                  <a:latin typeface="Helvetica" pitchFamily="34" charset="0"/>
                </a:rPr>
                <a:t>c</a:t>
              </a:r>
            </a:p>
          </p:txBody>
        </p:sp>
      </p:grpSp>
      <p:sp>
        <p:nvSpPr>
          <p:cNvPr id="30" name="ZoneTexte 29"/>
          <p:cNvSpPr txBox="1"/>
          <p:nvPr/>
        </p:nvSpPr>
        <p:spPr>
          <a:xfrm>
            <a:off x="595370" y="6247329"/>
            <a:ext cx="8873750" cy="2040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26" b="1" dirty="0" err="1">
                <a:latin typeface="Helvetica" pitchFamily="34" charset="0"/>
              </a:rPr>
              <a:t>Fig</a:t>
            </a:r>
            <a:r>
              <a:rPr lang="fr-FR" sz="726" b="1" dirty="0">
                <a:latin typeface="Helvetica" pitchFamily="34" charset="0"/>
              </a:rPr>
              <a:t> S3: </a:t>
            </a:r>
            <a:r>
              <a:rPr lang="fr-FR" sz="726" b="1" dirty="0" err="1">
                <a:latin typeface="Helvetica" pitchFamily="34" charset="0"/>
              </a:rPr>
              <a:t>Phylogenetic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relationships</a:t>
            </a:r>
            <a:r>
              <a:rPr lang="fr-FR" sz="726" b="1" dirty="0">
                <a:latin typeface="Helvetica" pitchFamily="34" charset="0"/>
              </a:rPr>
              <a:t> of </a:t>
            </a:r>
            <a:r>
              <a:rPr lang="fr-FR" sz="726" b="1" dirty="0" err="1">
                <a:latin typeface="Helvetica" pitchFamily="34" charset="0"/>
              </a:rPr>
              <a:t>satRNA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genomes</a:t>
            </a:r>
            <a:r>
              <a:rPr lang="fr-FR" sz="726" b="1" dirty="0">
                <a:latin typeface="Helvetica" pitchFamily="34" charset="0"/>
              </a:rPr>
              <a:t> (a), GFLV </a:t>
            </a:r>
            <a:r>
              <a:rPr lang="fr-FR" sz="726" b="1" i="1" dirty="0" err="1">
                <a:latin typeface="Helvetica" pitchFamily="34" charset="0"/>
              </a:rPr>
              <a:t>cp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gene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sequences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from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RNAseq</a:t>
            </a:r>
            <a:r>
              <a:rPr lang="fr-FR" sz="726" b="1" dirty="0">
                <a:latin typeface="Helvetica" pitchFamily="34" charset="0"/>
              </a:rPr>
              <a:t> (b) and </a:t>
            </a:r>
            <a:r>
              <a:rPr lang="fr-FR" sz="726" b="1" dirty="0" err="1">
                <a:latin typeface="Helvetica" pitchFamily="34" charset="0"/>
              </a:rPr>
              <a:t>from</a:t>
            </a:r>
            <a:r>
              <a:rPr lang="fr-FR" sz="726" b="1" dirty="0">
                <a:latin typeface="Helvetica" pitchFamily="34" charset="0"/>
              </a:rPr>
              <a:t> IC-RT-PCR NGS-</a:t>
            </a:r>
            <a:r>
              <a:rPr lang="fr-FR" sz="726" b="1" dirty="0" err="1">
                <a:latin typeface="Helvetica" pitchFamily="34" charset="0"/>
              </a:rPr>
              <a:t>based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dataset</a:t>
            </a:r>
            <a:r>
              <a:rPr lang="fr-FR" sz="726" b="1" dirty="0">
                <a:latin typeface="Helvetica" pitchFamily="34" charset="0"/>
              </a:rPr>
              <a:t> (c)</a:t>
            </a:r>
            <a:endParaRPr lang="en-US" sz="726" dirty="0">
              <a:latin typeface="Helvetica" pitchFamily="34" charset="0"/>
            </a:endParaRPr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728" y="522687"/>
            <a:ext cx="2854800" cy="5349793"/>
          </a:xfrm>
          <a:prstGeom prst="rect">
            <a:avLst/>
          </a:prstGeom>
        </p:spPr>
      </p:pic>
      <p:pic>
        <p:nvPicPr>
          <p:cNvPr id="31" name="Image 3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9279" y="581026"/>
            <a:ext cx="2613600" cy="3556263"/>
          </a:xfrm>
          <a:prstGeom prst="rect">
            <a:avLst/>
          </a:prstGeom>
        </p:spPr>
      </p:pic>
      <p:pic>
        <p:nvPicPr>
          <p:cNvPr id="32" name="Image 3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76696" y="552451"/>
            <a:ext cx="2613600" cy="39116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32863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939781" y="1733132"/>
            <a:ext cx="8006375" cy="132261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63"/>
          </a:p>
        </p:txBody>
      </p:sp>
      <p:sp>
        <p:nvSpPr>
          <p:cNvPr id="5" name="Rectangle 4"/>
          <p:cNvSpPr/>
          <p:nvPr/>
        </p:nvSpPr>
        <p:spPr>
          <a:xfrm>
            <a:off x="939781" y="375560"/>
            <a:ext cx="8006375" cy="132261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63"/>
          </a:p>
        </p:txBody>
      </p:sp>
      <p:sp>
        <p:nvSpPr>
          <p:cNvPr id="7" name="ZoneTexte 6"/>
          <p:cNvSpPr txBox="1"/>
          <p:nvPr/>
        </p:nvSpPr>
        <p:spPr>
          <a:xfrm>
            <a:off x="4843917" y="632703"/>
            <a:ext cx="616139" cy="1299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4" dirty="0"/>
              <a:t>AAAAAA</a:t>
            </a:r>
            <a:endParaRPr lang="en-US" sz="244" dirty="0"/>
          </a:p>
        </p:txBody>
      </p:sp>
      <p:sp>
        <p:nvSpPr>
          <p:cNvPr id="11" name="ZoneTexte 10"/>
          <p:cNvSpPr txBox="1"/>
          <p:nvPr/>
        </p:nvSpPr>
        <p:spPr>
          <a:xfrm>
            <a:off x="928689" y="347585"/>
            <a:ext cx="1717971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63" dirty="0"/>
              <a:t>a. </a:t>
            </a:r>
            <a:r>
              <a:rPr lang="fr-FR" sz="1300" dirty="0"/>
              <a:t>GFLV-RNA3</a:t>
            </a:r>
            <a:r>
              <a:rPr lang="fr-FR" sz="1138" dirty="0"/>
              <a:t> (</a:t>
            </a:r>
            <a:r>
              <a:rPr lang="fr-FR" sz="1138" dirty="0" err="1"/>
              <a:t>RNAseq</a:t>
            </a:r>
            <a:r>
              <a:rPr lang="fr-FR" sz="1138" dirty="0"/>
              <a:t>)</a:t>
            </a:r>
          </a:p>
        </p:txBody>
      </p:sp>
      <p:sp>
        <p:nvSpPr>
          <p:cNvPr id="12" name="ZoneTexte 11"/>
          <p:cNvSpPr txBox="1"/>
          <p:nvPr/>
        </p:nvSpPr>
        <p:spPr>
          <a:xfrm>
            <a:off x="928689" y="1710500"/>
            <a:ext cx="2061013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63" dirty="0"/>
              <a:t>b. </a:t>
            </a:r>
            <a:r>
              <a:rPr lang="fr-FR" sz="1300" dirty="0"/>
              <a:t>GFLV-CP </a:t>
            </a:r>
            <a:r>
              <a:rPr lang="fr-FR" sz="1138" dirty="0">
                <a:solidFill>
                  <a:srgbClr val="FF0000"/>
                </a:solidFill>
              </a:rPr>
              <a:t>∆ clade I</a:t>
            </a:r>
            <a:r>
              <a:rPr lang="fr-FR" sz="1138" dirty="0"/>
              <a:t> (</a:t>
            </a:r>
            <a:r>
              <a:rPr lang="fr-FR" sz="1138" dirty="0" err="1"/>
              <a:t>RNAseq</a:t>
            </a:r>
            <a:r>
              <a:rPr lang="fr-FR" sz="1138" dirty="0"/>
              <a:t>)</a:t>
            </a:r>
          </a:p>
        </p:txBody>
      </p:sp>
      <p:grpSp>
        <p:nvGrpSpPr>
          <p:cNvPr id="14" name="Groupe 232"/>
          <p:cNvGrpSpPr/>
          <p:nvPr/>
        </p:nvGrpSpPr>
        <p:grpSpPr>
          <a:xfrm>
            <a:off x="1254391" y="1854313"/>
            <a:ext cx="3699437" cy="198710"/>
            <a:chOff x="255980" y="5423757"/>
            <a:chExt cx="3152183" cy="353264"/>
          </a:xfrm>
        </p:grpSpPr>
        <p:sp>
          <p:nvSpPr>
            <p:cNvPr id="46" name="Rectangle 45"/>
            <p:cNvSpPr/>
            <p:nvPr/>
          </p:nvSpPr>
          <p:spPr>
            <a:xfrm>
              <a:off x="380051" y="5616803"/>
              <a:ext cx="2934000" cy="144000"/>
            </a:xfrm>
            <a:prstGeom prst="rect">
              <a:avLst/>
            </a:prstGeom>
            <a:solidFill>
              <a:schemeClr val="accent6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975" dirty="0">
                  <a:solidFill>
                    <a:schemeClr val="tx1"/>
                  </a:solidFill>
                </a:rPr>
                <a:t>2C</a:t>
              </a:r>
              <a:r>
                <a:rPr lang="fr-FR" sz="975" baseline="30000" dirty="0">
                  <a:solidFill>
                    <a:schemeClr val="tx1"/>
                  </a:solidFill>
                </a:rPr>
                <a:t>CP</a:t>
              </a:r>
              <a:endParaRPr lang="en-US" sz="975" dirty="0"/>
            </a:p>
          </p:txBody>
        </p:sp>
        <p:sp>
          <p:nvSpPr>
            <p:cNvPr id="47" name="ZoneTexte 46"/>
            <p:cNvSpPr txBox="1"/>
            <p:nvPr/>
          </p:nvSpPr>
          <p:spPr>
            <a:xfrm>
              <a:off x="255980" y="5423757"/>
              <a:ext cx="299399" cy="3419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50" dirty="0"/>
                <a:t>2047</a:t>
              </a:r>
              <a:endParaRPr lang="en-US" sz="650" dirty="0"/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3108764" y="5435046"/>
              <a:ext cx="299399" cy="3419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50" dirty="0"/>
                <a:t>3559</a:t>
              </a:r>
              <a:endParaRPr lang="en-US" sz="650" dirty="0"/>
            </a:p>
          </p:txBody>
        </p:sp>
        <p:cxnSp>
          <p:nvCxnSpPr>
            <p:cNvPr id="49" name="Connecteur droit 48"/>
            <p:cNvCxnSpPr/>
            <p:nvPr/>
          </p:nvCxnSpPr>
          <p:spPr>
            <a:xfrm>
              <a:off x="372628" y="5773504"/>
              <a:ext cx="2952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2" name="3 CuadroTexto"/>
          <p:cNvSpPr txBox="1">
            <a:spLocks noChangeArrowheads="1"/>
          </p:cNvSpPr>
          <p:nvPr/>
        </p:nvSpPr>
        <p:spPr bwMode="auto">
          <a:xfrm>
            <a:off x="5882603" y="1389077"/>
            <a:ext cx="1401346" cy="2174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13" i="1" dirty="0"/>
              <a:t>F</a:t>
            </a:r>
            <a:r>
              <a:rPr lang="en-GB" sz="813" i="1" baseline="-25000" dirty="0"/>
              <a:t>ST(WT/GM)</a:t>
            </a:r>
            <a:r>
              <a:rPr lang="en-GB" sz="813" dirty="0"/>
              <a:t> = -0.013 ; </a:t>
            </a:r>
            <a:r>
              <a:rPr lang="en-GB" sz="813" i="1" dirty="0"/>
              <a:t>P </a:t>
            </a:r>
            <a:r>
              <a:rPr lang="en-GB" sz="813" dirty="0"/>
              <a:t>= 0.645</a:t>
            </a:r>
          </a:p>
        </p:txBody>
      </p:sp>
      <p:graphicFrame>
        <p:nvGraphicFramePr>
          <p:cNvPr id="133" name="Tableau 13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6424395"/>
              </p:ext>
            </p:extLst>
          </p:nvPr>
        </p:nvGraphicFramePr>
        <p:xfrm>
          <a:off x="5037511" y="508164"/>
          <a:ext cx="3887431" cy="82611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55569"/>
                <a:gridCol w="371882"/>
                <a:gridCol w="862736"/>
                <a:gridCol w="845094"/>
                <a:gridCol w="1352150"/>
              </a:tblGrid>
              <a:tr h="96783"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>
                          <a:solidFill>
                            <a:sysClr val="windowText" lastClr="000000"/>
                          </a:solidFill>
                        </a:rPr>
                        <a:t>Pop.</a:t>
                      </a:r>
                      <a:endParaRPr lang="fr-FR" sz="3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>
                          <a:solidFill>
                            <a:sysClr val="windowText" lastClr="000000"/>
                          </a:solidFill>
                        </a:rPr>
                        <a:t>N</a:t>
                      </a:r>
                      <a:endParaRPr lang="fr-FR" sz="3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sz="300" dirty="0" smtClean="0">
                          <a:solidFill>
                            <a:sysClr val="windowText" lastClr="000000"/>
                          </a:solidFill>
                        </a:rPr>
                        <a:t>π</a:t>
                      </a:r>
                      <a:r>
                        <a:rPr lang="es-ES_tradnl" sz="300" dirty="0" smtClean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el-GR" sz="300" b="0" dirty="0" smtClean="0">
                          <a:solidFill>
                            <a:sysClr val="windowText" lastClr="000000"/>
                          </a:solidFill>
                        </a:rPr>
                        <a:t>±</a:t>
                      </a:r>
                      <a:r>
                        <a:rPr lang="es-ES_tradnl" sz="300" b="0" dirty="0" smtClean="0">
                          <a:solidFill>
                            <a:sysClr val="windowText" lastClr="000000"/>
                          </a:solidFill>
                        </a:rPr>
                        <a:t> SE</a:t>
                      </a:r>
                      <a:endParaRPr lang="en-GB" sz="300" b="0" dirty="0" smtClean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300" i="1" baseline="0" dirty="0" err="1" smtClean="0">
                          <a:solidFill>
                            <a:sysClr val="windowText" lastClr="000000"/>
                          </a:solidFill>
                        </a:rPr>
                        <a:t>d</a:t>
                      </a:r>
                      <a:r>
                        <a:rPr lang="en-GB" sz="300" i="1" baseline="-25000" dirty="0" err="1" smtClean="0">
                          <a:solidFill>
                            <a:sysClr val="windowText" lastClr="000000"/>
                          </a:solidFill>
                        </a:rPr>
                        <a:t>N</a:t>
                      </a:r>
                      <a:r>
                        <a:rPr lang="en-GB" sz="300" i="1" baseline="0" dirty="0" smtClean="0">
                          <a:solidFill>
                            <a:sysClr val="windowText" lastClr="000000"/>
                          </a:solidFill>
                        </a:rPr>
                        <a:t> - </a:t>
                      </a:r>
                      <a:r>
                        <a:rPr lang="en-GB" sz="300" i="1" baseline="0" dirty="0" err="1" smtClean="0">
                          <a:solidFill>
                            <a:sysClr val="windowText" lastClr="000000"/>
                          </a:solidFill>
                        </a:rPr>
                        <a:t>d</a:t>
                      </a:r>
                      <a:r>
                        <a:rPr lang="en-GB" sz="300" i="1" baseline="-25000" dirty="0" err="1" smtClean="0">
                          <a:solidFill>
                            <a:sysClr val="windowText" lastClr="000000"/>
                          </a:solidFill>
                        </a:rPr>
                        <a:t>S</a:t>
                      </a:r>
                      <a:r>
                        <a:rPr lang="en-GB" sz="300" i="1" baseline="0" dirty="0" smtClean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el-GR" sz="300" b="0" dirty="0" smtClean="0">
                          <a:solidFill>
                            <a:sysClr val="windowText" lastClr="000000"/>
                          </a:solidFill>
                        </a:rPr>
                        <a:t>±</a:t>
                      </a:r>
                      <a:r>
                        <a:rPr lang="es-ES_tradnl" sz="300" b="0" dirty="0" smtClean="0">
                          <a:solidFill>
                            <a:sysClr val="windowText" lastClr="000000"/>
                          </a:solidFill>
                        </a:rPr>
                        <a:t> SE</a:t>
                      </a:r>
                      <a:endParaRPr lang="en-GB" sz="300" i="0" baseline="0" dirty="0" smtClean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_tradnl" sz="300" i="1" dirty="0" smtClean="0">
                          <a:solidFill>
                            <a:sysClr val="windowText" lastClr="000000"/>
                          </a:solidFill>
                        </a:rPr>
                        <a:t>D</a:t>
                      </a:r>
                      <a:r>
                        <a:rPr lang="es-ES_tradnl" sz="300" i="1" baseline="-25000" dirty="0" smtClean="0">
                          <a:solidFill>
                            <a:sysClr val="windowText" lastClr="000000"/>
                          </a:solidFill>
                        </a:rPr>
                        <a:t>T</a:t>
                      </a:r>
                      <a:endParaRPr lang="en-GB" sz="300" i="1" baseline="-25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>
                          <a:solidFill>
                            <a:sysClr val="windowText" lastClr="000000"/>
                          </a:solidFill>
                        </a:rPr>
                        <a:t>All</a:t>
                      </a:r>
                      <a:endParaRPr lang="fr-FR" sz="3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/>
                        <a:t>31</a:t>
                      </a:r>
                      <a:endParaRPr lang="fr-FR" sz="300" b="1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/>
                        <a:t>0.0106 </a:t>
                      </a:r>
                      <a:r>
                        <a:rPr lang="el-GR" sz="300" b="1" dirty="0" smtClean="0"/>
                        <a:t>±</a:t>
                      </a:r>
                      <a:r>
                        <a:rPr lang="fr-FR" sz="300" b="1" dirty="0" smtClean="0"/>
                        <a:t> 0.0018</a:t>
                      </a:r>
                      <a:endParaRPr lang="fr-FR" sz="300" b="1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/>
                        <a:t>-0.0049 </a:t>
                      </a:r>
                      <a:r>
                        <a:rPr lang="el-GR" sz="300" b="1" dirty="0" smtClean="0"/>
                        <a:t>±</a:t>
                      </a:r>
                      <a:r>
                        <a:rPr lang="fr-FR" sz="300" b="1" dirty="0" smtClean="0"/>
                        <a:t> 0.0036</a:t>
                      </a:r>
                      <a:endParaRPr lang="fr-FR" sz="300" b="1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300" b="1" i="1" dirty="0" smtClean="0"/>
                        <a:t>D</a:t>
                      </a:r>
                      <a:r>
                        <a:rPr lang="es-ES_tradnl" sz="300" b="1" baseline="-25000" dirty="0" smtClean="0"/>
                        <a:t>T</a:t>
                      </a:r>
                      <a:r>
                        <a:rPr lang="es-ES_tradnl" sz="300" b="1" dirty="0" smtClean="0"/>
                        <a:t> =</a:t>
                      </a:r>
                      <a:r>
                        <a:rPr lang="es-ES_tradnl" sz="300" b="1" baseline="0" dirty="0" smtClean="0"/>
                        <a:t> -1.106</a:t>
                      </a:r>
                      <a:r>
                        <a:rPr lang="es-ES_tradnl" sz="300" b="1" dirty="0" smtClean="0"/>
                        <a:t> (</a:t>
                      </a:r>
                      <a:r>
                        <a:rPr lang="es-ES_tradnl" sz="300" b="1" i="1" dirty="0" smtClean="0"/>
                        <a:t>P </a:t>
                      </a:r>
                      <a:r>
                        <a:rPr lang="es-ES_tradnl" sz="300" b="1" dirty="0" smtClean="0"/>
                        <a:t>&gt; 0.10)</a:t>
                      </a:r>
                      <a:endParaRPr lang="fr-FR" sz="300" b="1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>
                          <a:solidFill>
                            <a:srgbClr val="00B050"/>
                          </a:solidFill>
                        </a:rPr>
                        <a:t>WT</a:t>
                      </a:r>
                      <a:endParaRPr lang="fr-FR" sz="300" b="0" dirty="0">
                        <a:solidFill>
                          <a:srgbClr val="00B05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16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132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22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-0.0064 </a:t>
                      </a:r>
                      <a:r>
                        <a:rPr lang="el-GR" sz="300" dirty="0" smtClean="0"/>
                        <a:t>±</a:t>
                      </a:r>
                      <a:r>
                        <a:rPr lang="fr-FR" sz="300" dirty="0" smtClean="0"/>
                        <a:t> 0.0046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-0.885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 smtClean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>
                          <a:solidFill>
                            <a:srgbClr val="7030A0"/>
                          </a:solidFill>
                        </a:rPr>
                        <a:t>GM</a:t>
                      </a:r>
                      <a:endParaRPr lang="fr-FR" sz="300" b="0" dirty="0">
                        <a:solidFill>
                          <a:srgbClr val="7030A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15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080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16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-0.0030 </a:t>
                      </a:r>
                      <a:r>
                        <a:rPr lang="el-GR" sz="300" dirty="0" smtClean="0"/>
                        <a:t>±</a:t>
                      </a:r>
                      <a:r>
                        <a:rPr lang="fr-FR" sz="300" dirty="0" smtClean="0"/>
                        <a:t> 0.0035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-0.904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 smtClean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>
                          <a:solidFill>
                            <a:sysClr val="windowText" lastClr="000000"/>
                          </a:solidFill>
                        </a:rPr>
                        <a:t>WTR</a:t>
                      </a:r>
                      <a:endParaRPr lang="fr-FR" sz="3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6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076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19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-0.0037 </a:t>
                      </a:r>
                      <a:r>
                        <a:rPr lang="el-GR" sz="300" dirty="0" smtClean="0"/>
                        <a:t>±</a:t>
                      </a:r>
                      <a:r>
                        <a:rPr lang="fr-FR" sz="300" dirty="0" smtClean="0"/>
                        <a:t> 0.0040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-0.540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err="1" smtClean="0">
                          <a:solidFill>
                            <a:sysClr val="windowText" lastClr="000000"/>
                          </a:solidFill>
                        </a:rPr>
                        <a:t>ScWT</a:t>
                      </a:r>
                      <a:endParaRPr lang="fr-FR" sz="3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10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155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25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-0.0065 </a:t>
                      </a:r>
                      <a:r>
                        <a:rPr lang="el-GR" sz="300" dirty="0" smtClean="0"/>
                        <a:t>±</a:t>
                      </a:r>
                      <a:r>
                        <a:rPr lang="fr-FR" sz="300" dirty="0" smtClean="0"/>
                        <a:t> 0.0054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-0.363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>
                          <a:solidFill>
                            <a:sysClr val="windowText" lastClr="000000"/>
                          </a:solidFill>
                        </a:rPr>
                        <a:t>GMR</a:t>
                      </a:r>
                      <a:endParaRPr lang="fr-FR" sz="3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7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089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18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-0.0070 </a:t>
                      </a:r>
                      <a:r>
                        <a:rPr lang="el-GR" sz="300" dirty="0" smtClean="0"/>
                        <a:t>±</a:t>
                      </a:r>
                      <a:r>
                        <a:rPr lang="fr-FR" sz="300" dirty="0" smtClean="0"/>
                        <a:t> 0.0041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-1.116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err="1" smtClean="0">
                          <a:solidFill>
                            <a:sysClr val="windowText" lastClr="000000"/>
                          </a:solidFill>
                        </a:rPr>
                        <a:t>ScGM</a:t>
                      </a:r>
                      <a:endParaRPr lang="fr-FR" sz="3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8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068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16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0.0001 </a:t>
                      </a:r>
                      <a:r>
                        <a:rPr lang="el-GR" sz="300" dirty="0" smtClean="0"/>
                        <a:t>±</a:t>
                      </a:r>
                      <a:r>
                        <a:rPr lang="fr-FR" sz="300" dirty="0" smtClean="0"/>
                        <a:t> 0.0035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0.209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134" name="Tableau 13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76909252"/>
              </p:ext>
            </p:extLst>
          </p:nvPr>
        </p:nvGraphicFramePr>
        <p:xfrm>
          <a:off x="5037511" y="1864945"/>
          <a:ext cx="3887431" cy="82611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55569"/>
                <a:gridCol w="371882"/>
                <a:gridCol w="862736"/>
                <a:gridCol w="845094"/>
                <a:gridCol w="1352150"/>
              </a:tblGrid>
              <a:tr h="96783"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>
                          <a:solidFill>
                            <a:sysClr val="windowText" lastClr="000000"/>
                          </a:solidFill>
                        </a:rPr>
                        <a:t>Pop.</a:t>
                      </a:r>
                      <a:endParaRPr lang="fr-FR" sz="3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>
                          <a:solidFill>
                            <a:sysClr val="windowText" lastClr="000000"/>
                          </a:solidFill>
                        </a:rPr>
                        <a:t>N</a:t>
                      </a:r>
                      <a:endParaRPr lang="fr-FR" sz="3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sz="300" dirty="0" smtClean="0">
                          <a:solidFill>
                            <a:sysClr val="windowText" lastClr="000000"/>
                          </a:solidFill>
                        </a:rPr>
                        <a:t>π</a:t>
                      </a:r>
                      <a:r>
                        <a:rPr lang="es-ES_tradnl" sz="300" dirty="0" smtClean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el-GR" sz="300" b="0" dirty="0" smtClean="0">
                          <a:solidFill>
                            <a:sysClr val="windowText" lastClr="000000"/>
                          </a:solidFill>
                        </a:rPr>
                        <a:t>±</a:t>
                      </a:r>
                      <a:r>
                        <a:rPr lang="es-ES_tradnl" sz="300" b="0" dirty="0" smtClean="0">
                          <a:solidFill>
                            <a:sysClr val="windowText" lastClr="000000"/>
                          </a:solidFill>
                        </a:rPr>
                        <a:t> SE</a:t>
                      </a:r>
                      <a:endParaRPr lang="en-GB" sz="300" b="0" dirty="0" smtClean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300" i="1" baseline="0" dirty="0" err="1" smtClean="0">
                          <a:solidFill>
                            <a:sysClr val="windowText" lastClr="000000"/>
                          </a:solidFill>
                        </a:rPr>
                        <a:t>d</a:t>
                      </a:r>
                      <a:r>
                        <a:rPr lang="en-GB" sz="300" i="1" baseline="-25000" dirty="0" err="1" smtClean="0">
                          <a:solidFill>
                            <a:sysClr val="windowText" lastClr="000000"/>
                          </a:solidFill>
                        </a:rPr>
                        <a:t>N</a:t>
                      </a:r>
                      <a:r>
                        <a:rPr lang="en-GB" sz="300" i="1" baseline="0" dirty="0" smtClean="0">
                          <a:solidFill>
                            <a:sysClr val="windowText" lastClr="000000"/>
                          </a:solidFill>
                        </a:rPr>
                        <a:t> - </a:t>
                      </a:r>
                      <a:r>
                        <a:rPr lang="en-GB" sz="300" i="1" baseline="0" dirty="0" err="1" smtClean="0">
                          <a:solidFill>
                            <a:sysClr val="windowText" lastClr="000000"/>
                          </a:solidFill>
                        </a:rPr>
                        <a:t>d</a:t>
                      </a:r>
                      <a:r>
                        <a:rPr lang="en-GB" sz="300" i="1" baseline="-25000" dirty="0" err="1" smtClean="0">
                          <a:solidFill>
                            <a:sysClr val="windowText" lastClr="000000"/>
                          </a:solidFill>
                        </a:rPr>
                        <a:t>S</a:t>
                      </a:r>
                      <a:r>
                        <a:rPr lang="en-GB" sz="300" i="1" baseline="0" dirty="0" smtClean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el-GR" sz="300" b="0" dirty="0" smtClean="0">
                          <a:solidFill>
                            <a:sysClr val="windowText" lastClr="000000"/>
                          </a:solidFill>
                        </a:rPr>
                        <a:t>±</a:t>
                      </a:r>
                      <a:r>
                        <a:rPr lang="es-ES_tradnl" sz="300" b="0" dirty="0" smtClean="0">
                          <a:solidFill>
                            <a:sysClr val="windowText" lastClr="000000"/>
                          </a:solidFill>
                        </a:rPr>
                        <a:t> SE</a:t>
                      </a:r>
                      <a:endParaRPr lang="en-GB" sz="300" i="0" baseline="0" dirty="0" smtClean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_tradnl" sz="300" i="1" dirty="0" smtClean="0">
                          <a:solidFill>
                            <a:sysClr val="windowText" lastClr="000000"/>
                          </a:solidFill>
                        </a:rPr>
                        <a:t>D</a:t>
                      </a:r>
                      <a:r>
                        <a:rPr lang="es-ES_tradnl" sz="300" i="1" baseline="-25000" dirty="0" smtClean="0">
                          <a:solidFill>
                            <a:sysClr val="windowText" lastClr="000000"/>
                          </a:solidFill>
                        </a:rPr>
                        <a:t>T</a:t>
                      </a:r>
                      <a:endParaRPr lang="en-GB" sz="300" i="1" baseline="-25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>
                          <a:solidFill>
                            <a:sysClr val="windowText" lastClr="000000"/>
                          </a:solidFill>
                        </a:rPr>
                        <a:t>All</a:t>
                      </a:r>
                      <a:endParaRPr lang="fr-FR" sz="3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/>
                        <a:t>35</a:t>
                      </a:r>
                      <a:endParaRPr lang="fr-FR" sz="300" b="1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/>
                        <a:t>0.0184 </a:t>
                      </a:r>
                      <a:r>
                        <a:rPr lang="el-GR" sz="300" b="1" dirty="0" smtClean="0"/>
                        <a:t>±</a:t>
                      </a:r>
                      <a:r>
                        <a:rPr lang="fr-FR" sz="300" b="1" dirty="0" smtClean="0"/>
                        <a:t> 0.0021</a:t>
                      </a:r>
                      <a:endParaRPr lang="fr-FR" sz="300" b="1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/>
                        <a:t>-0.0454 </a:t>
                      </a:r>
                      <a:r>
                        <a:rPr lang="el-GR" sz="300" b="1" dirty="0" smtClean="0"/>
                        <a:t>±</a:t>
                      </a:r>
                      <a:r>
                        <a:rPr lang="fr-FR" sz="300" b="1" dirty="0" smtClean="0"/>
                        <a:t> 0.0063</a:t>
                      </a:r>
                      <a:endParaRPr lang="fr-FR" sz="300" b="1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_tradnl" sz="300" b="1" i="1" dirty="0" smtClean="0"/>
                        <a:t>D</a:t>
                      </a:r>
                      <a:r>
                        <a:rPr lang="es-ES_tradnl" sz="300" b="1" baseline="-25000" dirty="0" smtClean="0"/>
                        <a:t>T</a:t>
                      </a:r>
                      <a:r>
                        <a:rPr lang="es-ES_tradnl" sz="300" b="1" dirty="0" smtClean="0"/>
                        <a:t> = -0.467 (</a:t>
                      </a:r>
                      <a:r>
                        <a:rPr lang="es-ES_tradnl" sz="300" b="1" i="1" dirty="0" smtClean="0"/>
                        <a:t>P </a:t>
                      </a:r>
                      <a:r>
                        <a:rPr lang="es-ES_tradnl" sz="300" b="1" dirty="0" smtClean="0"/>
                        <a:t>&gt; 0.10)</a:t>
                      </a:r>
                      <a:endParaRPr lang="fr-FR" sz="300" b="1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>
                          <a:solidFill>
                            <a:srgbClr val="00B050"/>
                          </a:solidFill>
                        </a:rPr>
                        <a:t>WT</a:t>
                      </a:r>
                      <a:endParaRPr lang="fr-FR" sz="300" b="0" dirty="0">
                        <a:solidFill>
                          <a:srgbClr val="00B05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18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200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25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-0.0496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70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0.175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 smtClean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>
                          <a:solidFill>
                            <a:srgbClr val="7030A0"/>
                          </a:solidFill>
                        </a:rPr>
                        <a:t>GM</a:t>
                      </a:r>
                      <a:endParaRPr lang="fr-FR" sz="300" b="0" dirty="0">
                        <a:solidFill>
                          <a:srgbClr val="7030A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17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172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19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-0.0420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62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-0.378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 smtClean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>
                          <a:solidFill>
                            <a:sysClr val="windowText" lastClr="000000"/>
                          </a:solidFill>
                        </a:rPr>
                        <a:t>WTR</a:t>
                      </a:r>
                      <a:endParaRPr lang="fr-FR" sz="3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6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246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31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-0.0636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97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0.582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err="1" smtClean="0">
                          <a:solidFill>
                            <a:sysClr val="windowText" lastClr="000000"/>
                          </a:solidFill>
                        </a:rPr>
                        <a:t>ScWT</a:t>
                      </a:r>
                      <a:endParaRPr lang="fr-FR" sz="3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12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181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24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-0.0433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66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0.091</a:t>
                      </a:r>
                      <a:r>
                        <a:rPr lang="es-ES_tradnl" sz="300" baseline="0" dirty="0" smtClean="0"/>
                        <a:t>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>
                          <a:solidFill>
                            <a:sysClr val="windowText" lastClr="000000"/>
                          </a:solidFill>
                        </a:rPr>
                        <a:t>GMR</a:t>
                      </a:r>
                      <a:endParaRPr lang="fr-FR" sz="3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11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143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19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-0.0363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54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-0.298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err="1" smtClean="0">
                          <a:solidFill>
                            <a:sysClr val="windowText" lastClr="000000"/>
                          </a:solidFill>
                        </a:rPr>
                        <a:t>ScGM</a:t>
                      </a:r>
                      <a:endParaRPr lang="fr-FR" sz="3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6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239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30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-0.0570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89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0.177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35" name="3 CuadroTexto"/>
          <p:cNvSpPr txBox="1">
            <a:spLocks noChangeArrowheads="1"/>
          </p:cNvSpPr>
          <p:nvPr/>
        </p:nvSpPr>
        <p:spPr bwMode="auto">
          <a:xfrm>
            <a:off x="5882603" y="2743690"/>
            <a:ext cx="1401346" cy="2174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13" i="1" dirty="0"/>
              <a:t>F</a:t>
            </a:r>
            <a:r>
              <a:rPr lang="en-GB" sz="813" i="1" baseline="-25000" dirty="0"/>
              <a:t>ST(WT/GM)</a:t>
            </a:r>
            <a:r>
              <a:rPr lang="en-GB" sz="813" dirty="0"/>
              <a:t> = -0.020 ; </a:t>
            </a:r>
            <a:r>
              <a:rPr lang="en-GB" sz="813" i="1" dirty="0"/>
              <a:t>P </a:t>
            </a:r>
            <a:r>
              <a:rPr lang="en-GB" sz="813" dirty="0"/>
              <a:t>= 0.474</a:t>
            </a:r>
          </a:p>
        </p:txBody>
      </p:sp>
      <p:grpSp>
        <p:nvGrpSpPr>
          <p:cNvPr id="156" name="Groupe 155"/>
          <p:cNvGrpSpPr/>
          <p:nvPr/>
        </p:nvGrpSpPr>
        <p:grpSpPr>
          <a:xfrm>
            <a:off x="932319" y="1958364"/>
            <a:ext cx="4131563" cy="1165755"/>
            <a:chOff x="3093" y="2859594"/>
            <a:chExt cx="3520385" cy="2072453"/>
          </a:xfrm>
        </p:grpSpPr>
        <p:pic>
          <p:nvPicPr>
            <p:cNvPr id="137" name="Picture 54"/>
            <p:cNvPicPr preferRelativeResize="0">
              <a:picLocks noChangeArrowheads="1"/>
            </p:cNvPicPr>
            <p:nvPr/>
          </p:nvPicPr>
          <p:blipFill>
            <a:blip r:embed="rId2" cstate="print"/>
            <a:srcRect l="4682" r="9507"/>
            <a:stretch>
              <a:fillRect/>
            </a:stretch>
          </p:blipFill>
          <p:spPr bwMode="auto">
            <a:xfrm>
              <a:off x="391102" y="3983406"/>
              <a:ext cx="2952000" cy="788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6" name="Picture 65"/>
            <p:cNvPicPr preferRelativeResize="0">
              <a:picLocks noChangeArrowheads="1"/>
            </p:cNvPicPr>
            <p:nvPr/>
          </p:nvPicPr>
          <p:blipFill>
            <a:blip r:embed="rId3" cstate="print"/>
            <a:srcRect l="4405" r="9481"/>
            <a:stretch>
              <a:fillRect/>
            </a:stretch>
          </p:blipFill>
          <p:spPr bwMode="auto">
            <a:xfrm>
              <a:off x="368992" y="3126842"/>
              <a:ext cx="2988000" cy="788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93" name="Connecteur droit 92"/>
            <p:cNvCxnSpPr/>
            <p:nvPr/>
          </p:nvCxnSpPr>
          <p:spPr>
            <a:xfrm>
              <a:off x="410274" y="3075233"/>
              <a:ext cx="1" cy="1656184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ZoneTexte 20"/>
            <p:cNvSpPr txBox="1">
              <a:spLocks noChangeArrowheads="1"/>
            </p:cNvSpPr>
            <p:nvPr/>
          </p:nvSpPr>
          <p:spPr bwMode="auto">
            <a:xfrm>
              <a:off x="2273558" y="3862801"/>
              <a:ext cx="277545" cy="297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fr-FR" altLang="en-US" sz="488" dirty="0"/>
                <a:t>1000</a:t>
              </a:r>
            </a:p>
          </p:txBody>
        </p:sp>
        <p:sp>
          <p:nvSpPr>
            <p:cNvPr id="95" name="ZoneTexte 20"/>
            <p:cNvSpPr txBox="1">
              <a:spLocks noChangeArrowheads="1"/>
            </p:cNvSpPr>
            <p:nvPr/>
          </p:nvSpPr>
          <p:spPr bwMode="auto">
            <a:xfrm>
              <a:off x="1293947" y="3862801"/>
              <a:ext cx="247496" cy="297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fr-FR" altLang="en-US" sz="488" dirty="0"/>
                <a:t>500</a:t>
              </a:r>
            </a:p>
          </p:txBody>
        </p:sp>
        <p:cxnSp>
          <p:nvCxnSpPr>
            <p:cNvPr id="96" name="Connecteur droit 95"/>
            <p:cNvCxnSpPr/>
            <p:nvPr/>
          </p:nvCxnSpPr>
          <p:spPr>
            <a:xfrm>
              <a:off x="3324254" y="3075233"/>
              <a:ext cx="1" cy="1656184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ZoneTexte 31"/>
            <p:cNvSpPr txBox="1">
              <a:spLocks noChangeArrowheads="1"/>
            </p:cNvSpPr>
            <p:nvPr/>
          </p:nvSpPr>
          <p:spPr bwMode="auto">
            <a:xfrm rot="16200000">
              <a:off x="-461691" y="4281791"/>
              <a:ext cx="1114837" cy="1852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fr-FR" sz="813" i="1" dirty="0" err="1"/>
                <a:t>Tajima’s</a:t>
              </a:r>
              <a:r>
                <a:rPr lang="fr-FR" sz="813" i="1" dirty="0"/>
                <a:t> D</a:t>
              </a:r>
            </a:p>
          </p:txBody>
        </p:sp>
        <p:sp>
          <p:nvSpPr>
            <p:cNvPr id="98" name="ZoneTexte 20"/>
            <p:cNvSpPr txBox="1">
              <a:spLocks noChangeArrowheads="1"/>
            </p:cNvSpPr>
            <p:nvPr/>
          </p:nvSpPr>
          <p:spPr bwMode="auto">
            <a:xfrm>
              <a:off x="244200" y="4172431"/>
              <a:ext cx="232471" cy="297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fr-FR" altLang="en-US" sz="488" dirty="0"/>
                <a:t>1.0</a:t>
              </a:r>
            </a:p>
          </p:txBody>
        </p:sp>
        <p:sp>
          <p:nvSpPr>
            <p:cNvPr id="99" name="ZoneTexte 20"/>
            <p:cNvSpPr txBox="1">
              <a:spLocks noChangeArrowheads="1"/>
            </p:cNvSpPr>
            <p:nvPr/>
          </p:nvSpPr>
          <p:spPr bwMode="auto">
            <a:xfrm>
              <a:off x="244200" y="4054607"/>
              <a:ext cx="232471" cy="297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fr-FR" altLang="en-US" sz="488" dirty="0"/>
                <a:t>2.0</a:t>
              </a:r>
            </a:p>
          </p:txBody>
        </p:sp>
        <p:sp>
          <p:nvSpPr>
            <p:cNvPr id="100" name="ZoneTexte 20"/>
            <p:cNvSpPr txBox="1">
              <a:spLocks noChangeArrowheads="1"/>
            </p:cNvSpPr>
            <p:nvPr/>
          </p:nvSpPr>
          <p:spPr bwMode="auto">
            <a:xfrm>
              <a:off x="244200" y="3938497"/>
              <a:ext cx="232471" cy="297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fr-FR" altLang="en-US" sz="488" dirty="0"/>
                <a:t>3.0</a:t>
              </a:r>
            </a:p>
          </p:txBody>
        </p:sp>
        <p:sp>
          <p:nvSpPr>
            <p:cNvPr id="101" name="ZoneTexte 31"/>
            <p:cNvSpPr txBox="1">
              <a:spLocks noChangeArrowheads="1"/>
            </p:cNvSpPr>
            <p:nvPr/>
          </p:nvSpPr>
          <p:spPr bwMode="auto">
            <a:xfrm rot="16200000">
              <a:off x="-562858" y="3425545"/>
              <a:ext cx="1317170" cy="1852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l-GR" sz="813" i="1" dirty="0"/>
                <a:t>π </a:t>
              </a:r>
              <a:r>
                <a:rPr lang="fr-FR" sz="813" i="1" dirty="0"/>
                <a:t>(</a:t>
              </a:r>
              <a:r>
                <a:rPr lang="fr-FR" sz="813" i="1" dirty="0" err="1"/>
                <a:t>subst</a:t>
              </a:r>
              <a:r>
                <a:rPr lang="fr-FR" sz="813" i="1" dirty="0"/>
                <a:t>/site)</a:t>
              </a:r>
            </a:p>
          </p:txBody>
        </p:sp>
        <p:sp>
          <p:nvSpPr>
            <p:cNvPr id="102" name="ZoneTexte 20"/>
            <p:cNvSpPr txBox="1">
              <a:spLocks noChangeArrowheads="1"/>
            </p:cNvSpPr>
            <p:nvPr/>
          </p:nvSpPr>
          <p:spPr bwMode="auto">
            <a:xfrm>
              <a:off x="214153" y="3605798"/>
              <a:ext cx="262521" cy="297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fr-FR" altLang="en-US" sz="488" dirty="0"/>
                <a:t>0.05</a:t>
              </a:r>
            </a:p>
          </p:txBody>
        </p:sp>
        <p:sp>
          <p:nvSpPr>
            <p:cNvPr id="103" name="ZoneTexte 20"/>
            <p:cNvSpPr txBox="1">
              <a:spLocks noChangeArrowheads="1"/>
            </p:cNvSpPr>
            <p:nvPr/>
          </p:nvSpPr>
          <p:spPr bwMode="auto">
            <a:xfrm>
              <a:off x="214153" y="3431445"/>
              <a:ext cx="262521" cy="297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fr-FR" altLang="en-US" sz="488" dirty="0"/>
                <a:t>0.10</a:t>
              </a:r>
            </a:p>
          </p:txBody>
        </p:sp>
        <p:sp>
          <p:nvSpPr>
            <p:cNvPr id="104" name="ZoneTexte 20"/>
            <p:cNvSpPr txBox="1">
              <a:spLocks noChangeArrowheads="1"/>
            </p:cNvSpPr>
            <p:nvPr/>
          </p:nvSpPr>
          <p:spPr bwMode="auto">
            <a:xfrm>
              <a:off x="214153" y="3254428"/>
              <a:ext cx="262521" cy="297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fr-FR" altLang="en-US" sz="488" dirty="0"/>
                <a:t>0.15</a:t>
              </a:r>
            </a:p>
          </p:txBody>
        </p:sp>
        <p:sp>
          <p:nvSpPr>
            <p:cNvPr id="105" name="ZoneTexte 20"/>
            <p:cNvSpPr txBox="1">
              <a:spLocks noChangeArrowheads="1"/>
            </p:cNvSpPr>
            <p:nvPr/>
          </p:nvSpPr>
          <p:spPr bwMode="auto">
            <a:xfrm>
              <a:off x="214153" y="3080074"/>
              <a:ext cx="262521" cy="297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fr-FR" altLang="en-US" sz="488" dirty="0"/>
                <a:t>0.20</a:t>
              </a:r>
            </a:p>
          </p:txBody>
        </p:sp>
        <p:sp>
          <p:nvSpPr>
            <p:cNvPr id="106" name="ZoneTexte 20"/>
            <p:cNvSpPr txBox="1">
              <a:spLocks noChangeArrowheads="1"/>
            </p:cNvSpPr>
            <p:nvPr/>
          </p:nvSpPr>
          <p:spPr bwMode="auto">
            <a:xfrm>
              <a:off x="214153" y="3778485"/>
              <a:ext cx="262521" cy="297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fr-FR" altLang="en-US" sz="488" dirty="0"/>
                <a:t>0.00</a:t>
              </a:r>
            </a:p>
          </p:txBody>
        </p:sp>
        <p:sp>
          <p:nvSpPr>
            <p:cNvPr id="107" name="ZoneTexte 20"/>
            <p:cNvSpPr txBox="1">
              <a:spLocks noChangeArrowheads="1"/>
            </p:cNvSpPr>
            <p:nvPr/>
          </p:nvSpPr>
          <p:spPr bwMode="auto">
            <a:xfrm>
              <a:off x="244199" y="4287297"/>
              <a:ext cx="232471" cy="297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fr-FR" altLang="en-US" sz="488" dirty="0"/>
                <a:t>0.0</a:t>
              </a:r>
            </a:p>
          </p:txBody>
        </p:sp>
        <p:sp>
          <p:nvSpPr>
            <p:cNvPr id="108" name="ZoneTexte 20"/>
            <p:cNvSpPr txBox="1">
              <a:spLocks noChangeArrowheads="1"/>
            </p:cNvSpPr>
            <p:nvPr/>
          </p:nvSpPr>
          <p:spPr bwMode="auto">
            <a:xfrm>
              <a:off x="226444" y="4634415"/>
              <a:ext cx="250228" cy="297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fr-FR" altLang="en-US" sz="488" dirty="0"/>
                <a:t>-3.0</a:t>
              </a:r>
            </a:p>
          </p:txBody>
        </p:sp>
        <p:sp>
          <p:nvSpPr>
            <p:cNvPr id="109" name="ZoneTexte 20"/>
            <p:cNvSpPr txBox="1">
              <a:spLocks noChangeArrowheads="1"/>
            </p:cNvSpPr>
            <p:nvPr/>
          </p:nvSpPr>
          <p:spPr bwMode="auto">
            <a:xfrm>
              <a:off x="226444" y="4405807"/>
              <a:ext cx="250228" cy="297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fr-FR" altLang="en-US" sz="488" dirty="0"/>
                <a:t>-1.0</a:t>
              </a:r>
            </a:p>
          </p:txBody>
        </p:sp>
        <p:sp>
          <p:nvSpPr>
            <p:cNvPr id="110" name="ZoneTexte 20"/>
            <p:cNvSpPr txBox="1">
              <a:spLocks noChangeArrowheads="1"/>
            </p:cNvSpPr>
            <p:nvPr/>
          </p:nvSpPr>
          <p:spPr bwMode="auto">
            <a:xfrm>
              <a:off x="226444" y="4520851"/>
              <a:ext cx="250228" cy="297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fr-FR" altLang="en-US" sz="488" dirty="0"/>
                <a:t>-2.0</a:t>
              </a:r>
            </a:p>
          </p:txBody>
        </p:sp>
        <p:sp>
          <p:nvSpPr>
            <p:cNvPr id="111" name="ZoneTexte 110"/>
            <p:cNvSpPr txBox="1"/>
            <p:nvPr/>
          </p:nvSpPr>
          <p:spPr>
            <a:xfrm rot="16200000">
              <a:off x="3047981" y="4450802"/>
              <a:ext cx="744364" cy="2066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488" b="1" dirty="0" err="1">
                  <a:solidFill>
                    <a:srgbClr val="C00000"/>
                  </a:solidFill>
                </a:rPr>
                <a:t>Selective</a:t>
              </a:r>
              <a:endParaRPr lang="fr-FR" sz="488" b="1" dirty="0">
                <a:solidFill>
                  <a:srgbClr val="C00000"/>
                </a:solidFill>
              </a:endParaRPr>
            </a:p>
            <a:p>
              <a:pPr algn="ctr"/>
              <a:r>
                <a:rPr lang="fr-FR" sz="488" b="1" dirty="0" err="1">
                  <a:solidFill>
                    <a:srgbClr val="C00000"/>
                  </a:solidFill>
                </a:rPr>
                <a:t>sweep</a:t>
              </a:r>
              <a:endParaRPr lang="fr-FR" sz="488" b="1" dirty="0">
                <a:solidFill>
                  <a:srgbClr val="C00000"/>
                </a:solidFill>
              </a:endParaRPr>
            </a:p>
          </p:txBody>
        </p:sp>
        <p:sp>
          <p:nvSpPr>
            <p:cNvPr id="112" name="ZoneTexte 111"/>
            <p:cNvSpPr txBox="1"/>
            <p:nvPr/>
          </p:nvSpPr>
          <p:spPr>
            <a:xfrm rot="16200000">
              <a:off x="3032308" y="4103798"/>
              <a:ext cx="775712" cy="2066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488" b="1" dirty="0" err="1">
                  <a:solidFill>
                    <a:schemeClr val="accent6">
                      <a:lumMod val="75000"/>
                    </a:schemeClr>
                  </a:solidFill>
                </a:rPr>
                <a:t>Balancing</a:t>
              </a:r>
              <a:endParaRPr lang="fr-FR" sz="488" b="1" dirty="0">
                <a:solidFill>
                  <a:schemeClr val="accent6">
                    <a:lumMod val="75000"/>
                  </a:schemeClr>
                </a:solidFill>
              </a:endParaRPr>
            </a:p>
            <a:p>
              <a:pPr algn="ctr"/>
              <a:r>
                <a:rPr lang="fr-FR" sz="488" b="1" dirty="0" err="1">
                  <a:solidFill>
                    <a:schemeClr val="accent6">
                      <a:lumMod val="75000"/>
                    </a:schemeClr>
                  </a:solidFill>
                </a:rPr>
                <a:t>selection</a:t>
              </a:r>
              <a:endParaRPr lang="fr-FR" sz="488" b="1" dirty="0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  <p:cxnSp>
          <p:nvCxnSpPr>
            <p:cNvPr id="113" name="Connecteur droit 112"/>
            <p:cNvCxnSpPr/>
            <p:nvPr/>
          </p:nvCxnSpPr>
          <p:spPr>
            <a:xfrm>
              <a:off x="404664" y="4376883"/>
              <a:ext cx="3096000" cy="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Forme libre 137"/>
            <p:cNvSpPr/>
            <p:nvPr/>
          </p:nvSpPr>
          <p:spPr>
            <a:xfrm>
              <a:off x="411956" y="3167827"/>
              <a:ext cx="2912269" cy="702469"/>
            </a:xfrm>
            <a:custGeom>
              <a:avLst/>
              <a:gdLst>
                <a:gd name="connsiteX0" fmla="*/ 0 w 2912269"/>
                <a:gd name="connsiteY0" fmla="*/ 0 h 702469"/>
                <a:gd name="connsiteX1" fmla="*/ 2912269 w 2912269"/>
                <a:gd name="connsiteY1" fmla="*/ 0 h 702469"/>
                <a:gd name="connsiteX2" fmla="*/ 2912269 w 2912269"/>
                <a:gd name="connsiteY2" fmla="*/ 702469 h 702469"/>
                <a:gd name="connsiteX3" fmla="*/ 0 w 2912269"/>
                <a:gd name="connsiteY3" fmla="*/ 702469 h 702469"/>
                <a:gd name="connsiteX4" fmla="*/ 0 w 2912269"/>
                <a:gd name="connsiteY4" fmla="*/ 0 h 7024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912269" h="702469">
                  <a:moveTo>
                    <a:pt x="0" y="0"/>
                  </a:moveTo>
                  <a:lnTo>
                    <a:pt x="2912269" y="0"/>
                  </a:lnTo>
                  <a:lnTo>
                    <a:pt x="2912269" y="702469"/>
                  </a:lnTo>
                  <a:lnTo>
                    <a:pt x="0" y="70246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9D9D9">
                <a:alpha val="1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63"/>
            </a:p>
          </p:txBody>
        </p:sp>
        <p:sp>
          <p:nvSpPr>
            <p:cNvPr id="139" name="Forme libre 138"/>
            <p:cNvSpPr/>
            <p:nvPr/>
          </p:nvSpPr>
          <p:spPr>
            <a:xfrm>
              <a:off x="411956" y="4025077"/>
              <a:ext cx="2912269" cy="700088"/>
            </a:xfrm>
            <a:custGeom>
              <a:avLst/>
              <a:gdLst>
                <a:gd name="connsiteX0" fmla="*/ 0 w 2912269"/>
                <a:gd name="connsiteY0" fmla="*/ 2382 h 700088"/>
                <a:gd name="connsiteX1" fmla="*/ 2909888 w 2912269"/>
                <a:gd name="connsiteY1" fmla="*/ 0 h 700088"/>
                <a:gd name="connsiteX2" fmla="*/ 2912269 w 2912269"/>
                <a:gd name="connsiteY2" fmla="*/ 697707 h 700088"/>
                <a:gd name="connsiteX3" fmla="*/ 4763 w 2912269"/>
                <a:gd name="connsiteY3" fmla="*/ 700088 h 700088"/>
                <a:gd name="connsiteX4" fmla="*/ 0 w 2912269"/>
                <a:gd name="connsiteY4" fmla="*/ 2382 h 7000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912269" h="700088">
                  <a:moveTo>
                    <a:pt x="0" y="2382"/>
                  </a:moveTo>
                  <a:lnTo>
                    <a:pt x="2909888" y="0"/>
                  </a:lnTo>
                  <a:cubicBezTo>
                    <a:pt x="2910682" y="232569"/>
                    <a:pt x="2911475" y="465138"/>
                    <a:pt x="2912269" y="697707"/>
                  </a:cubicBezTo>
                  <a:lnTo>
                    <a:pt x="4763" y="700088"/>
                  </a:lnTo>
                  <a:cubicBezTo>
                    <a:pt x="3175" y="467519"/>
                    <a:pt x="1588" y="234951"/>
                    <a:pt x="0" y="2382"/>
                  </a:cubicBezTo>
                  <a:close/>
                </a:path>
              </a:pathLst>
            </a:custGeom>
            <a:solidFill>
              <a:srgbClr val="D9D9D9">
                <a:alpha val="1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63"/>
            </a:p>
          </p:txBody>
        </p:sp>
        <p:sp>
          <p:nvSpPr>
            <p:cNvPr id="140" name="Forme libre 139"/>
            <p:cNvSpPr/>
            <p:nvPr/>
          </p:nvSpPr>
          <p:spPr>
            <a:xfrm>
              <a:off x="409575" y="4374356"/>
              <a:ext cx="66675" cy="97632"/>
            </a:xfrm>
            <a:custGeom>
              <a:avLst/>
              <a:gdLst>
                <a:gd name="connsiteX0" fmla="*/ 0 w 66675"/>
                <a:gd name="connsiteY0" fmla="*/ 97632 h 97632"/>
                <a:gd name="connsiteX1" fmla="*/ 66675 w 66675"/>
                <a:gd name="connsiteY1" fmla="*/ 0 h 97632"/>
                <a:gd name="connsiteX2" fmla="*/ 4763 w 66675"/>
                <a:gd name="connsiteY2" fmla="*/ 4763 h 97632"/>
                <a:gd name="connsiteX3" fmla="*/ 0 w 66675"/>
                <a:gd name="connsiteY3" fmla="*/ 97632 h 976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66675" h="97632">
                  <a:moveTo>
                    <a:pt x="0" y="97632"/>
                  </a:moveTo>
                  <a:lnTo>
                    <a:pt x="66675" y="0"/>
                  </a:lnTo>
                  <a:lnTo>
                    <a:pt x="4763" y="4763"/>
                  </a:lnTo>
                  <a:lnTo>
                    <a:pt x="0" y="97632"/>
                  </a:lnTo>
                  <a:close/>
                </a:path>
              </a:pathLst>
            </a:custGeom>
            <a:solidFill>
              <a:srgbClr val="C00000">
                <a:alpha val="3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63"/>
            </a:p>
          </p:txBody>
        </p:sp>
        <p:sp>
          <p:nvSpPr>
            <p:cNvPr id="142" name="Forme libre 141"/>
            <p:cNvSpPr/>
            <p:nvPr/>
          </p:nvSpPr>
          <p:spPr>
            <a:xfrm>
              <a:off x="409575" y="4379119"/>
              <a:ext cx="292894" cy="88106"/>
            </a:xfrm>
            <a:custGeom>
              <a:avLst/>
              <a:gdLst>
                <a:gd name="connsiteX0" fmla="*/ 0 w 292894"/>
                <a:gd name="connsiteY0" fmla="*/ 85725 h 88106"/>
                <a:gd name="connsiteX1" fmla="*/ 73819 w 292894"/>
                <a:gd name="connsiteY1" fmla="*/ 35719 h 88106"/>
                <a:gd name="connsiteX2" fmla="*/ 178594 w 292894"/>
                <a:gd name="connsiteY2" fmla="*/ 88106 h 88106"/>
                <a:gd name="connsiteX3" fmla="*/ 223838 w 292894"/>
                <a:gd name="connsiteY3" fmla="*/ 42862 h 88106"/>
                <a:gd name="connsiteX4" fmla="*/ 276225 w 292894"/>
                <a:gd name="connsiteY4" fmla="*/ 35719 h 88106"/>
                <a:gd name="connsiteX5" fmla="*/ 292894 w 292894"/>
                <a:gd name="connsiteY5" fmla="*/ 0 h 88106"/>
                <a:gd name="connsiteX6" fmla="*/ 2381 w 292894"/>
                <a:gd name="connsiteY6" fmla="*/ 2381 h 88106"/>
                <a:gd name="connsiteX7" fmla="*/ 0 w 292894"/>
                <a:gd name="connsiteY7" fmla="*/ 85725 h 8810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92894" h="88106">
                  <a:moveTo>
                    <a:pt x="0" y="85725"/>
                  </a:moveTo>
                  <a:lnTo>
                    <a:pt x="73819" y="35719"/>
                  </a:lnTo>
                  <a:lnTo>
                    <a:pt x="178594" y="88106"/>
                  </a:lnTo>
                  <a:lnTo>
                    <a:pt x="223838" y="42862"/>
                  </a:lnTo>
                  <a:lnTo>
                    <a:pt x="276225" y="35719"/>
                  </a:lnTo>
                  <a:lnTo>
                    <a:pt x="292894" y="0"/>
                  </a:lnTo>
                  <a:lnTo>
                    <a:pt x="2381" y="2381"/>
                  </a:lnTo>
                  <a:cubicBezTo>
                    <a:pt x="1587" y="30162"/>
                    <a:pt x="794" y="57944"/>
                    <a:pt x="0" y="85725"/>
                  </a:cubicBezTo>
                  <a:close/>
                </a:path>
              </a:pathLst>
            </a:custGeom>
            <a:solidFill>
              <a:srgbClr val="C00000">
                <a:alpha val="3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63"/>
            </a:p>
          </p:txBody>
        </p:sp>
        <p:sp>
          <p:nvSpPr>
            <p:cNvPr id="143" name="Forme libre 142"/>
            <p:cNvSpPr/>
            <p:nvPr/>
          </p:nvSpPr>
          <p:spPr>
            <a:xfrm>
              <a:off x="1047750" y="4376738"/>
              <a:ext cx="338138" cy="133350"/>
            </a:xfrm>
            <a:custGeom>
              <a:avLst/>
              <a:gdLst>
                <a:gd name="connsiteX0" fmla="*/ 0 w 338138"/>
                <a:gd name="connsiteY0" fmla="*/ 2381 h 133350"/>
                <a:gd name="connsiteX1" fmla="*/ 42863 w 338138"/>
                <a:gd name="connsiteY1" fmla="*/ 30956 h 133350"/>
                <a:gd name="connsiteX2" fmla="*/ 85725 w 338138"/>
                <a:gd name="connsiteY2" fmla="*/ 121443 h 133350"/>
                <a:gd name="connsiteX3" fmla="*/ 128588 w 338138"/>
                <a:gd name="connsiteY3" fmla="*/ 111918 h 133350"/>
                <a:gd name="connsiteX4" fmla="*/ 188119 w 338138"/>
                <a:gd name="connsiteY4" fmla="*/ 109537 h 133350"/>
                <a:gd name="connsiteX5" fmla="*/ 242888 w 338138"/>
                <a:gd name="connsiteY5" fmla="*/ 133350 h 133350"/>
                <a:gd name="connsiteX6" fmla="*/ 338138 w 338138"/>
                <a:gd name="connsiteY6" fmla="*/ 0 h 133350"/>
                <a:gd name="connsiteX7" fmla="*/ 0 w 338138"/>
                <a:gd name="connsiteY7" fmla="*/ 2381 h 1333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38138" h="133350">
                  <a:moveTo>
                    <a:pt x="0" y="2381"/>
                  </a:moveTo>
                  <a:lnTo>
                    <a:pt x="42863" y="30956"/>
                  </a:lnTo>
                  <a:lnTo>
                    <a:pt x="85725" y="121443"/>
                  </a:lnTo>
                  <a:lnTo>
                    <a:pt x="128588" y="111918"/>
                  </a:lnTo>
                  <a:lnTo>
                    <a:pt x="188119" y="109537"/>
                  </a:lnTo>
                  <a:lnTo>
                    <a:pt x="242888" y="133350"/>
                  </a:lnTo>
                  <a:lnTo>
                    <a:pt x="338138" y="0"/>
                  </a:lnTo>
                  <a:lnTo>
                    <a:pt x="0" y="2381"/>
                  </a:lnTo>
                  <a:close/>
                </a:path>
              </a:pathLst>
            </a:custGeom>
            <a:solidFill>
              <a:srgbClr val="C00000">
                <a:alpha val="3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63"/>
            </a:p>
          </p:txBody>
        </p:sp>
        <p:sp>
          <p:nvSpPr>
            <p:cNvPr id="144" name="Forme libre 143"/>
            <p:cNvSpPr/>
            <p:nvPr/>
          </p:nvSpPr>
          <p:spPr>
            <a:xfrm>
              <a:off x="504825" y="4379119"/>
              <a:ext cx="221456" cy="80962"/>
            </a:xfrm>
            <a:custGeom>
              <a:avLst/>
              <a:gdLst>
                <a:gd name="connsiteX0" fmla="*/ 0 w 221456"/>
                <a:gd name="connsiteY0" fmla="*/ 0 h 80962"/>
                <a:gd name="connsiteX1" fmla="*/ 221456 w 221456"/>
                <a:gd name="connsiteY1" fmla="*/ 0 h 80962"/>
                <a:gd name="connsiteX2" fmla="*/ 185738 w 221456"/>
                <a:gd name="connsiteY2" fmla="*/ 80962 h 80962"/>
                <a:gd name="connsiteX3" fmla="*/ 133350 w 221456"/>
                <a:gd name="connsiteY3" fmla="*/ 42862 h 80962"/>
                <a:gd name="connsiteX4" fmla="*/ 88106 w 221456"/>
                <a:gd name="connsiteY4" fmla="*/ 50006 h 80962"/>
                <a:gd name="connsiteX5" fmla="*/ 35719 w 221456"/>
                <a:gd name="connsiteY5" fmla="*/ 35719 h 80962"/>
                <a:gd name="connsiteX6" fmla="*/ 0 w 221456"/>
                <a:gd name="connsiteY6" fmla="*/ 0 h 8096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21456" h="80962">
                  <a:moveTo>
                    <a:pt x="0" y="0"/>
                  </a:moveTo>
                  <a:lnTo>
                    <a:pt x="221456" y="0"/>
                  </a:lnTo>
                  <a:lnTo>
                    <a:pt x="185738" y="80962"/>
                  </a:lnTo>
                  <a:lnTo>
                    <a:pt x="133350" y="42862"/>
                  </a:lnTo>
                  <a:lnTo>
                    <a:pt x="88106" y="50006"/>
                  </a:lnTo>
                  <a:lnTo>
                    <a:pt x="35719" y="3571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00000">
                <a:alpha val="3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63"/>
            </a:p>
          </p:txBody>
        </p:sp>
        <p:sp>
          <p:nvSpPr>
            <p:cNvPr id="145" name="Forme libre 144"/>
            <p:cNvSpPr/>
            <p:nvPr/>
          </p:nvSpPr>
          <p:spPr>
            <a:xfrm>
              <a:off x="1545431" y="4374356"/>
              <a:ext cx="195263" cy="78582"/>
            </a:xfrm>
            <a:custGeom>
              <a:avLst/>
              <a:gdLst>
                <a:gd name="connsiteX0" fmla="*/ 0 w 195263"/>
                <a:gd name="connsiteY0" fmla="*/ 7144 h 78582"/>
                <a:gd name="connsiteX1" fmla="*/ 35719 w 195263"/>
                <a:gd name="connsiteY1" fmla="*/ 64294 h 78582"/>
                <a:gd name="connsiteX2" fmla="*/ 92869 w 195263"/>
                <a:gd name="connsiteY2" fmla="*/ 78582 h 78582"/>
                <a:gd name="connsiteX3" fmla="*/ 142875 w 195263"/>
                <a:gd name="connsiteY3" fmla="*/ 54769 h 78582"/>
                <a:gd name="connsiteX4" fmla="*/ 195263 w 195263"/>
                <a:gd name="connsiteY4" fmla="*/ 0 h 78582"/>
                <a:gd name="connsiteX5" fmla="*/ 0 w 195263"/>
                <a:gd name="connsiteY5" fmla="*/ 7144 h 785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95263" h="78582">
                  <a:moveTo>
                    <a:pt x="0" y="7144"/>
                  </a:moveTo>
                  <a:lnTo>
                    <a:pt x="35719" y="64294"/>
                  </a:lnTo>
                  <a:lnTo>
                    <a:pt x="92869" y="78582"/>
                  </a:lnTo>
                  <a:lnTo>
                    <a:pt x="142875" y="54769"/>
                  </a:lnTo>
                  <a:lnTo>
                    <a:pt x="195263" y="0"/>
                  </a:lnTo>
                  <a:lnTo>
                    <a:pt x="0" y="7144"/>
                  </a:lnTo>
                  <a:close/>
                </a:path>
              </a:pathLst>
            </a:custGeom>
            <a:solidFill>
              <a:srgbClr val="C00000">
                <a:alpha val="3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63"/>
            </a:p>
          </p:txBody>
        </p:sp>
        <p:sp>
          <p:nvSpPr>
            <p:cNvPr id="148" name="Forme libre 147"/>
            <p:cNvSpPr/>
            <p:nvPr/>
          </p:nvSpPr>
          <p:spPr>
            <a:xfrm>
              <a:off x="2793206" y="4381500"/>
              <a:ext cx="533400" cy="95250"/>
            </a:xfrm>
            <a:custGeom>
              <a:avLst/>
              <a:gdLst>
                <a:gd name="connsiteX0" fmla="*/ 533400 w 533400"/>
                <a:gd name="connsiteY0" fmla="*/ 64294 h 95250"/>
                <a:gd name="connsiteX1" fmla="*/ 447675 w 533400"/>
                <a:gd name="connsiteY1" fmla="*/ 90488 h 95250"/>
                <a:gd name="connsiteX2" fmla="*/ 395288 w 533400"/>
                <a:gd name="connsiteY2" fmla="*/ 26194 h 95250"/>
                <a:gd name="connsiteX3" fmla="*/ 347663 w 533400"/>
                <a:gd name="connsiteY3" fmla="*/ 83344 h 95250"/>
                <a:gd name="connsiteX4" fmla="*/ 245269 w 533400"/>
                <a:gd name="connsiteY4" fmla="*/ 33338 h 95250"/>
                <a:gd name="connsiteX5" fmla="*/ 195263 w 533400"/>
                <a:gd name="connsiteY5" fmla="*/ 95250 h 95250"/>
                <a:gd name="connsiteX6" fmla="*/ 145257 w 533400"/>
                <a:gd name="connsiteY6" fmla="*/ 54769 h 95250"/>
                <a:gd name="connsiteX7" fmla="*/ 102394 w 533400"/>
                <a:gd name="connsiteY7" fmla="*/ 95250 h 95250"/>
                <a:gd name="connsiteX8" fmla="*/ 47625 w 533400"/>
                <a:gd name="connsiteY8" fmla="*/ 95250 h 95250"/>
                <a:gd name="connsiteX9" fmla="*/ 0 w 533400"/>
                <a:gd name="connsiteY9" fmla="*/ 0 h 95250"/>
                <a:gd name="connsiteX10" fmla="*/ 531019 w 533400"/>
                <a:gd name="connsiteY10" fmla="*/ 0 h 95250"/>
                <a:gd name="connsiteX11" fmla="*/ 533400 w 533400"/>
                <a:gd name="connsiteY11" fmla="*/ 64294 h 952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533400" h="95250">
                  <a:moveTo>
                    <a:pt x="533400" y="64294"/>
                  </a:moveTo>
                  <a:lnTo>
                    <a:pt x="447675" y="90488"/>
                  </a:lnTo>
                  <a:lnTo>
                    <a:pt x="395288" y="26194"/>
                  </a:lnTo>
                  <a:lnTo>
                    <a:pt x="347663" y="83344"/>
                  </a:lnTo>
                  <a:lnTo>
                    <a:pt x="245269" y="33338"/>
                  </a:lnTo>
                  <a:lnTo>
                    <a:pt x="195263" y="95250"/>
                  </a:lnTo>
                  <a:lnTo>
                    <a:pt x="145257" y="54769"/>
                  </a:lnTo>
                  <a:lnTo>
                    <a:pt x="102394" y="95250"/>
                  </a:lnTo>
                  <a:lnTo>
                    <a:pt x="47625" y="95250"/>
                  </a:lnTo>
                  <a:lnTo>
                    <a:pt x="0" y="0"/>
                  </a:lnTo>
                  <a:lnTo>
                    <a:pt x="531019" y="0"/>
                  </a:lnTo>
                  <a:cubicBezTo>
                    <a:pt x="531813" y="21431"/>
                    <a:pt x="532606" y="42863"/>
                    <a:pt x="533400" y="64294"/>
                  </a:cubicBezTo>
                  <a:close/>
                </a:path>
              </a:pathLst>
            </a:custGeom>
            <a:solidFill>
              <a:srgbClr val="C00000">
                <a:alpha val="3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63"/>
            </a:p>
          </p:txBody>
        </p:sp>
        <p:sp>
          <p:nvSpPr>
            <p:cNvPr id="150" name="Forme libre 149"/>
            <p:cNvSpPr/>
            <p:nvPr/>
          </p:nvSpPr>
          <p:spPr>
            <a:xfrm>
              <a:off x="2967038" y="4379119"/>
              <a:ext cx="357187" cy="145256"/>
            </a:xfrm>
            <a:custGeom>
              <a:avLst/>
              <a:gdLst>
                <a:gd name="connsiteX0" fmla="*/ 276225 w 357187"/>
                <a:gd name="connsiteY0" fmla="*/ 42862 h 145256"/>
                <a:gd name="connsiteX1" fmla="*/ 357187 w 357187"/>
                <a:gd name="connsiteY1" fmla="*/ 45244 h 145256"/>
                <a:gd name="connsiteX2" fmla="*/ 357187 w 357187"/>
                <a:gd name="connsiteY2" fmla="*/ 2381 h 145256"/>
                <a:gd name="connsiteX3" fmla="*/ 0 w 357187"/>
                <a:gd name="connsiteY3" fmla="*/ 0 h 145256"/>
                <a:gd name="connsiteX4" fmla="*/ 28575 w 357187"/>
                <a:gd name="connsiteY4" fmla="*/ 14287 h 145256"/>
                <a:gd name="connsiteX5" fmla="*/ 73818 w 357187"/>
                <a:gd name="connsiteY5" fmla="*/ 85725 h 145256"/>
                <a:gd name="connsiteX6" fmla="*/ 123825 w 357187"/>
                <a:gd name="connsiteY6" fmla="*/ 85725 h 145256"/>
                <a:gd name="connsiteX7" fmla="*/ 176212 w 357187"/>
                <a:gd name="connsiteY7" fmla="*/ 145256 h 145256"/>
                <a:gd name="connsiteX8" fmla="*/ 228600 w 357187"/>
                <a:gd name="connsiteY8" fmla="*/ 133350 h 145256"/>
                <a:gd name="connsiteX9" fmla="*/ 276225 w 357187"/>
                <a:gd name="connsiteY9" fmla="*/ 42862 h 14525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357187" h="145256">
                  <a:moveTo>
                    <a:pt x="276225" y="42862"/>
                  </a:moveTo>
                  <a:lnTo>
                    <a:pt x="357187" y="45244"/>
                  </a:lnTo>
                  <a:lnTo>
                    <a:pt x="357187" y="2381"/>
                  </a:lnTo>
                  <a:lnTo>
                    <a:pt x="0" y="0"/>
                  </a:lnTo>
                  <a:lnTo>
                    <a:pt x="28575" y="14287"/>
                  </a:lnTo>
                  <a:lnTo>
                    <a:pt x="73818" y="85725"/>
                  </a:lnTo>
                  <a:lnTo>
                    <a:pt x="123825" y="85725"/>
                  </a:lnTo>
                  <a:lnTo>
                    <a:pt x="176212" y="145256"/>
                  </a:lnTo>
                  <a:lnTo>
                    <a:pt x="228600" y="133350"/>
                  </a:lnTo>
                  <a:lnTo>
                    <a:pt x="276225" y="42862"/>
                  </a:lnTo>
                  <a:close/>
                </a:path>
              </a:pathLst>
            </a:custGeom>
            <a:solidFill>
              <a:srgbClr val="C00000">
                <a:alpha val="3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63"/>
            </a:p>
          </p:txBody>
        </p:sp>
        <p:sp>
          <p:nvSpPr>
            <p:cNvPr id="151" name="Forme libre 150"/>
            <p:cNvSpPr/>
            <p:nvPr/>
          </p:nvSpPr>
          <p:spPr>
            <a:xfrm flipH="1">
              <a:off x="2534041" y="4374951"/>
              <a:ext cx="126000" cy="25200"/>
            </a:xfrm>
            <a:custGeom>
              <a:avLst/>
              <a:gdLst>
                <a:gd name="connsiteX0" fmla="*/ 0 w 195263"/>
                <a:gd name="connsiteY0" fmla="*/ 7144 h 78582"/>
                <a:gd name="connsiteX1" fmla="*/ 35719 w 195263"/>
                <a:gd name="connsiteY1" fmla="*/ 64294 h 78582"/>
                <a:gd name="connsiteX2" fmla="*/ 92869 w 195263"/>
                <a:gd name="connsiteY2" fmla="*/ 78582 h 78582"/>
                <a:gd name="connsiteX3" fmla="*/ 142875 w 195263"/>
                <a:gd name="connsiteY3" fmla="*/ 54769 h 78582"/>
                <a:gd name="connsiteX4" fmla="*/ 195263 w 195263"/>
                <a:gd name="connsiteY4" fmla="*/ 0 h 78582"/>
                <a:gd name="connsiteX5" fmla="*/ 0 w 195263"/>
                <a:gd name="connsiteY5" fmla="*/ 7144 h 785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95263" h="78582">
                  <a:moveTo>
                    <a:pt x="0" y="7144"/>
                  </a:moveTo>
                  <a:lnTo>
                    <a:pt x="35719" y="64294"/>
                  </a:lnTo>
                  <a:lnTo>
                    <a:pt x="92869" y="78582"/>
                  </a:lnTo>
                  <a:lnTo>
                    <a:pt x="142875" y="54769"/>
                  </a:lnTo>
                  <a:lnTo>
                    <a:pt x="195263" y="0"/>
                  </a:lnTo>
                  <a:lnTo>
                    <a:pt x="0" y="7144"/>
                  </a:lnTo>
                  <a:close/>
                </a:path>
              </a:pathLst>
            </a:custGeom>
            <a:solidFill>
              <a:srgbClr val="C00000">
                <a:alpha val="3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63"/>
            </a:p>
          </p:txBody>
        </p:sp>
        <p:sp>
          <p:nvSpPr>
            <p:cNvPr id="152" name="Forme libre 151"/>
            <p:cNvSpPr/>
            <p:nvPr/>
          </p:nvSpPr>
          <p:spPr>
            <a:xfrm>
              <a:off x="1924046" y="4382094"/>
              <a:ext cx="108000" cy="36000"/>
            </a:xfrm>
            <a:custGeom>
              <a:avLst/>
              <a:gdLst>
                <a:gd name="connsiteX0" fmla="*/ 0 w 180975"/>
                <a:gd name="connsiteY0" fmla="*/ 2381 h 100012"/>
                <a:gd name="connsiteX1" fmla="*/ 180975 w 180975"/>
                <a:gd name="connsiteY1" fmla="*/ 0 h 100012"/>
                <a:gd name="connsiteX2" fmla="*/ 102394 w 180975"/>
                <a:gd name="connsiteY2" fmla="*/ 78581 h 100012"/>
                <a:gd name="connsiteX3" fmla="*/ 28575 w 180975"/>
                <a:gd name="connsiteY3" fmla="*/ 100012 h 100012"/>
                <a:gd name="connsiteX4" fmla="*/ 0 w 180975"/>
                <a:gd name="connsiteY4" fmla="*/ 2381 h 1000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80975" h="100012">
                  <a:moveTo>
                    <a:pt x="0" y="2381"/>
                  </a:moveTo>
                  <a:lnTo>
                    <a:pt x="180975" y="0"/>
                  </a:lnTo>
                  <a:lnTo>
                    <a:pt x="102394" y="78581"/>
                  </a:lnTo>
                  <a:lnTo>
                    <a:pt x="28575" y="100012"/>
                  </a:lnTo>
                  <a:lnTo>
                    <a:pt x="0" y="2381"/>
                  </a:lnTo>
                  <a:close/>
                </a:path>
              </a:pathLst>
            </a:custGeom>
            <a:solidFill>
              <a:srgbClr val="C00000">
                <a:alpha val="3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63"/>
            </a:p>
          </p:txBody>
        </p:sp>
        <p:sp>
          <p:nvSpPr>
            <p:cNvPr id="154" name="Forme libre 153"/>
            <p:cNvSpPr/>
            <p:nvPr/>
          </p:nvSpPr>
          <p:spPr>
            <a:xfrm>
              <a:off x="2107406" y="4376738"/>
              <a:ext cx="433388" cy="114300"/>
            </a:xfrm>
            <a:custGeom>
              <a:avLst/>
              <a:gdLst>
                <a:gd name="connsiteX0" fmla="*/ 433388 w 433388"/>
                <a:gd name="connsiteY0" fmla="*/ 0 h 114300"/>
                <a:gd name="connsiteX1" fmla="*/ 0 w 433388"/>
                <a:gd name="connsiteY1" fmla="*/ 2381 h 114300"/>
                <a:gd name="connsiteX2" fmla="*/ 33338 w 433388"/>
                <a:gd name="connsiteY2" fmla="*/ 38100 h 114300"/>
                <a:gd name="connsiteX3" fmla="*/ 85725 w 433388"/>
                <a:gd name="connsiteY3" fmla="*/ 42862 h 114300"/>
                <a:gd name="connsiteX4" fmla="*/ 128588 w 433388"/>
                <a:gd name="connsiteY4" fmla="*/ 102393 h 114300"/>
                <a:gd name="connsiteX5" fmla="*/ 178594 w 433388"/>
                <a:gd name="connsiteY5" fmla="*/ 114300 h 114300"/>
                <a:gd name="connsiteX6" fmla="*/ 228600 w 433388"/>
                <a:gd name="connsiteY6" fmla="*/ 111918 h 114300"/>
                <a:gd name="connsiteX7" fmla="*/ 280988 w 433388"/>
                <a:gd name="connsiteY7" fmla="*/ 52387 h 114300"/>
                <a:gd name="connsiteX8" fmla="*/ 326232 w 433388"/>
                <a:gd name="connsiteY8" fmla="*/ 78581 h 114300"/>
                <a:gd name="connsiteX9" fmla="*/ 383382 w 433388"/>
                <a:gd name="connsiteY9" fmla="*/ 92868 h 114300"/>
                <a:gd name="connsiteX10" fmla="*/ 433388 w 433388"/>
                <a:gd name="connsiteY10" fmla="*/ 0 h 1143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433388" h="114300">
                  <a:moveTo>
                    <a:pt x="433388" y="0"/>
                  </a:moveTo>
                  <a:lnTo>
                    <a:pt x="0" y="2381"/>
                  </a:lnTo>
                  <a:lnTo>
                    <a:pt x="33338" y="38100"/>
                  </a:lnTo>
                  <a:lnTo>
                    <a:pt x="85725" y="42862"/>
                  </a:lnTo>
                  <a:lnTo>
                    <a:pt x="128588" y="102393"/>
                  </a:lnTo>
                  <a:lnTo>
                    <a:pt x="178594" y="114300"/>
                  </a:lnTo>
                  <a:lnTo>
                    <a:pt x="228600" y="111918"/>
                  </a:lnTo>
                  <a:lnTo>
                    <a:pt x="280988" y="52387"/>
                  </a:lnTo>
                  <a:lnTo>
                    <a:pt x="326232" y="78581"/>
                  </a:lnTo>
                  <a:lnTo>
                    <a:pt x="383382" y="92868"/>
                  </a:lnTo>
                  <a:lnTo>
                    <a:pt x="433388" y="0"/>
                  </a:lnTo>
                  <a:close/>
                </a:path>
              </a:pathLst>
            </a:custGeom>
            <a:solidFill>
              <a:srgbClr val="C00000">
                <a:alpha val="3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63"/>
            </a:p>
          </p:txBody>
        </p:sp>
        <p:sp>
          <p:nvSpPr>
            <p:cNvPr id="155" name="Forme libre 154"/>
            <p:cNvSpPr/>
            <p:nvPr/>
          </p:nvSpPr>
          <p:spPr>
            <a:xfrm>
              <a:off x="2102644" y="4376738"/>
              <a:ext cx="250031" cy="138112"/>
            </a:xfrm>
            <a:custGeom>
              <a:avLst/>
              <a:gdLst>
                <a:gd name="connsiteX0" fmla="*/ 250031 w 250031"/>
                <a:gd name="connsiteY0" fmla="*/ 0 h 138112"/>
                <a:gd name="connsiteX1" fmla="*/ 238125 w 250031"/>
                <a:gd name="connsiteY1" fmla="*/ 52387 h 138112"/>
                <a:gd name="connsiteX2" fmla="*/ 180975 w 250031"/>
                <a:gd name="connsiteY2" fmla="*/ 90487 h 138112"/>
                <a:gd name="connsiteX3" fmla="*/ 133350 w 250031"/>
                <a:gd name="connsiteY3" fmla="*/ 138112 h 138112"/>
                <a:gd name="connsiteX4" fmla="*/ 35719 w 250031"/>
                <a:gd name="connsiteY4" fmla="*/ 23812 h 138112"/>
                <a:gd name="connsiteX5" fmla="*/ 0 w 250031"/>
                <a:gd name="connsiteY5" fmla="*/ 2381 h 138112"/>
                <a:gd name="connsiteX6" fmla="*/ 250031 w 250031"/>
                <a:gd name="connsiteY6" fmla="*/ 0 h 1381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50031" h="138112">
                  <a:moveTo>
                    <a:pt x="250031" y="0"/>
                  </a:moveTo>
                  <a:lnTo>
                    <a:pt x="238125" y="52387"/>
                  </a:lnTo>
                  <a:lnTo>
                    <a:pt x="180975" y="90487"/>
                  </a:lnTo>
                  <a:lnTo>
                    <a:pt x="133350" y="138112"/>
                  </a:lnTo>
                  <a:lnTo>
                    <a:pt x="35719" y="23812"/>
                  </a:lnTo>
                  <a:lnTo>
                    <a:pt x="0" y="2381"/>
                  </a:lnTo>
                  <a:lnTo>
                    <a:pt x="250031" y="0"/>
                  </a:lnTo>
                  <a:close/>
                </a:path>
              </a:pathLst>
            </a:custGeom>
            <a:solidFill>
              <a:srgbClr val="C00000">
                <a:alpha val="3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63"/>
            </a:p>
          </p:txBody>
        </p:sp>
      </p:grpSp>
      <p:graphicFrame>
        <p:nvGraphicFramePr>
          <p:cNvPr id="114" name="Tableau 1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7249359"/>
              </p:ext>
            </p:extLst>
          </p:nvPr>
        </p:nvGraphicFramePr>
        <p:xfrm>
          <a:off x="5037511" y="3216808"/>
          <a:ext cx="3887431" cy="82611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55569"/>
                <a:gridCol w="371882"/>
                <a:gridCol w="862736"/>
                <a:gridCol w="845094"/>
                <a:gridCol w="1352150"/>
              </a:tblGrid>
              <a:tr h="96783"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>
                          <a:solidFill>
                            <a:sysClr val="windowText" lastClr="000000"/>
                          </a:solidFill>
                        </a:rPr>
                        <a:t>Pop.</a:t>
                      </a:r>
                      <a:endParaRPr lang="fr-FR" sz="3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>
                          <a:solidFill>
                            <a:sysClr val="windowText" lastClr="000000"/>
                          </a:solidFill>
                        </a:rPr>
                        <a:t>N</a:t>
                      </a:r>
                      <a:endParaRPr lang="fr-FR" sz="3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sz="300" dirty="0" smtClean="0">
                          <a:solidFill>
                            <a:sysClr val="windowText" lastClr="000000"/>
                          </a:solidFill>
                        </a:rPr>
                        <a:t>π</a:t>
                      </a:r>
                      <a:r>
                        <a:rPr lang="es-ES_tradnl" sz="300" dirty="0" smtClean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el-GR" sz="300" b="0" dirty="0" smtClean="0">
                          <a:solidFill>
                            <a:sysClr val="windowText" lastClr="000000"/>
                          </a:solidFill>
                        </a:rPr>
                        <a:t>±</a:t>
                      </a:r>
                      <a:r>
                        <a:rPr lang="es-ES_tradnl" sz="300" b="0" dirty="0" smtClean="0">
                          <a:solidFill>
                            <a:sysClr val="windowText" lastClr="000000"/>
                          </a:solidFill>
                        </a:rPr>
                        <a:t> SE</a:t>
                      </a:r>
                      <a:endParaRPr lang="en-GB" sz="300" b="0" dirty="0" smtClean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300" i="1" baseline="0" dirty="0" err="1" smtClean="0">
                          <a:solidFill>
                            <a:sysClr val="windowText" lastClr="000000"/>
                          </a:solidFill>
                        </a:rPr>
                        <a:t>d</a:t>
                      </a:r>
                      <a:r>
                        <a:rPr lang="en-GB" sz="300" i="1" baseline="-25000" dirty="0" err="1" smtClean="0">
                          <a:solidFill>
                            <a:sysClr val="windowText" lastClr="000000"/>
                          </a:solidFill>
                        </a:rPr>
                        <a:t>N</a:t>
                      </a:r>
                      <a:r>
                        <a:rPr lang="en-GB" sz="300" i="1" baseline="0" dirty="0" smtClean="0">
                          <a:solidFill>
                            <a:sysClr val="windowText" lastClr="000000"/>
                          </a:solidFill>
                        </a:rPr>
                        <a:t> - </a:t>
                      </a:r>
                      <a:r>
                        <a:rPr lang="en-GB" sz="300" i="1" baseline="0" dirty="0" err="1" smtClean="0">
                          <a:solidFill>
                            <a:sysClr val="windowText" lastClr="000000"/>
                          </a:solidFill>
                        </a:rPr>
                        <a:t>d</a:t>
                      </a:r>
                      <a:r>
                        <a:rPr lang="en-GB" sz="300" i="1" baseline="-25000" dirty="0" err="1" smtClean="0">
                          <a:solidFill>
                            <a:sysClr val="windowText" lastClr="000000"/>
                          </a:solidFill>
                        </a:rPr>
                        <a:t>S</a:t>
                      </a:r>
                      <a:r>
                        <a:rPr lang="en-GB" sz="300" i="1" baseline="0" dirty="0" smtClean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el-GR" sz="300" b="0" dirty="0" smtClean="0">
                          <a:solidFill>
                            <a:sysClr val="windowText" lastClr="000000"/>
                          </a:solidFill>
                        </a:rPr>
                        <a:t>±</a:t>
                      </a:r>
                      <a:r>
                        <a:rPr lang="es-ES_tradnl" sz="300" b="0" dirty="0" smtClean="0">
                          <a:solidFill>
                            <a:sysClr val="windowText" lastClr="000000"/>
                          </a:solidFill>
                        </a:rPr>
                        <a:t> SE</a:t>
                      </a:r>
                      <a:endParaRPr lang="en-GB" sz="300" i="0" baseline="0" dirty="0" smtClean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_tradnl" sz="300" i="1" dirty="0" smtClean="0">
                          <a:solidFill>
                            <a:sysClr val="windowText" lastClr="000000"/>
                          </a:solidFill>
                        </a:rPr>
                        <a:t>D</a:t>
                      </a:r>
                      <a:r>
                        <a:rPr lang="es-ES_tradnl" sz="300" i="1" baseline="-25000" dirty="0" smtClean="0">
                          <a:solidFill>
                            <a:sysClr val="windowText" lastClr="000000"/>
                          </a:solidFill>
                        </a:rPr>
                        <a:t>T</a:t>
                      </a:r>
                      <a:endParaRPr lang="en-GB" sz="300" i="1" baseline="-25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>
                          <a:solidFill>
                            <a:sysClr val="windowText" lastClr="000000"/>
                          </a:solidFill>
                        </a:rPr>
                        <a:t>All</a:t>
                      </a:r>
                      <a:endParaRPr lang="fr-FR" sz="3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/>
                        <a:t>50</a:t>
                      </a:r>
                      <a:endParaRPr lang="fr-FR" sz="300" b="1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/>
                        <a:t>0.0552 </a:t>
                      </a:r>
                      <a:r>
                        <a:rPr lang="el-GR" sz="300" b="1" dirty="0" smtClean="0"/>
                        <a:t>±</a:t>
                      </a:r>
                      <a:r>
                        <a:rPr lang="fr-FR" sz="300" b="1" dirty="0" smtClean="0"/>
                        <a:t> 0.0040</a:t>
                      </a:r>
                      <a:endParaRPr lang="fr-FR" sz="300" b="1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/>
                        <a:t>-0.1476 </a:t>
                      </a:r>
                      <a:r>
                        <a:rPr lang="el-GR" sz="300" b="1" dirty="0" smtClean="0"/>
                        <a:t>±</a:t>
                      </a:r>
                      <a:r>
                        <a:rPr lang="fr-FR" sz="300" b="1" dirty="0" smtClean="0"/>
                        <a:t> 0.0122</a:t>
                      </a:r>
                      <a:endParaRPr lang="fr-FR" sz="300" b="1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300" b="1" i="1" dirty="0" smtClean="0"/>
                        <a:t>D</a:t>
                      </a:r>
                      <a:r>
                        <a:rPr lang="es-ES_tradnl" sz="300" b="1" baseline="-25000" dirty="0" smtClean="0"/>
                        <a:t>T</a:t>
                      </a:r>
                      <a:r>
                        <a:rPr lang="es-ES_tradnl" sz="300" b="1" dirty="0" smtClean="0"/>
                        <a:t> = 0.7450  (</a:t>
                      </a:r>
                      <a:r>
                        <a:rPr lang="es-ES_tradnl" sz="300" b="1" i="1" dirty="0" smtClean="0"/>
                        <a:t>P </a:t>
                      </a:r>
                      <a:r>
                        <a:rPr lang="es-ES_tradnl" sz="300" b="1" dirty="0" smtClean="0"/>
                        <a:t>&gt; 0.10)</a:t>
                      </a:r>
                      <a:endParaRPr lang="fr-FR" sz="300" b="1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>
                          <a:solidFill>
                            <a:srgbClr val="00B050"/>
                          </a:solidFill>
                        </a:rPr>
                        <a:t>WT</a:t>
                      </a:r>
                      <a:endParaRPr lang="fr-FR" sz="300" b="0" dirty="0">
                        <a:solidFill>
                          <a:srgbClr val="00B05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32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614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42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-0.1676 </a:t>
                      </a:r>
                      <a:r>
                        <a:rPr lang="el-GR" sz="300" dirty="0" smtClean="0"/>
                        <a:t>±</a:t>
                      </a:r>
                      <a:r>
                        <a:rPr lang="fr-FR" sz="300" dirty="0" smtClean="0"/>
                        <a:t> 0.0144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0.70821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>
                          <a:solidFill>
                            <a:srgbClr val="7030A0"/>
                          </a:solidFill>
                        </a:rPr>
                        <a:t>GM</a:t>
                      </a:r>
                      <a:endParaRPr lang="fr-FR" sz="300" b="0" dirty="0">
                        <a:solidFill>
                          <a:srgbClr val="7030A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18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432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33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-0.1075 </a:t>
                      </a:r>
                      <a:r>
                        <a:rPr lang="el-GR" sz="300" dirty="0" smtClean="0"/>
                        <a:t>±</a:t>
                      </a:r>
                      <a:r>
                        <a:rPr lang="fr-FR" sz="300" dirty="0" smtClean="0"/>
                        <a:t> 0.0106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-0.85935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 smtClean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>
                          <a:solidFill>
                            <a:sysClr val="windowText" lastClr="000000"/>
                          </a:solidFill>
                        </a:rPr>
                        <a:t>WTR</a:t>
                      </a:r>
                      <a:endParaRPr lang="fr-FR" sz="3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13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697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50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-0.1922 </a:t>
                      </a:r>
                      <a:r>
                        <a:rPr lang="el-GR" sz="300" dirty="0" smtClean="0"/>
                        <a:t>±</a:t>
                      </a:r>
                      <a:r>
                        <a:rPr lang="fr-FR" sz="300" dirty="0" smtClean="0"/>
                        <a:t> 0.0173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1.0382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err="1" smtClean="0">
                          <a:solidFill>
                            <a:sysClr val="windowText" lastClr="000000"/>
                          </a:solidFill>
                        </a:rPr>
                        <a:t>ScWT</a:t>
                      </a:r>
                      <a:endParaRPr lang="fr-FR" sz="3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19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527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38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-0.1406 </a:t>
                      </a:r>
                      <a:r>
                        <a:rPr lang="el-GR" sz="300" dirty="0" smtClean="0"/>
                        <a:t>±</a:t>
                      </a:r>
                      <a:r>
                        <a:rPr lang="fr-FR" sz="300" dirty="0" smtClean="0"/>
                        <a:t> 0.0117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-0.0902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smtClean="0">
                          <a:solidFill>
                            <a:sysClr val="windowText" lastClr="000000"/>
                          </a:solidFill>
                        </a:rPr>
                        <a:t>GMR</a:t>
                      </a:r>
                      <a:endParaRPr lang="fr-FR" sz="3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8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237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31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-0.0533 </a:t>
                      </a:r>
                      <a:r>
                        <a:rPr lang="el-GR" sz="300" dirty="0" smtClean="0"/>
                        <a:t>±</a:t>
                      </a:r>
                      <a:r>
                        <a:rPr lang="fr-FR" sz="300" dirty="0" smtClean="0"/>
                        <a:t> 0.0085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0.5973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 smtClean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04190">
                <a:tc>
                  <a:txBody>
                    <a:bodyPr/>
                    <a:lstStyle/>
                    <a:p>
                      <a:pPr algn="ctr"/>
                      <a:r>
                        <a:rPr lang="fr-FR" sz="300" b="1" dirty="0" err="1" smtClean="0">
                          <a:solidFill>
                            <a:sysClr val="windowText" lastClr="000000"/>
                          </a:solidFill>
                        </a:rPr>
                        <a:t>ScGM</a:t>
                      </a:r>
                      <a:endParaRPr lang="fr-FR" sz="3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91868" marR="91868" marT="22015" marB="22015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10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b="0" dirty="0" smtClean="0"/>
                        <a:t>0.0563 </a:t>
                      </a:r>
                      <a:r>
                        <a:rPr lang="el-GR" sz="300" b="0" dirty="0" smtClean="0"/>
                        <a:t>±</a:t>
                      </a:r>
                      <a:r>
                        <a:rPr lang="fr-FR" sz="300" b="0" dirty="0" smtClean="0"/>
                        <a:t> 0.0042</a:t>
                      </a:r>
                      <a:endParaRPr lang="fr-FR" sz="300" b="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300" dirty="0" smtClean="0"/>
                        <a:t>-0.1446 </a:t>
                      </a:r>
                      <a:r>
                        <a:rPr lang="el-GR" sz="300" dirty="0" smtClean="0"/>
                        <a:t>±</a:t>
                      </a:r>
                      <a:r>
                        <a:rPr lang="fr-FR" sz="300" dirty="0" smtClean="0"/>
                        <a:t> 0.0140</a:t>
                      </a:r>
                      <a:endParaRPr lang="fr-FR" sz="300" dirty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_tradnl" sz="300" i="1" dirty="0" smtClean="0"/>
                        <a:t>D</a:t>
                      </a:r>
                      <a:r>
                        <a:rPr lang="es-ES_tradnl" sz="300" baseline="-25000" dirty="0" smtClean="0"/>
                        <a:t>T</a:t>
                      </a:r>
                      <a:r>
                        <a:rPr lang="es-ES_tradnl" sz="300" dirty="0" smtClean="0"/>
                        <a:t> = -0.2749 (</a:t>
                      </a:r>
                      <a:r>
                        <a:rPr lang="es-ES_tradnl" sz="300" i="1" dirty="0" smtClean="0"/>
                        <a:t>P </a:t>
                      </a:r>
                      <a:r>
                        <a:rPr lang="es-ES_tradnl" sz="300" dirty="0" smtClean="0"/>
                        <a:t>&gt; 0.10)</a:t>
                      </a:r>
                      <a:endParaRPr lang="fr-FR" sz="300" dirty="0" smtClean="0"/>
                    </a:p>
                  </a:txBody>
                  <a:tcPr marL="107315" marR="107315" marT="25718" marB="25718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16" name="ZoneTexte 115"/>
          <p:cNvSpPr txBox="1"/>
          <p:nvPr/>
        </p:nvSpPr>
        <p:spPr>
          <a:xfrm>
            <a:off x="928687" y="3063529"/>
            <a:ext cx="1831784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63" dirty="0"/>
              <a:t>c. </a:t>
            </a:r>
            <a:r>
              <a:rPr lang="fr-FR" sz="1300" dirty="0"/>
              <a:t>GFLV-CP</a:t>
            </a:r>
            <a:r>
              <a:rPr lang="fr-FR" sz="1138" dirty="0"/>
              <a:t> (IC-RT-</a:t>
            </a:r>
            <a:r>
              <a:rPr lang="fr-FR" sz="1138" dirty="0" err="1"/>
              <a:t>PCRseq</a:t>
            </a:r>
            <a:r>
              <a:rPr lang="fr-FR" sz="1138" dirty="0"/>
              <a:t>)</a:t>
            </a:r>
          </a:p>
        </p:txBody>
      </p:sp>
      <p:sp>
        <p:nvSpPr>
          <p:cNvPr id="119" name="3 CuadroTexto"/>
          <p:cNvSpPr txBox="1">
            <a:spLocks noChangeArrowheads="1"/>
          </p:cNvSpPr>
          <p:nvPr/>
        </p:nvSpPr>
        <p:spPr bwMode="auto">
          <a:xfrm>
            <a:off x="5882602" y="4095553"/>
            <a:ext cx="1369286" cy="2174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13" i="1" dirty="0"/>
              <a:t>F</a:t>
            </a:r>
            <a:r>
              <a:rPr lang="en-GB" sz="813" i="1" baseline="-25000" dirty="0"/>
              <a:t>ST(WT/GM)</a:t>
            </a:r>
            <a:r>
              <a:rPr lang="en-GB" sz="813" dirty="0"/>
              <a:t> = 0.007 ; </a:t>
            </a:r>
            <a:r>
              <a:rPr lang="en-GB" sz="813" i="1" dirty="0"/>
              <a:t>P </a:t>
            </a:r>
            <a:r>
              <a:rPr lang="en-GB" sz="813" dirty="0"/>
              <a:t>= 0.288</a:t>
            </a:r>
          </a:p>
        </p:txBody>
      </p:sp>
      <p:sp>
        <p:nvSpPr>
          <p:cNvPr id="141" name="Rectangle 140"/>
          <p:cNvSpPr/>
          <p:nvPr/>
        </p:nvSpPr>
        <p:spPr>
          <a:xfrm>
            <a:off x="939781" y="3085858"/>
            <a:ext cx="8006375" cy="132261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63"/>
          </a:p>
        </p:txBody>
      </p:sp>
      <p:grpSp>
        <p:nvGrpSpPr>
          <p:cNvPr id="146" name="Groupe 145"/>
          <p:cNvGrpSpPr/>
          <p:nvPr/>
        </p:nvGrpSpPr>
        <p:grpSpPr>
          <a:xfrm>
            <a:off x="932319" y="3219444"/>
            <a:ext cx="4131563" cy="1260995"/>
            <a:chOff x="3093" y="7495589"/>
            <a:chExt cx="3520385" cy="2241768"/>
          </a:xfrm>
        </p:grpSpPr>
        <p:grpSp>
          <p:nvGrpSpPr>
            <p:cNvPr id="147" name="Groupe 232"/>
            <p:cNvGrpSpPr/>
            <p:nvPr/>
          </p:nvGrpSpPr>
          <p:grpSpPr>
            <a:xfrm>
              <a:off x="277522" y="7495589"/>
              <a:ext cx="3152182" cy="353262"/>
              <a:chOff x="255980" y="5423757"/>
              <a:chExt cx="3152182" cy="353262"/>
            </a:xfrm>
          </p:grpSpPr>
          <p:sp>
            <p:nvSpPr>
              <p:cNvPr id="186" name="Rectangle 185"/>
              <p:cNvSpPr/>
              <p:nvPr/>
            </p:nvSpPr>
            <p:spPr>
              <a:xfrm>
                <a:off x="380051" y="5616803"/>
                <a:ext cx="2934000" cy="144000"/>
              </a:xfrm>
              <a:prstGeom prst="rect">
                <a:avLst/>
              </a:prstGeom>
              <a:solidFill>
                <a:schemeClr val="accent6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975" dirty="0">
                    <a:solidFill>
                      <a:schemeClr val="tx1"/>
                    </a:solidFill>
                  </a:rPr>
                  <a:t>2C</a:t>
                </a:r>
                <a:r>
                  <a:rPr lang="fr-FR" sz="975" baseline="30000" dirty="0">
                    <a:solidFill>
                      <a:schemeClr val="tx1"/>
                    </a:solidFill>
                  </a:rPr>
                  <a:t>CP</a:t>
                </a:r>
                <a:endParaRPr lang="en-US" sz="975" dirty="0"/>
              </a:p>
            </p:txBody>
          </p:sp>
          <p:sp>
            <p:nvSpPr>
              <p:cNvPr id="187" name="ZoneTexte 186"/>
              <p:cNvSpPr txBox="1"/>
              <p:nvPr/>
            </p:nvSpPr>
            <p:spPr>
              <a:xfrm>
                <a:off x="255980" y="5423757"/>
                <a:ext cx="299399" cy="3419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50" dirty="0"/>
                  <a:t>2047</a:t>
                </a:r>
                <a:endParaRPr lang="en-US" sz="650" dirty="0"/>
              </a:p>
            </p:txBody>
          </p:sp>
          <p:sp>
            <p:nvSpPr>
              <p:cNvPr id="188" name="ZoneTexte 187"/>
              <p:cNvSpPr txBox="1"/>
              <p:nvPr/>
            </p:nvSpPr>
            <p:spPr>
              <a:xfrm>
                <a:off x="3108763" y="5435046"/>
                <a:ext cx="299399" cy="3419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50" dirty="0"/>
                  <a:t>3559</a:t>
                </a:r>
                <a:endParaRPr lang="en-US" sz="650" dirty="0"/>
              </a:p>
            </p:txBody>
          </p:sp>
          <p:cxnSp>
            <p:nvCxnSpPr>
              <p:cNvPr id="189" name="Connecteur droit 188"/>
              <p:cNvCxnSpPr/>
              <p:nvPr/>
            </p:nvCxnSpPr>
            <p:spPr>
              <a:xfrm>
                <a:off x="372628" y="5773504"/>
                <a:ext cx="29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9" name="Groupe 327"/>
            <p:cNvGrpSpPr/>
            <p:nvPr/>
          </p:nvGrpSpPr>
          <p:grpSpPr>
            <a:xfrm>
              <a:off x="3093" y="7664904"/>
              <a:ext cx="3520385" cy="2072453"/>
              <a:chOff x="3093" y="7664904"/>
              <a:chExt cx="3520385" cy="2072453"/>
            </a:xfrm>
          </p:grpSpPr>
          <p:pic>
            <p:nvPicPr>
              <p:cNvPr id="153" name="Picture 1"/>
              <p:cNvPicPr preferRelativeResize="0">
                <a:picLocks noChangeArrowheads="1"/>
              </p:cNvPicPr>
              <p:nvPr/>
            </p:nvPicPr>
            <p:blipFill>
              <a:blip r:embed="rId4" cstate="print"/>
              <a:srcRect l="3832" r="9696"/>
              <a:stretch>
                <a:fillRect/>
              </a:stretch>
            </p:blipFill>
            <p:spPr bwMode="auto">
              <a:xfrm>
                <a:off x="356952" y="8789478"/>
                <a:ext cx="2988000" cy="788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57" name="Picture 1"/>
              <p:cNvPicPr preferRelativeResize="0">
                <a:picLocks noChangeArrowheads="1"/>
              </p:cNvPicPr>
              <p:nvPr/>
            </p:nvPicPr>
            <p:blipFill>
              <a:blip r:embed="rId5" cstate="print"/>
              <a:srcRect l="4404" r="9480"/>
              <a:stretch>
                <a:fillRect/>
              </a:stretch>
            </p:blipFill>
            <p:spPr bwMode="auto">
              <a:xfrm>
                <a:off x="371003" y="7929860"/>
                <a:ext cx="2988000" cy="788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158" name="Connecteur droit 157"/>
              <p:cNvCxnSpPr/>
              <p:nvPr/>
            </p:nvCxnSpPr>
            <p:spPr>
              <a:xfrm>
                <a:off x="410274" y="7880543"/>
                <a:ext cx="1" cy="1656184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9" name="ZoneTexte 20"/>
              <p:cNvSpPr txBox="1">
                <a:spLocks noChangeArrowheads="1"/>
              </p:cNvSpPr>
              <p:nvPr/>
            </p:nvSpPr>
            <p:spPr bwMode="auto">
              <a:xfrm>
                <a:off x="2273558" y="8668111"/>
                <a:ext cx="277545" cy="2976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fr-FR" altLang="en-US" sz="488" dirty="0"/>
                  <a:t>1000</a:t>
                </a:r>
              </a:p>
            </p:txBody>
          </p:sp>
          <p:sp>
            <p:nvSpPr>
              <p:cNvPr id="160" name="ZoneTexte 20"/>
              <p:cNvSpPr txBox="1">
                <a:spLocks noChangeArrowheads="1"/>
              </p:cNvSpPr>
              <p:nvPr/>
            </p:nvSpPr>
            <p:spPr bwMode="auto">
              <a:xfrm>
                <a:off x="1293947" y="8668111"/>
                <a:ext cx="247496" cy="2976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fr-FR" altLang="en-US" sz="488" dirty="0"/>
                  <a:t>500</a:t>
                </a:r>
              </a:p>
            </p:txBody>
          </p:sp>
          <p:cxnSp>
            <p:nvCxnSpPr>
              <p:cNvPr id="161" name="Connecteur droit 160"/>
              <p:cNvCxnSpPr/>
              <p:nvPr/>
            </p:nvCxnSpPr>
            <p:spPr>
              <a:xfrm>
                <a:off x="3324254" y="7880543"/>
                <a:ext cx="1" cy="1656184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2" name="ZoneTexte 31"/>
              <p:cNvSpPr txBox="1">
                <a:spLocks noChangeArrowheads="1"/>
              </p:cNvSpPr>
              <p:nvPr/>
            </p:nvSpPr>
            <p:spPr bwMode="auto">
              <a:xfrm rot="16200000">
                <a:off x="-461691" y="9087101"/>
                <a:ext cx="1114837" cy="18526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fr-FR" sz="813" i="1" dirty="0" err="1"/>
                  <a:t>Tajima’s</a:t>
                </a:r>
                <a:r>
                  <a:rPr lang="fr-FR" sz="813" i="1" dirty="0"/>
                  <a:t> D</a:t>
                </a:r>
              </a:p>
            </p:txBody>
          </p:sp>
          <p:sp>
            <p:nvSpPr>
              <p:cNvPr id="163" name="ZoneTexte 20"/>
              <p:cNvSpPr txBox="1">
                <a:spLocks noChangeArrowheads="1"/>
              </p:cNvSpPr>
              <p:nvPr/>
            </p:nvSpPr>
            <p:spPr bwMode="auto">
              <a:xfrm>
                <a:off x="244200" y="8977741"/>
                <a:ext cx="232471" cy="2976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fr-FR" altLang="en-US" sz="488" dirty="0"/>
                  <a:t>1.0</a:t>
                </a:r>
              </a:p>
            </p:txBody>
          </p:sp>
          <p:sp>
            <p:nvSpPr>
              <p:cNvPr id="164" name="ZoneTexte 20"/>
              <p:cNvSpPr txBox="1">
                <a:spLocks noChangeArrowheads="1"/>
              </p:cNvSpPr>
              <p:nvPr/>
            </p:nvSpPr>
            <p:spPr bwMode="auto">
              <a:xfrm>
                <a:off x="244200" y="8859917"/>
                <a:ext cx="232471" cy="2976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fr-FR" altLang="en-US" sz="488" dirty="0"/>
                  <a:t>2.0</a:t>
                </a:r>
              </a:p>
            </p:txBody>
          </p:sp>
          <p:sp>
            <p:nvSpPr>
              <p:cNvPr id="165" name="ZoneTexte 20"/>
              <p:cNvSpPr txBox="1">
                <a:spLocks noChangeArrowheads="1"/>
              </p:cNvSpPr>
              <p:nvPr/>
            </p:nvSpPr>
            <p:spPr bwMode="auto">
              <a:xfrm>
                <a:off x="244200" y="8743807"/>
                <a:ext cx="232471" cy="2976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fr-FR" altLang="en-US" sz="488" dirty="0"/>
                  <a:t>3.0</a:t>
                </a:r>
              </a:p>
            </p:txBody>
          </p:sp>
          <p:sp>
            <p:nvSpPr>
              <p:cNvPr id="166" name="ZoneTexte 31"/>
              <p:cNvSpPr txBox="1">
                <a:spLocks noChangeArrowheads="1"/>
              </p:cNvSpPr>
              <p:nvPr/>
            </p:nvSpPr>
            <p:spPr bwMode="auto">
              <a:xfrm rot="16200000">
                <a:off x="-562858" y="8230855"/>
                <a:ext cx="1317170" cy="18526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l-GR" sz="813" i="1" dirty="0"/>
                  <a:t>π </a:t>
                </a:r>
                <a:r>
                  <a:rPr lang="fr-FR" sz="813" i="1" dirty="0"/>
                  <a:t>(</a:t>
                </a:r>
                <a:r>
                  <a:rPr lang="fr-FR" sz="813" i="1" dirty="0" err="1"/>
                  <a:t>subst</a:t>
                </a:r>
                <a:r>
                  <a:rPr lang="fr-FR" sz="813" i="1" dirty="0"/>
                  <a:t>/site)</a:t>
                </a:r>
              </a:p>
            </p:txBody>
          </p:sp>
          <p:sp>
            <p:nvSpPr>
              <p:cNvPr id="167" name="ZoneTexte 20"/>
              <p:cNvSpPr txBox="1">
                <a:spLocks noChangeArrowheads="1"/>
              </p:cNvSpPr>
              <p:nvPr/>
            </p:nvSpPr>
            <p:spPr bwMode="auto">
              <a:xfrm>
                <a:off x="214153" y="8411108"/>
                <a:ext cx="262521" cy="2976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fr-FR" altLang="en-US" sz="488" dirty="0"/>
                  <a:t>0.05</a:t>
                </a:r>
              </a:p>
            </p:txBody>
          </p:sp>
          <p:sp>
            <p:nvSpPr>
              <p:cNvPr id="168" name="ZoneTexte 20"/>
              <p:cNvSpPr txBox="1">
                <a:spLocks noChangeArrowheads="1"/>
              </p:cNvSpPr>
              <p:nvPr/>
            </p:nvSpPr>
            <p:spPr bwMode="auto">
              <a:xfrm>
                <a:off x="214153" y="8236755"/>
                <a:ext cx="262521" cy="2976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fr-FR" altLang="en-US" sz="488" dirty="0"/>
                  <a:t>0.10</a:t>
                </a:r>
              </a:p>
            </p:txBody>
          </p:sp>
          <p:sp>
            <p:nvSpPr>
              <p:cNvPr id="169" name="ZoneTexte 20"/>
              <p:cNvSpPr txBox="1">
                <a:spLocks noChangeArrowheads="1"/>
              </p:cNvSpPr>
              <p:nvPr/>
            </p:nvSpPr>
            <p:spPr bwMode="auto">
              <a:xfrm>
                <a:off x="214153" y="8059738"/>
                <a:ext cx="262521" cy="2976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fr-FR" altLang="en-US" sz="488" dirty="0"/>
                  <a:t>0.15</a:t>
                </a:r>
              </a:p>
            </p:txBody>
          </p:sp>
          <p:sp>
            <p:nvSpPr>
              <p:cNvPr id="170" name="ZoneTexte 20"/>
              <p:cNvSpPr txBox="1">
                <a:spLocks noChangeArrowheads="1"/>
              </p:cNvSpPr>
              <p:nvPr/>
            </p:nvSpPr>
            <p:spPr bwMode="auto">
              <a:xfrm>
                <a:off x="214153" y="7885384"/>
                <a:ext cx="262521" cy="2976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fr-FR" altLang="en-US" sz="488" dirty="0"/>
                  <a:t>0.20</a:t>
                </a:r>
              </a:p>
            </p:txBody>
          </p:sp>
          <p:sp>
            <p:nvSpPr>
              <p:cNvPr id="171" name="ZoneTexte 20"/>
              <p:cNvSpPr txBox="1">
                <a:spLocks noChangeArrowheads="1"/>
              </p:cNvSpPr>
              <p:nvPr/>
            </p:nvSpPr>
            <p:spPr bwMode="auto">
              <a:xfrm>
                <a:off x="214153" y="8583795"/>
                <a:ext cx="262521" cy="2976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fr-FR" altLang="en-US" sz="488" dirty="0"/>
                  <a:t>0.00</a:t>
                </a:r>
              </a:p>
            </p:txBody>
          </p:sp>
          <p:sp>
            <p:nvSpPr>
              <p:cNvPr id="172" name="ZoneTexte 20"/>
              <p:cNvSpPr txBox="1">
                <a:spLocks noChangeArrowheads="1"/>
              </p:cNvSpPr>
              <p:nvPr/>
            </p:nvSpPr>
            <p:spPr bwMode="auto">
              <a:xfrm>
                <a:off x="244199" y="9092607"/>
                <a:ext cx="232471" cy="2976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fr-FR" altLang="en-US" sz="488" dirty="0"/>
                  <a:t>0.0</a:t>
                </a:r>
              </a:p>
            </p:txBody>
          </p:sp>
          <p:sp>
            <p:nvSpPr>
              <p:cNvPr id="173" name="ZoneTexte 20"/>
              <p:cNvSpPr txBox="1">
                <a:spLocks noChangeArrowheads="1"/>
              </p:cNvSpPr>
              <p:nvPr/>
            </p:nvSpPr>
            <p:spPr bwMode="auto">
              <a:xfrm>
                <a:off x="226444" y="9439725"/>
                <a:ext cx="250228" cy="2976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fr-FR" altLang="en-US" sz="488" dirty="0"/>
                  <a:t>-3.0</a:t>
                </a:r>
              </a:p>
            </p:txBody>
          </p:sp>
          <p:sp>
            <p:nvSpPr>
              <p:cNvPr id="174" name="ZoneTexte 20"/>
              <p:cNvSpPr txBox="1">
                <a:spLocks noChangeArrowheads="1"/>
              </p:cNvSpPr>
              <p:nvPr/>
            </p:nvSpPr>
            <p:spPr bwMode="auto">
              <a:xfrm>
                <a:off x="226444" y="9211117"/>
                <a:ext cx="250228" cy="2976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fr-FR" altLang="en-US" sz="488" dirty="0"/>
                  <a:t>-1.0</a:t>
                </a:r>
              </a:p>
            </p:txBody>
          </p:sp>
          <p:sp>
            <p:nvSpPr>
              <p:cNvPr id="175" name="ZoneTexte 20"/>
              <p:cNvSpPr txBox="1">
                <a:spLocks noChangeArrowheads="1"/>
              </p:cNvSpPr>
              <p:nvPr/>
            </p:nvSpPr>
            <p:spPr bwMode="auto">
              <a:xfrm>
                <a:off x="226444" y="9326161"/>
                <a:ext cx="250228" cy="2976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r" eaLnBrk="1" hangingPunct="1"/>
                <a:r>
                  <a:rPr lang="fr-FR" altLang="en-US" sz="488" dirty="0"/>
                  <a:t>-2.0</a:t>
                </a:r>
              </a:p>
            </p:txBody>
          </p:sp>
          <p:sp>
            <p:nvSpPr>
              <p:cNvPr id="176" name="ZoneTexte 175"/>
              <p:cNvSpPr txBox="1"/>
              <p:nvPr/>
            </p:nvSpPr>
            <p:spPr>
              <a:xfrm rot="16200000">
                <a:off x="3047981" y="9256112"/>
                <a:ext cx="744364" cy="2066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488" b="1" dirty="0" err="1">
                    <a:solidFill>
                      <a:srgbClr val="C00000"/>
                    </a:solidFill>
                  </a:rPr>
                  <a:t>Selective</a:t>
                </a:r>
                <a:endParaRPr lang="fr-FR" sz="488" b="1" dirty="0">
                  <a:solidFill>
                    <a:srgbClr val="C00000"/>
                  </a:solidFill>
                </a:endParaRPr>
              </a:p>
              <a:p>
                <a:pPr algn="ctr"/>
                <a:r>
                  <a:rPr lang="fr-FR" sz="488" b="1" dirty="0" err="1">
                    <a:solidFill>
                      <a:srgbClr val="C00000"/>
                    </a:solidFill>
                  </a:rPr>
                  <a:t>sweep</a:t>
                </a:r>
                <a:endParaRPr lang="fr-FR" sz="488" b="1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177" name="ZoneTexte 176"/>
              <p:cNvSpPr txBox="1"/>
              <p:nvPr/>
            </p:nvSpPr>
            <p:spPr>
              <a:xfrm rot="16200000">
                <a:off x="3032308" y="8909108"/>
                <a:ext cx="775712" cy="2066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488" b="1" dirty="0" err="1">
                    <a:solidFill>
                      <a:schemeClr val="accent6">
                        <a:lumMod val="75000"/>
                      </a:schemeClr>
                    </a:solidFill>
                  </a:rPr>
                  <a:t>Balancing</a:t>
                </a:r>
                <a:endParaRPr lang="fr-FR" sz="488" b="1" dirty="0">
                  <a:solidFill>
                    <a:schemeClr val="accent6">
                      <a:lumMod val="75000"/>
                    </a:schemeClr>
                  </a:solidFill>
                </a:endParaRPr>
              </a:p>
              <a:p>
                <a:pPr algn="ctr"/>
                <a:r>
                  <a:rPr lang="fr-FR" sz="488" b="1" dirty="0" err="1">
                    <a:solidFill>
                      <a:schemeClr val="accent6">
                        <a:lumMod val="75000"/>
                      </a:schemeClr>
                    </a:solidFill>
                  </a:rPr>
                  <a:t>selection</a:t>
                </a:r>
                <a:endParaRPr lang="fr-FR" sz="488" b="1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  <p:cxnSp>
            <p:nvCxnSpPr>
              <p:cNvPr id="178" name="Connecteur droit 177"/>
              <p:cNvCxnSpPr/>
              <p:nvPr/>
            </p:nvCxnSpPr>
            <p:spPr>
              <a:xfrm>
                <a:off x="404664" y="9182193"/>
                <a:ext cx="3096000" cy="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9" name="Forme libre 178"/>
              <p:cNvSpPr/>
              <p:nvPr/>
            </p:nvSpPr>
            <p:spPr>
              <a:xfrm>
                <a:off x="404664" y="7968208"/>
                <a:ext cx="2912269" cy="700088"/>
              </a:xfrm>
              <a:custGeom>
                <a:avLst/>
                <a:gdLst>
                  <a:gd name="connsiteX0" fmla="*/ 0 w 2912269"/>
                  <a:gd name="connsiteY0" fmla="*/ 2382 h 700088"/>
                  <a:gd name="connsiteX1" fmla="*/ 2909888 w 2912269"/>
                  <a:gd name="connsiteY1" fmla="*/ 0 h 700088"/>
                  <a:gd name="connsiteX2" fmla="*/ 2912269 w 2912269"/>
                  <a:gd name="connsiteY2" fmla="*/ 697707 h 700088"/>
                  <a:gd name="connsiteX3" fmla="*/ 4763 w 2912269"/>
                  <a:gd name="connsiteY3" fmla="*/ 700088 h 700088"/>
                  <a:gd name="connsiteX4" fmla="*/ 0 w 2912269"/>
                  <a:gd name="connsiteY4" fmla="*/ 2382 h 7000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912269" h="700088">
                    <a:moveTo>
                      <a:pt x="0" y="2382"/>
                    </a:moveTo>
                    <a:lnTo>
                      <a:pt x="2909888" y="0"/>
                    </a:lnTo>
                    <a:cubicBezTo>
                      <a:pt x="2910682" y="232569"/>
                      <a:pt x="2911475" y="465138"/>
                      <a:pt x="2912269" y="697707"/>
                    </a:cubicBezTo>
                    <a:lnTo>
                      <a:pt x="4763" y="700088"/>
                    </a:lnTo>
                    <a:cubicBezTo>
                      <a:pt x="3175" y="467519"/>
                      <a:pt x="1588" y="234951"/>
                      <a:pt x="0" y="2382"/>
                    </a:cubicBezTo>
                    <a:close/>
                  </a:path>
                </a:pathLst>
              </a:custGeom>
              <a:solidFill>
                <a:srgbClr val="D9D9D9">
                  <a:alpha val="10196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463"/>
              </a:p>
            </p:txBody>
          </p:sp>
          <p:sp>
            <p:nvSpPr>
              <p:cNvPr id="180" name="Forme libre 179"/>
              <p:cNvSpPr/>
              <p:nvPr/>
            </p:nvSpPr>
            <p:spPr>
              <a:xfrm>
                <a:off x="404664" y="8832304"/>
                <a:ext cx="2912269" cy="700088"/>
              </a:xfrm>
              <a:custGeom>
                <a:avLst/>
                <a:gdLst>
                  <a:gd name="connsiteX0" fmla="*/ 0 w 2912269"/>
                  <a:gd name="connsiteY0" fmla="*/ 2382 h 700088"/>
                  <a:gd name="connsiteX1" fmla="*/ 2909888 w 2912269"/>
                  <a:gd name="connsiteY1" fmla="*/ 0 h 700088"/>
                  <a:gd name="connsiteX2" fmla="*/ 2912269 w 2912269"/>
                  <a:gd name="connsiteY2" fmla="*/ 697707 h 700088"/>
                  <a:gd name="connsiteX3" fmla="*/ 4763 w 2912269"/>
                  <a:gd name="connsiteY3" fmla="*/ 700088 h 700088"/>
                  <a:gd name="connsiteX4" fmla="*/ 0 w 2912269"/>
                  <a:gd name="connsiteY4" fmla="*/ 2382 h 7000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912269" h="700088">
                    <a:moveTo>
                      <a:pt x="0" y="2382"/>
                    </a:moveTo>
                    <a:lnTo>
                      <a:pt x="2909888" y="0"/>
                    </a:lnTo>
                    <a:cubicBezTo>
                      <a:pt x="2910682" y="232569"/>
                      <a:pt x="2911475" y="465138"/>
                      <a:pt x="2912269" y="697707"/>
                    </a:cubicBezTo>
                    <a:lnTo>
                      <a:pt x="4763" y="700088"/>
                    </a:lnTo>
                    <a:cubicBezTo>
                      <a:pt x="3175" y="467519"/>
                      <a:pt x="1588" y="234951"/>
                      <a:pt x="0" y="2382"/>
                    </a:cubicBezTo>
                    <a:close/>
                  </a:path>
                </a:pathLst>
              </a:custGeom>
              <a:solidFill>
                <a:srgbClr val="D9D9D9">
                  <a:alpha val="10196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463"/>
              </a:p>
            </p:txBody>
          </p:sp>
          <p:sp>
            <p:nvSpPr>
              <p:cNvPr id="181" name="Forme libre 180"/>
              <p:cNvSpPr/>
              <p:nvPr/>
            </p:nvSpPr>
            <p:spPr>
              <a:xfrm>
                <a:off x="410369" y="9184481"/>
                <a:ext cx="196850" cy="126207"/>
              </a:xfrm>
              <a:custGeom>
                <a:avLst/>
                <a:gdLst>
                  <a:gd name="connsiteX0" fmla="*/ 1587 w 196850"/>
                  <a:gd name="connsiteY0" fmla="*/ 126207 h 126207"/>
                  <a:gd name="connsiteX1" fmla="*/ 70644 w 196850"/>
                  <a:gd name="connsiteY1" fmla="*/ 69057 h 126207"/>
                  <a:gd name="connsiteX2" fmla="*/ 120650 w 196850"/>
                  <a:gd name="connsiteY2" fmla="*/ 35719 h 126207"/>
                  <a:gd name="connsiteX3" fmla="*/ 175419 w 196850"/>
                  <a:gd name="connsiteY3" fmla="*/ 23813 h 126207"/>
                  <a:gd name="connsiteX4" fmla="*/ 196850 w 196850"/>
                  <a:gd name="connsiteY4" fmla="*/ 2382 h 126207"/>
                  <a:gd name="connsiteX5" fmla="*/ 1587 w 196850"/>
                  <a:gd name="connsiteY5" fmla="*/ 0 h 126207"/>
                  <a:gd name="connsiteX6" fmla="*/ 1587 w 196850"/>
                  <a:gd name="connsiteY6" fmla="*/ 126207 h 12620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96850" h="126207">
                    <a:moveTo>
                      <a:pt x="1587" y="126207"/>
                    </a:moveTo>
                    <a:lnTo>
                      <a:pt x="70644" y="69057"/>
                    </a:lnTo>
                    <a:lnTo>
                      <a:pt x="120650" y="35719"/>
                    </a:lnTo>
                    <a:lnTo>
                      <a:pt x="175419" y="23813"/>
                    </a:lnTo>
                    <a:lnTo>
                      <a:pt x="196850" y="2382"/>
                    </a:lnTo>
                    <a:lnTo>
                      <a:pt x="1587" y="0"/>
                    </a:lnTo>
                    <a:cubicBezTo>
                      <a:pt x="793" y="41275"/>
                      <a:pt x="0" y="82550"/>
                      <a:pt x="1587" y="126207"/>
                    </a:cubicBezTo>
                    <a:close/>
                  </a:path>
                </a:pathLst>
              </a:custGeom>
              <a:solidFill>
                <a:srgbClr val="C00000">
                  <a:alpha val="30196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463"/>
              </a:p>
            </p:txBody>
          </p:sp>
          <p:sp>
            <p:nvSpPr>
              <p:cNvPr id="182" name="Forme libre 181"/>
              <p:cNvSpPr/>
              <p:nvPr/>
            </p:nvSpPr>
            <p:spPr>
              <a:xfrm>
                <a:off x="1131094" y="9182100"/>
                <a:ext cx="245269" cy="71438"/>
              </a:xfrm>
              <a:custGeom>
                <a:avLst/>
                <a:gdLst>
                  <a:gd name="connsiteX0" fmla="*/ 0 w 245269"/>
                  <a:gd name="connsiteY0" fmla="*/ 2381 h 71438"/>
                  <a:gd name="connsiteX1" fmla="*/ 54769 w 245269"/>
                  <a:gd name="connsiteY1" fmla="*/ 45244 h 71438"/>
                  <a:gd name="connsiteX2" fmla="*/ 102394 w 245269"/>
                  <a:gd name="connsiteY2" fmla="*/ 33338 h 71438"/>
                  <a:gd name="connsiteX3" fmla="*/ 152400 w 245269"/>
                  <a:gd name="connsiteY3" fmla="*/ 71438 h 71438"/>
                  <a:gd name="connsiteX4" fmla="*/ 209550 w 245269"/>
                  <a:gd name="connsiteY4" fmla="*/ 45244 h 71438"/>
                  <a:gd name="connsiteX5" fmla="*/ 245269 w 245269"/>
                  <a:gd name="connsiteY5" fmla="*/ 0 h 71438"/>
                  <a:gd name="connsiteX6" fmla="*/ 0 w 245269"/>
                  <a:gd name="connsiteY6" fmla="*/ 2381 h 714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245269" h="71438">
                    <a:moveTo>
                      <a:pt x="0" y="2381"/>
                    </a:moveTo>
                    <a:lnTo>
                      <a:pt x="54769" y="45244"/>
                    </a:lnTo>
                    <a:lnTo>
                      <a:pt x="102394" y="33338"/>
                    </a:lnTo>
                    <a:lnTo>
                      <a:pt x="152400" y="71438"/>
                    </a:lnTo>
                    <a:lnTo>
                      <a:pt x="209550" y="45244"/>
                    </a:lnTo>
                    <a:lnTo>
                      <a:pt x="245269" y="0"/>
                    </a:lnTo>
                    <a:lnTo>
                      <a:pt x="0" y="2381"/>
                    </a:lnTo>
                    <a:close/>
                  </a:path>
                </a:pathLst>
              </a:custGeom>
              <a:solidFill>
                <a:srgbClr val="C00000">
                  <a:alpha val="30196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463"/>
              </a:p>
            </p:txBody>
          </p:sp>
          <p:sp>
            <p:nvSpPr>
              <p:cNvPr id="183" name="Forme libre 182"/>
              <p:cNvSpPr/>
              <p:nvPr/>
            </p:nvSpPr>
            <p:spPr>
              <a:xfrm>
                <a:off x="409575" y="9189244"/>
                <a:ext cx="180975" cy="104775"/>
              </a:xfrm>
              <a:custGeom>
                <a:avLst/>
                <a:gdLst>
                  <a:gd name="connsiteX0" fmla="*/ 0 w 180975"/>
                  <a:gd name="connsiteY0" fmla="*/ 64294 h 104775"/>
                  <a:gd name="connsiteX1" fmla="*/ 71438 w 180975"/>
                  <a:gd name="connsiteY1" fmla="*/ 104775 h 104775"/>
                  <a:gd name="connsiteX2" fmla="*/ 119063 w 180975"/>
                  <a:gd name="connsiteY2" fmla="*/ 14287 h 104775"/>
                  <a:gd name="connsiteX3" fmla="*/ 180975 w 180975"/>
                  <a:gd name="connsiteY3" fmla="*/ 0 h 104775"/>
                  <a:gd name="connsiteX4" fmla="*/ 0 w 180975"/>
                  <a:gd name="connsiteY4" fmla="*/ 0 h 104775"/>
                  <a:gd name="connsiteX5" fmla="*/ 0 w 180975"/>
                  <a:gd name="connsiteY5" fmla="*/ 64294 h 1047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80975" h="104775">
                    <a:moveTo>
                      <a:pt x="0" y="64294"/>
                    </a:moveTo>
                    <a:lnTo>
                      <a:pt x="71438" y="104775"/>
                    </a:lnTo>
                    <a:lnTo>
                      <a:pt x="119063" y="14287"/>
                    </a:lnTo>
                    <a:lnTo>
                      <a:pt x="180975" y="0"/>
                    </a:lnTo>
                    <a:lnTo>
                      <a:pt x="0" y="0"/>
                    </a:lnTo>
                    <a:cubicBezTo>
                      <a:pt x="794" y="22225"/>
                      <a:pt x="1587" y="44450"/>
                      <a:pt x="0" y="64294"/>
                    </a:cubicBezTo>
                    <a:close/>
                  </a:path>
                </a:pathLst>
              </a:custGeom>
              <a:solidFill>
                <a:srgbClr val="C00000">
                  <a:alpha val="30196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463"/>
              </a:p>
            </p:txBody>
          </p:sp>
          <p:sp>
            <p:nvSpPr>
              <p:cNvPr id="184" name="Forme libre 183"/>
              <p:cNvSpPr/>
              <p:nvPr/>
            </p:nvSpPr>
            <p:spPr>
              <a:xfrm>
                <a:off x="1512094" y="9182100"/>
                <a:ext cx="1812131" cy="219075"/>
              </a:xfrm>
              <a:custGeom>
                <a:avLst/>
                <a:gdLst>
                  <a:gd name="connsiteX0" fmla="*/ 0 w 1812131"/>
                  <a:gd name="connsiteY0" fmla="*/ 4763 h 219075"/>
                  <a:gd name="connsiteX1" fmla="*/ 71437 w 1812131"/>
                  <a:gd name="connsiteY1" fmla="*/ 54769 h 219075"/>
                  <a:gd name="connsiteX2" fmla="*/ 126206 w 1812131"/>
                  <a:gd name="connsiteY2" fmla="*/ 121444 h 219075"/>
                  <a:gd name="connsiteX3" fmla="*/ 190500 w 1812131"/>
                  <a:gd name="connsiteY3" fmla="*/ 76200 h 219075"/>
                  <a:gd name="connsiteX4" fmla="*/ 223837 w 1812131"/>
                  <a:gd name="connsiteY4" fmla="*/ 30956 h 219075"/>
                  <a:gd name="connsiteX5" fmla="*/ 285750 w 1812131"/>
                  <a:gd name="connsiteY5" fmla="*/ 73819 h 219075"/>
                  <a:gd name="connsiteX6" fmla="*/ 326231 w 1812131"/>
                  <a:gd name="connsiteY6" fmla="*/ 83344 h 219075"/>
                  <a:gd name="connsiteX7" fmla="*/ 378619 w 1812131"/>
                  <a:gd name="connsiteY7" fmla="*/ 161925 h 219075"/>
                  <a:gd name="connsiteX8" fmla="*/ 426244 w 1812131"/>
                  <a:gd name="connsiteY8" fmla="*/ 190500 h 219075"/>
                  <a:gd name="connsiteX9" fmla="*/ 483394 w 1812131"/>
                  <a:gd name="connsiteY9" fmla="*/ 157163 h 219075"/>
                  <a:gd name="connsiteX10" fmla="*/ 523875 w 1812131"/>
                  <a:gd name="connsiteY10" fmla="*/ 64294 h 219075"/>
                  <a:gd name="connsiteX11" fmla="*/ 573881 w 1812131"/>
                  <a:gd name="connsiteY11" fmla="*/ 57150 h 219075"/>
                  <a:gd name="connsiteX12" fmla="*/ 626269 w 1812131"/>
                  <a:gd name="connsiteY12" fmla="*/ 80963 h 219075"/>
                  <a:gd name="connsiteX13" fmla="*/ 681037 w 1812131"/>
                  <a:gd name="connsiteY13" fmla="*/ 121444 h 219075"/>
                  <a:gd name="connsiteX14" fmla="*/ 728662 w 1812131"/>
                  <a:gd name="connsiteY14" fmla="*/ 211931 h 219075"/>
                  <a:gd name="connsiteX15" fmla="*/ 778669 w 1812131"/>
                  <a:gd name="connsiteY15" fmla="*/ 202406 h 219075"/>
                  <a:gd name="connsiteX16" fmla="*/ 833437 w 1812131"/>
                  <a:gd name="connsiteY16" fmla="*/ 219075 h 219075"/>
                  <a:gd name="connsiteX17" fmla="*/ 876300 w 1812131"/>
                  <a:gd name="connsiteY17" fmla="*/ 161925 h 219075"/>
                  <a:gd name="connsiteX18" fmla="*/ 928687 w 1812131"/>
                  <a:gd name="connsiteY18" fmla="*/ 183356 h 219075"/>
                  <a:gd name="connsiteX19" fmla="*/ 985837 w 1812131"/>
                  <a:gd name="connsiteY19" fmla="*/ 130969 h 219075"/>
                  <a:gd name="connsiteX20" fmla="*/ 1031081 w 1812131"/>
                  <a:gd name="connsiteY20" fmla="*/ 50006 h 219075"/>
                  <a:gd name="connsiteX21" fmla="*/ 1083469 w 1812131"/>
                  <a:gd name="connsiteY21" fmla="*/ 121444 h 219075"/>
                  <a:gd name="connsiteX22" fmla="*/ 1133475 w 1812131"/>
                  <a:gd name="connsiteY22" fmla="*/ 52388 h 219075"/>
                  <a:gd name="connsiteX23" fmla="*/ 1235869 w 1812131"/>
                  <a:gd name="connsiteY23" fmla="*/ 169069 h 219075"/>
                  <a:gd name="connsiteX24" fmla="*/ 1283494 w 1812131"/>
                  <a:gd name="connsiteY24" fmla="*/ 169069 h 219075"/>
                  <a:gd name="connsiteX25" fmla="*/ 1328737 w 1812131"/>
                  <a:gd name="connsiteY25" fmla="*/ 204788 h 219075"/>
                  <a:gd name="connsiteX26" fmla="*/ 1383506 w 1812131"/>
                  <a:gd name="connsiteY26" fmla="*/ 216694 h 219075"/>
                  <a:gd name="connsiteX27" fmla="*/ 1435894 w 1812131"/>
                  <a:gd name="connsiteY27" fmla="*/ 178594 h 219075"/>
                  <a:gd name="connsiteX28" fmla="*/ 1488281 w 1812131"/>
                  <a:gd name="connsiteY28" fmla="*/ 180975 h 219075"/>
                  <a:gd name="connsiteX29" fmla="*/ 1531144 w 1812131"/>
                  <a:gd name="connsiteY29" fmla="*/ 185738 h 219075"/>
                  <a:gd name="connsiteX30" fmla="*/ 1581150 w 1812131"/>
                  <a:gd name="connsiteY30" fmla="*/ 152400 h 219075"/>
                  <a:gd name="connsiteX31" fmla="*/ 1626394 w 1812131"/>
                  <a:gd name="connsiteY31" fmla="*/ 178594 h 219075"/>
                  <a:gd name="connsiteX32" fmla="*/ 1685925 w 1812131"/>
                  <a:gd name="connsiteY32" fmla="*/ 190500 h 219075"/>
                  <a:gd name="connsiteX33" fmla="*/ 1728787 w 1812131"/>
                  <a:gd name="connsiteY33" fmla="*/ 164306 h 219075"/>
                  <a:gd name="connsiteX34" fmla="*/ 1812131 w 1812131"/>
                  <a:gd name="connsiteY34" fmla="*/ 216694 h 219075"/>
                  <a:gd name="connsiteX35" fmla="*/ 1809750 w 1812131"/>
                  <a:gd name="connsiteY35" fmla="*/ 0 h 219075"/>
                  <a:gd name="connsiteX36" fmla="*/ 0 w 1812131"/>
                  <a:gd name="connsiteY36" fmla="*/ 4763 h 2190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</a:cxnLst>
                <a:rect l="l" t="t" r="r" b="b"/>
                <a:pathLst>
                  <a:path w="1812131" h="219075">
                    <a:moveTo>
                      <a:pt x="0" y="4763"/>
                    </a:moveTo>
                    <a:lnTo>
                      <a:pt x="71437" y="54769"/>
                    </a:lnTo>
                    <a:lnTo>
                      <a:pt x="126206" y="121444"/>
                    </a:lnTo>
                    <a:lnTo>
                      <a:pt x="190500" y="76200"/>
                    </a:lnTo>
                    <a:lnTo>
                      <a:pt x="223837" y="30956"/>
                    </a:lnTo>
                    <a:lnTo>
                      <a:pt x="285750" y="73819"/>
                    </a:lnTo>
                    <a:lnTo>
                      <a:pt x="326231" y="83344"/>
                    </a:lnTo>
                    <a:lnTo>
                      <a:pt x="378619" y="161925"/>
                    </a:lnTo>
                    <a:lnTo>
                      <a:pt x="426244" y="190500"/>
                    </a:lnTo>
                    <a:lnTo>
                      <a:pt x="483394" y="157163"/>
                    </a:lnTo>
                    <a:lnTo>
                      <a:pt x="523875" y="64294"/>
                    </a:lnTo>
                    <a:lnTo>
                      <a:pt x="573881" y="57150"/>
                    </a:lnTo>
                    <a:lnTo>
                      <a:pt x="626269" y="80963"/>
                    </a:lnTo>
                    <a:lnTo>
                      <a:pt x="681037" y="121444"/>
                    </a:lnTo>
                    <a:lnTo>
                      <a:pt x="728662" y="211931"/>
                    </a:lnTo>
                    <a:lnTo>
                      <a:pt x="778669" y="202406"/>
                    </a:lnTo>
                    <a:lnTo>
                      <a:pt x="833437" y="219075"/>
                    </a:lnTo>
                    <a:lnTo>
                      <a:pt x="876300" y="161925"/>
                    </a:lnTo>
                    <a:lnTo>
                      <a:pt x="928687" y="183356"/>
                    </a:lnTo>
                    <a:lnTo>
                      <a:pt x="985837" y="130969"/>
                    </a:lnTo>
                    <a:lnTo>
                      <a:pt x="1031081" y="50006"/>
                    </a:lnTo>
                    <a:lnTo>
                      <a:pt x="1083469" y="121444"/>
                    </a:lnTo>
                    <a:lnTo>
                      <a:pt x="1133475" y="52388"/>
                    </a:lnTo>
                    <a:lnTo>
                      <a:pt x="1235869" y="169069"/>
                    </a:lnTo>
                    <a:lnTo>
                      <a:pt x="1283494" y="169069"/>
                    </a:lnTo>
                    <a:lnTo>
                      <a:pt x="1328737" y="204788"/>
                    </a:lnTo>
                    <a:lnTo>
                      <a:pt x="1383506" y="216694"/>
                    </a:lnTo>
                    <a:lnTo>
                      <a:pt x="1435894" y="178594"/>
                    </a:lnTo>
                    <a:lnTo>
                      <a:pt x="1488281" y="180975"/>
                    </a:lnTo>
                    <a:lnTo>
                      <a:pt x="1531144" y="185738"/>
                    </a:lnTo>
                    <a:lnTo>
                      <a:pt x="1581150" y="152400"/>
                    </a:lnTo>
                    <a:lnTo>
                      <a:pt x="1626394" y="178594"/>
                    </a:lnTo>
                    <a:lnTo>
                      <a:pt x="1685925" y="190500"/>
                    </a:lnTo>
                    <a:lnTo>
                      <a:pt x="1728787" y="164306"/>
                    </a:lnTo>
                    <a:lnTo>
                      <a:pt x="1812131" y="216694"/>
                    </a:lnTo>
                    <a:cubicBezTo>
                      <a:pt x="1811337" y="144463"/>
                      <a:pt x="1810544" y="72231"/>
                      <a:pt x="1809750" y="0"/>
                    </a:cubicBezTo>
                    <a:lnTo>
                      <a:pt x="0" y="4763"/>
                    </a:lnTo>
                    <a:close/>
                  </a:path>
                </a:pathLst>
              </a:custGeom>
              <a:solidFill>
                <a:srgbClr val="C00000">
                  <a:alpha val="30196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463"/>
              </a:p>
            </p:txBody>
          </p:sp>
          <p:sp>
            <p:nvSpPr>
              <p:cNvPr id="185" name="Forme libre 184"/>
              <p:cNvSpPr/>
              <p:nvPr/>
            </p:nvSpPr>
            <p:spPr>
              <a:xfrm>
                <a:off x="3145631" y="9182100"/>
                <a:ext cx="180181" cy="171450"/>
              </a:xfrm>
              <a:custGeom>
                <a:avLst/>
                <a:gdLst>
                  <a:gd name="connsiteX0" fmla="*/ 173832 w 180181"/>
                  <a:gd name="connsiteY0" fmla="*/ 2381 h 171450"/>
                  <a:gd name="connsiteX1" fmla="*/ 0 w 180181"/>
                  <a:gd name="connsiteY1" fmla="*/ 0 h 171450"/>
                  <a:gd name="connsiteX2" fmla="*/ 59532 w 180181"/>
                  <a:gd name="connsiteY2" fmla="*/ 21431 h 171450"/>
                  <a:gd name="connsiteX3" fmla="*/ 178594 w 180181"/>
                  <a:gd name="connsiteY3" fmla="*/ 171450 h 171450"/>
                  <a:gd name="connsiteX4" fmla="*/ 173832 w 180181"/>
                  <a:gd name="connsiteY4" fmla="*/ 2381 h 1714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80181" h="171450">
                    <a:moveTo>
                      <a:pt x="173832" y="2381"/>
                    </a:moveTo>
                    <a:lnTo>
                      <a:pt x="0" y="0"/>
                    </a:lnTo>
                    <a:lnTo>
                      <a:pt x="59532" y="21431"/>
                    </a:lnTo>
                    <a:lnTo>
                      <a:pt x="178594" y="171450"/>
                    </a:lnTo>
                    <a:cubicBezTo>
                      <a:pt x="179388" y="115094"/>
                      <a:pt x="180181" y="58737"/>
                      <a:pt x="173832" y="2381"/>
                    </a:cubicBezTo>
                    <a:close/>
                  </a:path>
                </a:pathLst>
              </a:custGeom>
              <a:solidFill>
                <a:srgbClr val="C00000">
                  <a:alpha val="30196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463"/>
              </a:p>
            </p:txBody>
          </p:sp>
        </p:grpSp>
      </p:grpSp>
      <p:grpSp>
        <p:nvGrpSpPr>
          <p:cNvPr id="191" name="Groupe 190"/>
          <p:cNvGrpSpPr/>
          <p:nvPr/>
        </p:nvGrpSpPr>
        <p:grpSpPr>
          <a:xfrm>
            <a:off x="932319" y="585971"/>
            <a:ext cx="4131563" cy="1243784"/>
            <a:chOff x="3093" y="419782"/>
            <a:chExt cx="3520385" cy="2211171"/>
          </a:xfrm>
        </p:grpSpPr>
        <p:grpSp>
          <p:nvGrpSpPr>
            <p:cNvPr id="131" name="Groupe 130"/>
            <p:cNvGrpSpPr/>
            <p:nvPr/>
          </p:nvGrpSpPr>
          <p:grpSpPr>
            <a:xfrm>
              <a:off x="3093" y="419782"/>
              <a:ext cx="3520385" cy="2096085"/>
              <a:chOff x="3093" y="419782"/>
              <a:chExt cx="3520385" cy="2096085"/>
            </a:xfrm>
          </p:grpSpPr>
          <p:grpSp>
            <p:nvGrpSpPr>
              <p:cNvPr id="117" name="Groupe 116"/>
              <p:cNvGrpSpPr/>
              <p:nvPr/>
            </p:nvGrpSpPr>
            <p:grpSpPr>
              <a:xfrm>
                <a:off x="39338" y="419782"/>
                <a:ext cx="3399436" cy="391116"/>
                <a:chOff x="39338" y="419782"/>
                <a:chExt cx="3399436" cy="391116"/>
              </a:xfrm>
            </p:grpSpPr>
            <p:sp>
              <p:nvSpPr>
                <p:cNvPr id="10" name="Rectangle 9"/>
                <p:cNvSpPr/>
                <p:nvPr/>
              </p:nvSpPr>
              <p:spPr>
                <a:xfrm>
                  <a:off x="404664" y="419782"/>
                  <a:ext cx="2916535" cy="144000"/>
                </a:xfrm>
                <a:prstGeom prst="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fr-FR" sz="975" dirty="0">
                      <a:solidFill>
                        <a:schemeClr val="tx1"/>
                      </a:solidFill>
                    </a:rPr>
                    <a:t>ORF1</a:t>
                  </a:r>
                  <a:endParaRPr lang="en-US" sz="975" dirty="0">
                    <a:solidFill>
                      <a:schemeClr val="tx1"/>
                    </a:solidFill>
                  </a:endParaRPr>
                </a:p>
              </p:txBody>
            </p:sp>
            <p:cxnSp>
              <p:nvCxnSpPr>
                <p:cNvPr id="6" name="Connecteur droit 5"/>
                <p:cNvCxnSpPr/>
                <p:nvPr/>
              </p:nvCxnSpPr>
              <p:spPr>
                <a:xfrm>
                  <a:off x="342774" y="572079"/>
                  <a:ext cx="3096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" name="Ellipse 7"/>
                <p:cNvSpPr/>
                <p:nvPr/>
              </p:nvSpPr>
              <p:spPr>
                <a:xfrm>
                  <a:off x="58153" y="476559"/>
                  <a:ext cx="312326" cy="177211"/>
                </a:xfrm>
                <a:prstGeom prst="ellipse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406" b="1" dirty="0"/>
                </a:p>
              </p:txBody>
            </p:sp>
            <p:sp>
              <p:nvSpPr>
                <p:cNvPr id="9" name="ZoneTexte 8"/>
                <p:cNvSpPr txBox="1"/>
                <p:nvPr/>
              </p:nvSpPr>
              <p:spPr>
                <a:xfrm>
                  <a:off x="39338" y="446808"/>
                  <a:ext cx="405595" cy="3640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31" dirty="0" err="1"/>
                    <a:t>VPg</a:t>
                  </a:r>
                  <a:endParaRPr lang="en-US" sz="731" dirty="0"/>
                </a:p>
              </p:txBody>
            </p:sp>
          </p:grpSp>
          <p:grpSp>
            <p:nvGrpSpPr>
              <p:cNvPr id="130" name="Groupe 129"/>
              <p:cNvGrpSpPr/>
              <p:nvPr/>
            </p:nvGrpSpPr>
            <p:grpSpPr>
              <a:xfrm>
                <a:off x="3093" y="443414"/>
                <a:ext cx="3520385" cy="2072453"/>
                <a:chOff x="3093" y="443414"/>
                <a:chExt cx="3520385" cy="2072453"/>
              </a:xfrm>
            </p:grpSpPr>
            <p:pic>
              <p:nvPicPr>
                <p:cNvPr id="118" name="Picture 54"/>
                <p:cNvPicPr preferRelativeResize="0">
                  <a:picLocks noChangeArrowheads="1"/>
                </p:cNvPicPr>
                <p:nvPr/>
              </p:nvPicPr>
              <p:blipFill>
                <a:blip r:embed="rId6" cstate="print"/>
                <a:srcRect l="5780" r="14602"/>
                <a:stretch>
                  <a:fillRect/>
                </a:stretch>
              </p:blipFill>
              <p:spPr bwMode="auto">
                <a:xfrm>
                  <a:off x="345070" y="1564529"/>
                  <a:ext cx="2970000" cy="788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115" name="Picture 62"/>
                <p:cNvPicPr preferRelativeResize="0">
                  <a:picLocks noChangeArrowheads="1"/>
                </p:cNvPicPr>
                <p:nvPr/>
              </p:nvPicPr>
              <p:blipFill>
                <a:blip r:embed="rId7" cstate="print"/>
                <a:srcRect l="6237" r="13368"/>
                <a:stretch>
                  <a:fillRect/>
                </a:stretch>
              </p:blipFill>
              <p:spPr bwMode="auto">
                <a:xfrm>
                  <a:off x="345070" y="718197"/>
                  <a:ext cx="3024000" cy="788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cxnSp>
              <p:nvCxnSpPr>
                <p:cNvPr id="72" name="Connecteur droit 71"/>
                <p:cNvCxnSpPr/>
                <p:nvPr/>
              </p:nvCxnSpPr>
              <p:spPr>
                <a:xfrm>
                  <a:off x="410274" y="659053"/>
                  <a:ext cx="1" cy="165618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4" name="ZoneTexte 20"/>
                <p:cNvSpPr txBox="1">
                  <a:spLocks noChangeArrowheads="1"/>
                </p:cNvSpPr>
                <p:nvPr/>
              </p:nvSpPr>
              <p:spPr bwMode="auto">
                <a:xfrm>
                  <a:off x="1814599" y="1446621"/>
                  <a:ext cx="247496" cy="2976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ctr" eaLnBrk="1" hangingPunct="1"/>
                  <a:r>
                    <a:rPr lang="fr-FR" altLang="en-US" sz="488" dirty="0"/>
                    <a:t>500</a:t>
                  </a:r>
                </a:p>
              </p:txBody>
            </p:sp>
            <p:cxnSp>
              <p:nvCxnSpPr>
                <p:cNvPr id="75" name="Connecteur droit 74"/>
                <p:cNvCxnSpPr/>
                <p:nvPr/>
              </p:nvCxnSpPr>
              <p:spPr>
                <a:xfrm>
                  <a:off x="3324254" y="659053"/>
                  <a:ext cx="1" cy="165618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6" name="ZoneTexte 31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-461691" y="1865611"/>
                  <a:ext cx="1114837" cy="18526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fr-FR" sz="813" i="1" dirty="0" err="1"/>
                    <a:t>Tajima’s</a:t>
                  </a:r>
                  <a:r>
                    <a:rPr lang="fr-FR" sz="813" i="1" dirty="0"/>
                    <a:t> D</a:t>
                  </a:r>
                </a:p>
              </p:txBody>
            </p:sp>
            <p:sp>
              <p:nvSpPr>
                <p:cNvPr id="77" name="ZoneTexte 20"/>
                <p:cNvSpPr txBox="1">
                  <a:spLocks noChangeArrowheads="1"/>
                </p:cNvSpPr>
                <p:nvPr/>
              </p:nvSpPr>
              <p:spPr bwMode="auto">
                <a:xfrm>
                  <a:off x="244200" y="1756251"/>
                  <a:ext cx="232471" cy="2976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fr-FR" altLang="en-US" sz="488" dirty="0"/>
                    <a:t>1.0</a:t>
                  </a:r>
                </a:p>
              </p:txBody>
            </p:sp>
            <p:sp>
              <p:nvSpPr>
                <p:cNvPr id="78" name="ZoneTexte 20"/>
                <p:cNvSpPr txBox="1">
                  <a:spLocks noChangeArrowheads="1"/>
                </p:cNvSpPr>
                <p:nvPr/>
              </p:nvSpPr>
              <p:spPr bwMode="auto">
                <a:xfrm>
                  <a:off x="244200" y="1638427"/>
                  <a:ext cx="232471" cy="2976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fr-FR" altLang="en-US" sz="488" dirty="0"/>
                    <a:t>2.0</a:t>
                  </a:r>
                </a:p>
              </p:txBody>
            </p:sp>
            <p:sp>
              <p:nvSpPr>
                <p:cNvPr id="79" name="ZoneTexte 20"/>
                <p:cNvSpPr txBox="1">
                  <a:spLocks noChangeArrowheads="1"/>
                </p:cNvSpPr>
                <p:nvPr/>
              </p:nvSpPr>
              <p:spPr bwMode="auto">
                <a:xfrm>
                  <a:off x="244200" y="1522317"/>
                  <a:ext cx="232471" cy="2976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fr-FR" altLang="en-US" sz="488" dirty="0"/>
                    <a:t>3.0</a:t>
                  </a:r>
                </a:p>
              </p:txBody>
            </p:sp>
            <p:sp>
              <p:nvSpPr>
                <p:cNvPr id="80" name="ZoneTexte 31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-562858" y="1009365"/>
                  <a:ext cx="1317170" cy="18526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el-GR" sz="813" i="1" dirty="0"/>
                    <a:t>π </a:t>
                  </a:r>
                  <a:r>
                    <a:rPr lang="fr-FR" sz="813" i="1" dirty="0"/>
                    <a:t>(</a:t>
                  </a:r>
                  <a:r>
                    <a:rPr lang="fr-FR" sz="813" i="1" dirty="0" err="1"/>
                    <a:t>subst</a:t>
                  </a:r>
                  <a:r>
                    <a:rPr lang="fr-FR" sz="813" i="1" dirty="0"/>
                    <a:t>/site)</a:t>
                  </a:r>
                </a:p>
              </p:txBody>
            </p:sp>
            <p:sp>
              <p:nvSpPr>
                <p:cNvPr id="81" name="ZoneTexte 20"/>
                <p:cNvSpPr txBox="1">
                  <a:spLocks noChangeArrowheads="1"/>
                </p:cNvSpPr>
                <p:nvPr/>
              </p:nvSpPr>
              <p:spPr bwMode="auto">
                <a:xfrm>
                  <a:off x="214153" y="1189618"/>
                  <a:ext cx="262521" cy="2976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fr-FR" altLang="en-US" sz="488" dirty="0"/>
                    <a:t>0.05</a:t>
                  </a:r>
                </a:p>
              </p:txBody>
            </p:sp>
            <p:sp>
              <p:nvSpPr>
                <p:cNvPr id="82" name="ZoneTexte 20"/>
                <p:cNvSpPr txBox="1">
                  <a:spLocks noChangeArrowheads="1"/>
                </p:cNvSpPr>
                <p:nvPr/>
              </p:nvSpPr>
              <p:spPr bwMode="auto">
                <a:xfrm>
                  <a:off x="214153" y="1015265"/>
                  <a:ext cx="262521" cy="2976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fr-FR" altLang="en-US" sz="488" dirty="0"/>
                    <a:t>0.10</a:t>
                  </a:r>
                </a:p>
              </p:txBody>
            </p:sp>
            <p:sp>
              <p:nvSpPr>
                <p:cNvPr id="83" name="ZoneTexte 20"/>
                <p:cNvSpPr txBox="1">
                  <a:spLocks noChangeArrowheads="1"/>
                </p:cNvSpPr>
                <p:nvPr/>
              </p:nvSpPr>
              <p:spPr bwMode="auto">
                <a:xfrm>
                  <a:off x="214153" y="838248"/>
                  <a:ext cx="262521" cy="2976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fr-FR" altLang="en-US" sz="488" dirty="0"/>
                    <a:t>0.15</a:t>
                  </a:r>
                </a:p>
              </p:txBody>
            </p:sp>
            <p:sp>
              <p:nvSpPr>
                <p:cNvPr id="84" name="ZoneTexte 20"/>
                <p:cNvSpPr txBox="1">
                  <a:spLocks noChangeArrowheads="1"/>
                </p:cNvSpPr>
                <p:nvPr/>
              </p:nvSpPr>
              <p:spPr bwMode="auto">
                <a:xfrm>
                  <a:off x="214153" y="663894"/>
                  <a:ext cx="262521" cy="2976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fr-FR" altLang="en-US" sz="488" dirty="0"/>
                    <a:t>0.20</a:t>
                  </a:r>
                </a:p>
              </p:txBody>
            </p:sp>
            <p:sp>
              <p:nvSpPr>
                <p:cNvPr id="85" name="ZoneTexte 20"/>
                <p:cNvSpPr txBox="1">
                  <a:spLocks noChangeArrowheads="1"/>
                </p:cNvSpPr>
                <p:nvPr/>
              </p:nvSpPr>
              <p:spPr bwMode="auto">
                <a:xfrm>
                  <a:off x="214153" y="1362305"/>
                  <a:ext cx="262521" cy="2976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fr-FR" altLang="en-US" sz="488" dirty="0"/>
                    <a:t>0.00</a:t>
                  </a:r>
                </a:p>
              </p:txBody>
            </p:sp>
            <p:sp>
              <p:nvSpPr>
                <p:cNvPr id="86" name="ZoneTexte 20"/>
                <p:cNvSpPr txBox="1">
                  <a:spLocks noChangeArrowheads="1"/>
                </p:cNvSpPr>
                <p:nvPr/>
              </p:nvSpPr>
              <p:spPr bwMode="auto">
                <a:xfrm>
                  <a:off x="244199" y="1871117"/>
                  <a:ext cx="232471" cy="2976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fr-FR" altLang="en-US" sz="488" dirty="0"/>
                    <a:t>0.0</a:t>
                  </a:r>
                </a:p>
              </p:txBody>
            </p:sp>
            <p:sp>
              <p:nvSpPr>
                <p:cNvPr id="87" name="ZoneTexte 20"/>
                <p:cNvSpPr txBox="1">
                  <a:spLocks noChangeArrowheads="1"/>
                </p:cNvSpPr>
                <p:nvPr/>
              </p:nvSpPr>
              <p:spPr bwMode="auto">
                <a:xfrm>
                  <a:off x="226444" y="2218235"/>
                  <a:ext cx="250228" cy="2976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fr-FR" altLang="en-US" sz="488" dirty="0"/>
                    <a:t>-3.0</a:t>
                  </a:r>
                </a:p>
              </p:txBody>
            </p:sp>
            <p:sp>
              <p:nvSpPr>
                <p:cNvPr id="88" name="ZoneTexte 20"/>
                <p:cNvSpPr txBox="1">
                  <a:spLocks noChangeArrowheads="1"/>
                </p:cNvSpPr>
                <p:nvPr/>
              </p:nvSpPr>
              <p:spPr bwMode="auto">
                <a:xfrm>
                  <a:off x="226444" y="1989627"/>
                  <a:ext cx="250228" cy="2976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fr-FR" altLang="en-US" sz="488" dirty="0"/>
                    <a:t>-1.0</a:t>
                  </a:r>
                </a:p>
              </p:txBody>
            </p:sp>
            <p:sp>
              <p:nvSpPr>
                <p:cNvPr id="89" name="ZoneTexte 20"/>
                <p:cNvSpPr txBox="1">
                  <a:spLocks noChangeArrowheads="1"/>
                </p:cNvSpPr>
                <p:nvPr/>
              </p:nvSpPr>
              <p:spPr bwMode="auto">
                <a:xfrm>
                  <a:off x="226444" y="2104671"/>
                  <a:ext cx="250228" cy="2976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9pPr>
                </a:lstStyle>
                <a:p>
                  <a:pPr algn="r" eaLnBrk="1" hangingPunct="1"/>
                  <a:r>
                    <a:rPr lang="fr-FR" altLang="en-US" sz="488" dirty="0"/>
                    <a:t>-2.0</a:t>
                  </a:r>
                </a:p>
              </p:txBody>
            </p:sp>
            <p:sp>
              <p:nvSpPr>
                <p:cNvPr id="90" name="ZoneTexte 89"/>
                <p:cNvSpPr txBox="1"/>
                <p:nvPr/>
              </p:nvSpPr>
              <p:spPr>
                <a:xfrm rot="16200000">
                  <a:off x="3047981" y="2034622"/>
                  <a:ext cx="744364" cy="20662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488" b="1" dirty="0" err="1">
                      <a:solidFill>
                        <a:srgbClr val="C00000"/>
                      </a:solidFill>
                    </a:rPr>
                    <a:t>Selective</a:t>
                  </a:r>
                  <a:endParaRPr lang="fr-FR" sz="488" b="1" dirty="0">
                    <a:solidFill>
                      <a:srgbClr val="C00000"/>
                    </a:solidFill>
                  </a:endParaRPr>
                </a:p>
                <a:p>
                  <a:pPr algn="ctr"/>
                  <a:r>
                    <a:rPr lang="fr-FR" sz="488" b="1" dirty="0" err="1">
                      <a:solidFill>
                        <a:srgbClr val="C00000"/>
                      </a:solidFill>
                    </a:rPr>
                    <a:t>sweep</a:t>
                  </a:r>
                  <a:endParaRPr lang="fr-FR" sz="488" b="1" dirty="0">
                    <a:solidFill>
                      <a:srgbClr val="C00000"/>
                    </a:solidFill>
                  </a:endParaRPr>
                </a:p>
              </p:txBody>
            </p:sp>
            <p:sp>
              <p:nvSpPr>
                <p:cNvPr id="91" name="ZoneTexte 90"/>
                <p:cNvSpPr txBox="1"/>
                <p:nvPr/>
              </p:nvSpPr>
              <p:spPr>
                <a:xfrm rot="16200000">
                  <a:off x="3032308" y="1687618"/>
                  <a:ext cx="775712" cy="20662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488" b="1" dirty="0" err="1">
                      <a:solidFill>
                        <a:schemeClr val="accent6">
                          <a:lumMod val="75000"/>
                        </a:schemeClr>
                      </a:solidFill>
                    </a:rPr>
                    <a:t>Balancing</a:t>
                  </a:r>
                  <a:endParaRPr lang="fr-FR" sz="488" b="1" dirty="0">
                    <a:solidFill>
                      <a:schemeClr val="accent6">
                        <a:lumMod val="75000"/>
                      </a:schemeClr>
                    </a:solidFill>
                  </a:endParaRPr>
                </a:p>
                <a:p>
                  <a:pPr algn="ctr"/>
                  <a:r>
                    <a:rPr lang="fr-FR" sz="488" b="1" dirty="0" err="1">
                      <a:solidFill>
                        <a:schemeClr val="accent6">
                          <a:lumMod val="75000"/>
                        </a:schemeClr>
                      </a:solidFill>
                    </a:rPr>
                    <a:t>selection</a:t>
                  </a:r>
                  <a:endParaRPr lang="fr-FR" sz="488" b="1" dirty="0">
                    <a:solidFill>
                      <a:schemeClr val="accent6">
                        <a:lumMod val="75000"/>
                      </a:schemeClr>
                    </a:solidFill>
                  </a:endParaRPr>
                </a:p>
              </p:txBody>
            </p:sp>
            <p:cxnSp>
              <p:nvCxnSpPr>
                <p:cNvPr id="92" name="Connecteur droit 91"/>
                <p:cNvCxnSpPr/>
                <p:nvPr/>
              </p:nvCxnSpPr>
              <p:spPr>
                <a:xfrm>
                  <a:off x="404664" y="1960703"/>
                  <a:ext cx="3096000" cy="0"/>
                </a:xfrm>
                <a:prstGeom prst="line">
                  <a:avLst/>
                </a:prstGeom>
                <a:ln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0" name="Forme libre 119"/>
                <p:cNvSpPr/>
                <p:nvPr/>
              </p:nvSpPr>
              <p:spPr>
                <a:xfrm>
                  <a:off x="404664" y="1606676"/>
                  <a:ext cx="2912269" cy="702469"/>
                </a:xfrm>
                <a:custGeom>
                  <a:avLst/>
                  <a:gdLst>
                    <a:gd name="connsiteX0" fmla="*/ 0 w 2912269"/>
                    <a:gd name="connsiteY0" fmla="*/ 0 h 702469"/>
                    <a:gd name="connsiteX1" fmla="*/ 2912269 w 2912269"/>
                    <a:gd name="connsiteY1" fmla="*/ 0 h 702469"/>
                    <a:gd name="connsiteX2" fmla="*/ 2912269 w 2912269"/>
                    <a:gd name="connsiteY2" fmla="*/ 702469 h 702469"/>
                    <a:gd name="connsiteX3" fmla="*/ 0 w 2912269"/>
                    <a:gd name="connsiteY3" fmla="*/ 702469 h 702469"/>
                    <a:gd name="connsiteX4" fmla="*/ 0 w 2912269"/>
                    <a:gd name="connsiteY4" fmla="*/ 0 h 70246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2912269" h="702469">
                      <a:moveTo>
                        <a:pt x="0" y="0"/>
                      </a:moveTo>
                      <a:lnTo>
                        <a:pt x="2912269" y="0"/>
                      </a:lnTo>
                      <a:lnTo>
                        <a:pt x="2912269" y="702469"/>
                      </a:lnTo>
                      <a:lnTo>
                        <a:pt x="0" y="702469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D9D9D9">
                    <a:alpha val="10196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1" name="Forme libre 120"/>
                <p:cNvSpPr/>
                <p:nvPr/>
              </p:nvSpPr>
              <p:spPr>
                <a:xfrm>
                  <a:off x="404664" y="765224"/>
                  <a:ext cx="2912269" cy="702469"/>
                </a:xfrm>
                <a:custGeom>
                  <a:avLst/>
                  <a:gdLst>
                    <a:gd name="connsiteX0" fmla="*/ 0 w 2912269"/>
                    <a:gd name="connsiteY0" fmla="*/ 0 h 702469"/>
                    <a:gd name="connsiteX1" fmla="*/ 2912269 w 2912269"/>
                    <a:gd name="connsiteY1" fmla="*/ 0 h 702469"/>
                    <a:gd name="connsiteX2" fmla="*/ 2912269 w 2912269"/>
                    <a:gd name="connsiteY2" fmla="*/ 702469 h 702469"/>
                    <a:gd name="connsiteX3" fmla="*/ 0 w 2912269"/>
                    <a:gd name="connsiteY3" fmla="*/ 702469 h 702469"/>
                    <a:gd name="connsiteX4" fmla="*/ 0 w 2912269"/>
                    <a:gd name="connsiteY4" fmla="*/ 0 h 70246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2912269" h="702469">
                      <a:moveTo>
                        <a:pt x="0" y="0"/>
                      </a:moveTo>
                      <a:lnTo>
                        <a:pt x="2912269" y="0"/>
                      </a:lnTo>
                      <a:lnTo>
                        <a:pt x="2912269" y="702469"/>
                      </a:lnTo>
                      <a:lnTo>
                        <a:pt x="0" y="702469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D9D9D9">
                    <a:alpha val="10196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2" name="Forme libre 121"/>
                <p:cNvSpPr/>
                <p:nvPr/>
              </p:nvSpPr>
              <p:spPr>
                <a:xfrm>
                  <a:off x="410369" y="1957388"/>
                  <a:ext cx="263525" cy="178593"/>
                </a:xfrm>
                <a:custGeom>
                  <a:avLst/>
                  <a:gdLst>
                    <a:gd name="connsiteX0" fmla="*/ 1587 w 263525"/>
                    <a:gd name="connsiteY0" fmla="*/ 178593 h 178593"/>
                    <a:gd name="connsiteX1" fmla="*/ 113506 w 263525"/>
                    <a:gd name="connsiteY1" fmla="*/ 78581 h 178593"/>
                    <a:gd name="connsiteX2" fmla="*/ 196850 w 263525"/>
                    <a:gd name="connsiteY2" fmla="*/ 76200 h 178593"/>
                    <a:gd name="connsiteX3" fmla="*/ 263525 w 263525"/>
                    <a:gd name="connsiteY3" fmla="*/ 0 h 178593"/>
                    <a:gd name="connsiteX4" fmla="*/ 1587 w 263525"/>
                    <a:gd name="connsiteY4" fmla="*/ 7143 h 178593"/>
                    <a:gd name="connsiteX5" fmla="*/ 1587 w 263525"/>
                    <a:gd name="connsiteY5" fmla="*/ 178593 h 1785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263525" h="178593">
                      <a:moveTo>
                        <a:pt x="1587" y="178593"/>
                      </a:moveTo>
                      <a:lnTo>
                        <a:pt x="113506" y="78581"/>
                      </a:lnTo>
                      <a:lnTo>
                        <a:pt x="196850" y="76200"/>
                      </a:lnTo>
                      <a:lnTo>
                        <a:pt x="263525" y="0"/>
                      </a:lnTo>
                      <a:lnTo>
                        <a:pt x="1587" y="7143"/>
                      </a:lnTo>
                      <a:cubicBezTo>
                        <a:pt x="793" y="63499"/>
                        <a:pt x="0" y="119856"/>
                        <a:pt x="1587" y="178593"/>
                      </a:cubicBezTo>
                      <a:close/>
                    </a:path>
                  </a:pathLst>
                </a:custGeom>
                <a:solidFill>
                  <a:srgbClr val="C00000">
                    <a:alpha val="30196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3" name="Forme libre 122"/>
                <p:cNvSpPr/>
                <p:nvPr/>
              </p:nvSpPr>
              <p:spPr>
                <a:xfrm>
                  <a:off x="407194" y="1962150"/>
                  <a:ext cx="271462" cy="173831"/>
                </a:xfrm>
                <a:custGeom>
                  <a:avLst/>
                  <a:gdLst>
                    <a:gd name="connsiteX0" fmla="*/ 0 w 271462"/>
                    <a:gd name="connsiteY0" fmla="*/ 135731 h 173831"/>
                    <a:gd name="connsiteX1" fmla="*/ 107156 w 271462"/>
                    <a:gd name="connsiteY1" fmla="*/ 173831 h 173831"/>
                    <a:gd name="connsiteX2" fmla="*/ 195262 w 271462"/>
                    <a:gd name="connsiteY2" fmla="*/ 152400 h 173831"/>
                    <a:gd name="connsiteX3" fmla="*/ 271462 w 271462"/>
                    <a:gd name="connsiteY3" fmla="*/ 2381 h 173831"/>
                    <a:gd name="connsiteX4" fmla="*/ 7144 w 271462"/>
                    <a:gd name="connsiteY4" fmla="*/ 0 h 173831"/>
                    <a:gd name="connsiteX5" fmla="*/ 0 w 271462"/>
                    <a:gd name="connsiteY5" fmla="*/ 135731 h 17383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271462" h="173831">
                      <a:moveTo>
                        <a:pt x="0" y="135731"/>
                      </a:moveTo>
                      <a:lnTo>
                        <a:pt x="107156" y="173831"/>
                      </a:lnTo>
                      <a:lnTo>
                        <a:pt x="195262" y="152400"/>
                      </a:lnTo>
                      <a:lnTo>
                        <a:pt x="271462" y="2381"/>
                      </a:lnTo>
                      <a:lnTo>
                        <a:pt x="7144" y="0"/>
                      </a:lnTo>
                      <a:lnTo>
                        <a:pt x="0" y="135731"/>
                      </a:lnTo>
                      <a:close/>
                    </a:path>
                  </a:pathLst>
                </a:custGeom>
                <a:solidFill>
                  <a:srgbClr val="C00000">
                    <a:alpha val="30196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4" name="Forme libre 123"/>
                <p:cNvSpPr/>
                <p:nvPr/>
              </p:nvSpPr>
              <p:spPr>
                <a:xfrm>
                  <a:off x="912019" y="1962150"/>
                  <a:ext cx="523875" cy="169069"/>
                </a:xfrm>
                <a:custGeom>
                  <a:avLst/>
                  <a:gdLst>
                    <a:gd name="connsiteX0" fmla="*/ 0 w 523875"/>
                    <a:gd name="connsiteY0" fmla="*/ 0 h 169069"/>
                    <a:gd name="connsiteX1" fmla="*/ 64294 w 523875"/>
                    <a:gd name="connsiteY1" fmla="*/ 47625 h 169069"/>
                    <a:gd name="connsiteX2" fmla="*/ 147637 w 523875"/>
                    <a:gd name="connsiteY2" fmla="*/ 92869 h 169069"/>
                    <a:gd name="connsiteX3" fmla="*/ 221456 w 523875"/>
                    <a:gd name="connsiteY3" fmla="*/ 123825 h 169069"/>
                    <a:gd name="connsiteX4" fmla="*/ 295275 w 523875"/>
                    <a:gd name="connsiteY4" fmla="*/ 123825 h 169069"/>
                    <a:gd name="connsiteX5" fmla="*/ 378619 w 523875"/>
                    <a:gd name="connsiteY5" fmla="*/ 169069 h 169069"/>
                    <a:gd name="connsiteX6" fmla="*/ 457200 w 523875"/>
                    <a:gd name="connsiteY6" fmla="*/ 130969 h 169069"/>
                    <a:gd name="connsiteX7" fmla="*/ 523875 w 523875"/>
                    <a:gd name="connsiteY7" fmla="*/ 2381 h 169069"/>
                    <a:gd name="connsiteX8" fmla="*/ 0 w 523875"/>
                    <a:gd name="connsiteY8" fmla="*/ 0 h 16906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523875" h="169069">
                      <a:moveTo>
                        <a:pt x="0" y="0"/>
                      </a:moveTo>
                      <a:lnTo>
                        <a:pt x="64294" y="47625"/>
                      </a:lnTo>
                      <a:lnTo>
                        <a:pt x="147637" y="92869"/>
                      </a:lnTo>
                      <a:lnTo>
                        <a:pt x="221456" y="123825"/>
                      </a:lnTo>
                      <a:lnTo>
                        <a:pt x="295275" y="123825"/>
                      </a:lnTo>
                      <a:lnTo>
                        <a:pt x="378619" y="169069"/>
                      </a:lnTo>
                      <a:lnTo>
                        <a:pt x="457200" y="130969"/>
                      </a:lnTo>
                      <a:lnTo>
                        <a:pt x="523875" y="238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C00000">
                    <a:alpha val="30196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5" name="Forme libre 124"/>
                <p:cNvSpPr/>
                <p:nvPr/>
              </p:nvSpPr>
              <p:spPr>
                <a:xfrm>
                  <a:off x="1450181" y="1959769"/>
                  <a:ext cx="1278732" cy="202406"/>
                </a:xfrm>
                <a:custGeom>
                  <a:avLst/>
                  <a:gdLst>
                    <a:gd name="connsiteX0" fmla="*/ 0 w 1278732"/>
                    <a:gd name="connsiteY0" fmla="*/ 4762 h 202406"/>
                    <a:gd name="connsiteX1" fmla="*/ 66675 w 1278732"/>
                    <a:gd name="connsiteY1" fmla="*/ 61912 h 202406"/>
                    <a:gd name="connsiteX2" fmla="*/ 145257 w 1278732"/>
                    <a:gd name="connsiteY2" fmla="*/ 102394 h 202406"/>
                    <a:gd name="connsiteX3" fmla="*/ 223838 w 1278732"/>
                    <a:gd name="connsiteY3" fmla="*/ 78581 h 202406"/>
                    <a:gd name="connsiteX4" fmla="*/ 300038 w 1278732"/>
                    <a:gd name="connsiteY4" fmla="*/ 104775 h 202406"/>
                    <a:gd name="connsiteX5" fmla="*/ 371475 w 1278732"/>
                    <a:gd name="connsiteY5" fmla="*/ 126206 h 202406"/>
                    <a:gd name="connsiteX6" fmla="*/ 447675 w 1278732"/>
                    <a:gd name="connsiteY6" fmla="*/ 119062 h 202406"/>
                    <a:gd name="connsiteX7" fmla="*/ 523875 w 1278732"/>
                    <a:gd name="connsiteY7" fmla="*/ 202406 h 202406"/>
                    <a:gd name="connsiteX8" fmla="*/ 595313 w 1278732"/>
                    <a:gd name="connsiteY8" fmla="*/ 104775 h 202406"/>
                    <a:gd name="connsiteX9" fmla="*/ 678657 w 1278732"/>
                    <a:gd name="connsiteY9" fmla="*/ 130969 h 202406"/>
                    <a:gd name="connsiteX10" fmla="*/ 752475 w 1278732"/>
                    <a:gd name="connsiteY10" fmla="*/ 69056 h 202406"/>
                    <a:gd name="connsiteX11" fmla="*/ 835819 w 1278732"/>
                    <a:gd name="connsiteY11" fmla="*/ 47625 h 202406"/>
                    <a:gd name="connsiteX12" fmla="*/ 890588 w 1278732"/>
                    <a:gd name="connsiteY12" fmla="*/ 59531 h 202406"/>
                    <a:gd name="connsiteX13" fmla="*/ 976313 w 1278732"/>
                    <a:gd name="connsiteY13" fmla="*/ 59531 h 202406"/>
                    <a:gd name="connsiteX14" fmla="*/ 1062038 w 1278732"/>
                    <a:gd name="connsiteY14" fmla="*/ 104775 h 202406"/>
                    <a:gd name="connsiteX15" fmla="*/ 1131094 w 1278732"/>
                    <a:gd name="connsiteY15" fmla="*/ 102394 h 202406"/>
                    <a:gd name="connsiteX16" fmla="*/ 1204913 w 1278732"/>
                    <a:gd name="connsiteY16" fmla="*/ 126206 h 202406"/>
                    <a:gd name="connsiteX17" fmla="*/ 1278732 w 1278732"/>
                    <a:gd name="connsiteY17" fmla="*/ 0 h 202406"/>
                    <a:gd name="connsiteX18" fmla="*/ 0 w 1278732"/>
                    <a:gd name="connsiteY18" fmla="*/ 4762 h 20240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</a:cxnLst>
                  <a:rect l="l" t="t" r="r" b="b"/>
                  <a:pathLst>
                    <a:path w="1278732" h="202406">
                      <a:moveTo>
                        <a:pt x="0" y="4762"/>
                      </a:moveTo>
                      <a:lnTo>
                        <a:pt x="66675" y="61912"/>
                      </a:lnTo>
                      <a:lnTo>
                        <a:pt x="145257" y="102394"/>
                      </a:lnTo>
                      <a:lnTo>
                        <a:pt x="223838" y="78581"/>
                      </a:lnTo>
                      <a:lnTo>
                        <a:pt x="300038" y="104775"/>
                      </a:lnTo>
                      <a:lnTo>
                        <a:pt x="371475" y="126206"/>
                      </a:lnTo>
                      <a:lnTo>
                        <a:pt x="447675" y="119062"/>
                      </a:lnTo>
                      <a:lnTo>
                        <a:pt x="523875" y="202406"/>
                      </a:lnTo>
                      <a:lnTo>
                        <a:pt x="595313" y="104775"/>
                      </a:lnTo>
                      <a:lnTo>
                        <a:pt x="678657" y="130969"/>
                      </a:lnTo>
                      <a:lnTo>
                        <a:pt x="752475" y="69056"/>
                      </a:lnTo>
                      <a:lnTo>
                        <a:pt x="835819" y="47625"/>
                      </a:lnTo>
                      <a:lnTo>
                        <a:pt x="890588" y="59531"/>
                      </a:lnTo>
                      <a:lnTo>
                        <a:pt x="976313" y="59531"/>
                      </a:lnTo>
                      <a:lnTo>
                        <a:pt x="1062038" y="104775"/>
                      </a:lnTo>
                      <a:lnTo>
                        <a:pt x="1131094" y="102394"/>
                      </a:lnTo>
                      <a:lnTo>
                        <a:pt x="1204913" y="126206"/>
                      </a:lnTo>
                      <a:lnTo>
                        <a:pt x="1278732" y="0"/>
                      </a:lnTo>
                      <a:lnTo>
                        <a:pt x="0" y="4762"/>
                      </a:lnTo>
                      <a:close/>
                    </a:path>
                  </a:pathLst>
                </a:custGeom>
                <a:solidFill>
                  <a:srgbClr val="C00000">
                    <a:alpha val="30196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6" name="Forme libre 125"/>
                <p:cNvSpPr/>
                <p:nvPr/>
              </p:nvSpPr>
              <p:spPr>
                <a:xfrm>
                  <a:off x="1902619" y="1955006"/>
                  <a:ext cx="657225" cy="133350"/>
                </a:xfrm>
                <a:custGeom>
                  <a:avLst/>
                  <a:gdLst>
                    <a:gd name="connsiteX0" fmla="*/ 0 w 657225"/>
                    <a:gd name="connsiteY0" fmla="*/ 0 h 133350"/>
                    <a:gd name="connsiteX1" fmla="*/ 71437 w 657225"/>
                    <a:gd name="connsiteY1" fmla="*/ 133350 h 133350"/>
                    <a:gd name="connsiteX2" fmla="*/ 140494 w 657225"/>
                    <a:gd name="connsiteY2" fmla="*/ 85725 h 133350"/>
                    <a:gd name="connsiteX3" fmla="*/ 223837 w 657225"/>
                    <a:gd name="connsiteY3" fmla="*/ 83344 h 133350"/>
                    <a:gd name="connsiteX4" fmla="*/ 300037 w 657225"/>
                    <a:gd name="connsiteY4" fmla="*/ 30957 h 133350"/>
                    <a:gd name="connsiteX5" fmla="*/ 376237 w 657225"/>
                    <a:gd name="connsiteY5" fmla="*/ 59532 h 133350"/>
                    <a:gd name="connsiteX6" fmla="*/ 452437 w 657225"/>
                    <a:gd name="connsiteY6" fmla="*/ 42863 h 133350"/>
                    <a:gd name="connsiteX7" fmla="*/ 531019 w 657225"/>
                    <a:gd name="connsiteY7" fmla="*/ 40482 h 133350"/>
                    <a:gd name="connsiteX8" fmla="*/ 607219 w 657225"/>
                    <a:gd name="connsiteY8" fmla="*/ 64294 h 133350"/>
                    <a:gd name="connsiteX9" fmla="*/ 657225 w 657225"/>
                    <a:gd name="connsiteY9" fmla="*/ 4763 h 133350"/>
                    <a:gd name="connsiteX10" fmla="*/ 0 w 657225"/>
                    <a:gd name="connsiteY10" fmla="*/ 0 h 1333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</a:cxnLst>
                  <a:rect l="l" t="t" r="r" b="b"/>
                  <a:pathLst>
                    <a:path w="657225" h="133350">
                      <a:moveTo>
                        <a:pt x="0" y="0"/>
                      </a:moveTo>
                      <a:lnTo>
                        <a:pt x="71437" y="133350"/>
                      </a:lnTo>
                      <a:lnTo>
                        <a:pt x="140494" y="85725"/>
                      </a:lnTo>
                      <a:lnTo>
                        <a:pt x="223837" y="83344"/>
                      </a:lnTo>
                      <a:lnTo>
                        <a:pt x="300037" y="30957"/>
                      </a:lnTo>
                      <a:lnTo>
                        <a:pt x="376237" y="59532"/>
                      </a:lnTo>
                      <a:lnTo>
                        <a:pt x="452437" y="42863"/>
                      </a:lnTo>
                      <a:lnTo>
                        <a:pt x="531019" y="40482"/>
                      </a:lnTo>
                      <a:lnTo>
                        <a:pt x="607219" y="64294"/>
                      </a:lnTo>
                      <a:lnTo>
                        <a:pt x="657225" y="476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C00000">
                    <a:alpha val="30196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7" name="Forme libre 126"/>
                <p:cNvSpPr/>
                <p:nvPr/>
              </p:nvSpPr>
              <p:spPr>
                <a:xfrm>
                  <a:off x="2733675" y="1959769"/>
                  <a:ext cx="378619" cy="135731"/>
                </a:xfrm>
                <a:custGeom>
                  <a:avLst/>
                  <a:gdLst>
                    <a:gd name="connsiteX0" fmla="*/ 0 w 378619"/>
                    <a:gd name="connsiteY0" fmla="*/ 0 h 135731"/>
                    <a:gd name="connsiteX1" fmla="*/ 80963 w 378619"/>
                    <a:gd name="connsiteY1" fmla="*/ 130969 h 135731"/>
                    <a:gd name="connsiteX2" fmla="*/ 302419 w 378619"/>
                    <a:gd name="connsiteY2" fmla="*/ 135731 h 135731"/>
                    <a:gd name="connsiteX3" fmla="*/ 378619 w 378619"/>
                    <a:gd name="connsiteY3" fmla="*/ 2381 h 135731"/>
                    <a:gd name="connsiteX4" fmla="*/ 0 w 378619"/>
                    <a:gd name="connsiteY4" fmla="*/ 0 h 13573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378619" h="135731">
                      <a:moveTo>
                        <a:pt x="0" y="0"/>
                      </a:moveTo>
                      <a:lnTo>
                        <a:pt x="80963" y="130969"/>
                      </a:lnTo>
                      <a:lnTo>
                        <a:pt x="302419" y="135731"/>
                      </a:lnTo>
                      <a:lnTo>
                        <a:pt x="378619" y="238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C00000">
                    <a:alpha val="30196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8" name="Forme libre 127"/>
                <p:cNvSpPr/>
                <p:nvPr/>
              </p:nvSpPr>
              <p:spPr>
                <a:xfrm>
                  <a:off x="2750344" y="1959769"/>
                  <a:ext cx="578644" cy="138112"/>
                </a:xfrm>
                <a:custGeom>
                  <a:avLst/>
                  <a:gdLst>
                    <a:gd name="connsiteX0" fmla="*/ 0 w 578644"/>
                    <a:gd name="connsiteY0" fmla="*/ 0 h 138112"/>
                    <a:gd name="connsiteX1" fmla="*/ 61912 w 578644"/>
                    <a:gd name="connsiteY1" fmla="*/ 78581 h 138112"/>
                    <a:gd name="connsiteX2" fmla="*/ 135731 w 578644"/>
                    <a:gd name="connsiteY2" fmla="*/ 130969 h 138112"/>
                    <a:gd name="connsiteX3" fmla="*/ 226219 w 578644"/>
                    <a:gd name="connsiteY3" fmla="*/ 138112 h 138112"/>
                    <a:gd name="connsiteX4" fmla="*/ 295275 w 578644"/>
                    <a:gd name="connsiteY4" fmla="*/ 109537 h 138112"/>
                    <a:gd name="connsiteX5" fmla="*/ 361950 w 578644"/>
                    <a:gd name="connsiteY5" fmla="*/ 54769 h 138112"/>
                    <a:gd name="connsiteX6" fmla="*/ 445294 w 578644"/>
                    <a:gd name="connsiteY6" fmla="*/ 119062 h 138112"/>
                    <a:gd name="connsiteX7" fmla="*/ 571500 w 578644"/>
                    <a:gd name="connsiteY7" fmla="*/ 119062 h 138112"/>
                    <a:gd name="connsiteX8" fmla="*/ 578644 w 578644"/>
                    <a:gd name="connsiteY8" fmla="*/ 2381 h 138112"/>
                    <a:gd name="connsiteX9" fmla="*/ 0 w 578644"/>
                    <a:gd name="connsiteY9" fmla="*/ 0 h 13811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578644" h="138112">
                      <a:moveTo>
                        <a:pt x="0" y="0"/>
                      </a:moveTo>
                      <a:lnTo>
                        <a:pt x="61912" y="78581"/>
                      </a:lnTo>
                      <a:lnTo>
                        <a:pt x="135731" y="130969"/>
                      </a:lnTo>
                      <a:lnTo>
                        <a:pt x="226219" y="138112"/>
                      </a:lnTo>
                      <a:lnTo>
                        <a:pt x="295275" y="109537"/>
                      </a:lnTo>
                      <a:lnTo>
                        <a:pt x="361950" y="54769"/>
                      </a:lnTo>
                      <a:lnTo>
                        <a:pt x="445294" y="119062"/>
                      </a:lnTo>
                      <a:lnTo>
                        <a:pt x="571500" y="119062"/>
                      </a:lnTo>
                      <a:lnTo>
                        <a:pt x="578644" y="238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C00000">
                    <a:alpha val="30196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463"/>
                </a:p>
              </p:txBody>
            </p:sp>
            <p:sp>
              <p:nvSpPr>
                <p:cNvPr id="129" name="Forme libre 128"/>
                <p:cNvSpPr/>
                <p:nvPr/>
              </p:nvSpPr>
              <p:spPr>
                <a:xfrm>
                  <a:off x="3119438" y="1964531"/>
                  <a:ext cx="207168" cy="169069"/>
                </a:xfrm>
                <a:custGeom>
                  <a:avLst/>
                  <a:gdLst>
                    <a:gd name="connsiteX0" fmla="*/ 0 w 207168"/>
                    <a:gd name="connsiteY0" fmla="*/ 0 h 169069"/>
                    <a:gd name="connsiteX1" fmla="*/ 78581 w 207168"/>
                    <a:gd name="connsiteY1" fmla="*/ 169069 h 169069"/>
                    <a:gd name="connsiteX2" fmla="*/ 204787 w 207168"/>
                    <a:gd name="connsiteY2" fmla="*/ 169069 h 169069"/>
                    <a:gd name="connsiteX3" fmla="*/ 207168 w 207168"/>
                    <a:gd name="connsiteY3" fmla="*/ 0 h 169069"/>
                    <a:gd name="connsiteX4" fmla="*/ 0 w 207168"/>
                    <a:gd name="connsiteY4" fmla="*/ 0 h 16906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207168" h="169069">
                      <a:moveTo>
                        <a:pt x="0" y="0"/>
                      </a:moveTo>
                      <a:lnTo>
                        <a:pt x="78581" y="169069"/>
                      </a:lnTo>
                      <a:lnTo>
                        <a:pt x="204787" y="169069"/>
                      </a:lnTo>
                      <a:cubicBezTo>
                        <a:pt x="205581" y="112713"/>
                        <a:pt x="206374" y="56356"/>
                        <a:pt x="207168" y="0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C00000">
                    <a:alpha val="30196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463"/>
                </a:p>
              </p:txBody>
            </p:sp>
          </p:grpSp>
        </p:grpSp>
        <p:sp>
          <p:nvSpPr>
            <p:cNvPr id="190" name="ZoneTexte 189"/>
            <p:cNvSpPr txBox="1"/>
            <p:nvPr/>
          </p:nvSpPr>
          <p:spPr>
            <a:xfrm>
              <a:off x="1840356" y="2200066"/>
              <a:ext cx="21061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75" b="1" dirty="0">
                  <a:solidFill>
                    <a:srgbClr val="00B050"/>
                  </a:solidFill>
                </a:rPr>
                <a:t>*</a:t>
              </a:r>
            </a:p>
          </p:txBody>
        </p:sp>
      </p:grpSp>
      <p:sp>
        <p:nvSpPr>
          <p:cNvPr id="192" name="ZoneTexte 191"/>
          <p:cNvSpPr txBox="1"/>
          <p:nvPr/>
        </p:nvSpPr>
        <p:spPr>
          <a:xfrm>
            <a:off x="1205672" y="4568583"/>
            <a:ext cx="7494659" cy="3157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726" b="1" dirty="0" err="1">
                <a:latin typeface="Helvetica" pitchFamily="34" charset="0"/>
              </a:rPr>
              <a:t>Fig</a:t>
            </a:r>
            <a:r>
              <a:rPr lang="fr-FR" sz="726" b="1" dirty="0">
                <a:latin typeface="Helvetica" pitchFamily="34" charset="0"/>
              </a:rPr>
              <a:t> S4: </a:t>
            </a:r>
            <a:r>
              <a:rPr lang="fr-FR" sz="726" b="1" dirty="0" err="1">
                <a:latin typeface="Helvetica" pitchFamily="34" charset="0"/>
              </a:rPr>
              <a:t>Genetic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diversity</a:t>
            </a:r>
            <a:r>
              <a:rPr lang="fr-FR" sz="726" b="1" dirty="0">
                <a:latin typeface="Helvetica" pitchFamily="34" charset="0"/>
              </a:rPr>
              <a:t> analyses of </a:t>
            </a:r>
            <a:r>
              <a:rPr lang="fr-FR" sz="726" b="1" dirty="0" err="1">
                <a:latin typeface="Helvetica" pitchFamily="34" charset="0"/>
              </a:rPr>
              <a:t>satRNA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sequences</a:t>
            </a:r>
            <a:r>
              <a:rPr lang="fr-FR" sz="726" b="1" dirty="0">
                <a:latin typeface="Helvetica" pitchFamily="34" charset="0"/>
              </a:rPr>
              <a:t> (a), GFLV </a:t>
            </a:r>
            <a:r>
              <a:rPr lang="fr-FR" sz="726" b="1" dirty="0" err="1">
                <a:latin typeface="Helvetica" pitchFamily="34" charset="0"/>
              </a:rPr>
              <a:t>cp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gene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sequences</a:t>
            </a:r>
            <a:r>
              <a:rPr lang="fr-FR" sz="726" b="1" dirty="0">
                <a:latin typeface="Helvetica" pitchFamily="34" charset="0"/>
              </a:rPr>
              <a:t> (b) and GFLV </a:t>
            </a:r>
            <a:r>
              <a:rPr lang="fr-FR" sz="726" b="1" i="1" dirty="0" err="1">
                <a:latin typeface="Helvetica" pitchFamily="34" charset="0"/>
              </a:rPr>
              <a:t>cp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gene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sequences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without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cladeI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sequences</a:t>
            </a:r>
            <a:r>
              <a:rPr lang="fr-FR" sz="726" b="1" dirty="0">
                <a:latin typeface="Helvetica" pitchFamily="34" charset="0"/>
              </a:rPr>
              <a:t> (c) all </a:t>
            </a:r>
            <a:r>
              <a:rPr lang="fr-FR" sz="726" b="1" dirty="0" err="1">
                <a:latin typeface="Helvetica" pitchFamily="34" charset="0"/>
              </a:rPr>
              <a:t>from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RNAseq</a:t>
            </a:r>
            <a:r>
              <a:rPr lang="fr-FR" sz="726" b="1" dirty="0">
                <a:latin typeface="Helvetica" pitchFamily="34" charset="0"/>
              </a:rPr>
              <a:t> </a:t>
            </a:r>
            <a:r>
              <a:rPr lang="fr-FR" sz="726" b="1" dirty="0" err="1">
                <a:latin typeface="Helvetica" pitchFamily="34" charset="0"/>
              </a:rPr>
              <a:t>dataset</a:t>
            </a:r>
            <a:endParaRPr lang="en-GB" altLang="en-US" sz="726" b="1" dirty="0">
              <a:solidFill>
                <a:srgbClr val="009900"/>
              </a:solidFill>
              <a:latin typeface="Helvetic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54181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9056000"/>
              </p:ext>
            </p:extLst>
          </p:nvPr>
        </p:nvGraphicFramePr>
        <p:xfrm>
          <a:off x="471488" y="473075"/>
          <a:ext cx="8543927" cy="3965525"/>
        </p:xfrm>
        <a:graphic>
          <a:graphicData uri="http://schemas.openxmlformats.org/drawingml/2006/table">
            <a:tbl>
              <a:tblPr/>
              <a:tblGrid>
                <a:gridCol w="228319"/>
                <a:gridCol w="745040"/>
                <a:gridCol w="745040"/>
                <a:gridCol w="745040"/>
                <a:gridCol w="276386"/>
                <a:gridCol w="745040"/>
                <a:gridCol w="745040"/>
                <a:gridCol w="745040"/>
                <a:gridCol w="745040"/>
                <a:gridCol w="1393946"/>
                <a:gridCol w="1429996"/>
              </a:tblGrid>
              <a:tr h="158621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</a:rPr>
                        <a:t>A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B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C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Leaf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MG-RAST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oil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MG-RAST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FFC000"/>
                          </a:solidFill>
                          <a:effectLst/>
                          <a:latin typeface="Arial" panose="020B0604020202020204" pitchFamily="34" charset="0"/>
                        </a:rPr>
                        <a:t>pinot m/G68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pinot m/T41B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ampling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name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Location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ampling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name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Location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77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240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effectLst/>
                          <a:latin typeface="Arial" panose="020B0604020202020204" pitchFamily="34" charset="0"/>
                        </a:rPr>
                        <a:t>G77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206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219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06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WTR1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WTR1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A10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WTSo1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P2W_S1_R1 and R2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A22-A2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pinot m/T41B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206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19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WTR2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</a:rPr>
                        <a:t>WTR2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A22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WTSo2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P3W_S2_R1 and R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B1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4F81BD"/>
                          </a:solidFill>
                          <a:effectLst/>
                          <a:latin typeface="Arial" panose="020B0604020202020204" pitchFamily="34" charset="0"/>
                        </a:rPr>
                        <a:t>G68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77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40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WTR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</a:rPr>
                        <a:t>WTR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B7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WTSo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P3W_S3_R1 and R4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B19-B20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77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FFC000"/>
                          </a:solidFill>
                          <a:effectLst/>
                          <a:latin typeface="Arial" panose="020B0604020202020204" pitchFamily="34" charset="0"/>
                        </a:rPr>
                        <a:t>pinot m/G68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41B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WTR4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WTR4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B19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GMSo1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P4T_S1_R1 and R2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A13-A14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06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41B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240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WTR5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WTR5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</a:rPr>
                        <a:t>C6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GMSo2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P5T_S2_R1 and R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B4-B5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19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40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219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WTR6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WTR6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</a:rPr>
                        <a:t>C16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GMSo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P5T_S3_R1 and R4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B22-B2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40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19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206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ScWT1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WT1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</a:rPr>
                        <a:t>A4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41B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06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pinot m/T41B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ScWT2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WT2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</a:rPr>
                        <a:t>A2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FFC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219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4F81BD"/>
                          </a:solidFill>
                          <a:effectLst/>
                          <a:latin typeface="Arial" panose="020B0604020202020204" pitchFamily="34" charset="0"/>
                        </a:rPr>
                        <a:t>G68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ScWT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WT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B19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77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FFC000"/>
                          </a:solidFill>
                          <a:effectLst/>
                          <a:latin typeface="Arial" panose="020B0604020202020204" pitchFamily="34" charset="0"/>
                        </a:rPr>
                        <a:t>pinot m/G240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77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ScWT4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WT4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</a:rPr>
                        <a:t>B1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IC-RT-PCR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206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pinot m/T41B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06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ScWT5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WT5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B20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ample name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amples mixed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219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4F81BD"/>
                          </a:solidFill>
                          <a:effectLst/>
                          <a:latin typeface="Arial" panose="020B0604020202020204" pitchFamily="34" charset="0"/>
                        </a:rPr>
                        <a:t>G68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19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ScWT6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WT6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C10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WTRa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WTR1+WTR4+WTR5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15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240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77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40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</a:rPr>
                        <a:t>GMR1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GMR1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A5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WTRb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WTR2+WTR3+WTR6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77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06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41B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</a:rPr>
                        <a:t>GMR2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GMR2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A17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cWTa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cWT1+ScWT5+ScWT6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4F81BD"/>
                          </a:solidFill>
                          <a:effectLst/>
                          <a:latin typeface="Arial" panose="020B0604020202020204" pitchFamily="34" charset="0"/>
                        </a:rPr>
                        <a:t>G68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19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FFC000"/>
                          </a:solidFill>
                          <a:effectLst/>
                          <a:latin typeface="Arial" panose="020B0604020202020204" pitchFamily="34" charset="0"/>
                        </a:rPr>
                        <a:t>pinot m/G68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</a:rPr>
                        <a:t>GMR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GMR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B14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cWTb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cWT2+ScWT3+ScWT4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18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77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40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77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</a:rPr>
                        <a:t>GMR4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GMR4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C11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GMRa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GMR1+GMR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19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06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41B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206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</a:rPr>
                        <a:t>GMR5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GMR5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C20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GMRb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GMR2+GMR4+GMR5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20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19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pinot m/T41B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4F81BD"/>
                          </a:solidFill>
                          <a:effectLst/>
                          <a:latin typeface="Arial" panose="020B0604020202020204" pitchFamily="34" charset="0"/>
                        </a:rPr>
                        <a:t>G68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FFC000"/>
                          </a:solidFill>
                          <a:effectLst/>
                          <a:latin typeface="Arial" panose="020B0604020202020204" pitchFamily="34" charset="0"/>
                        </a:rPr>
                        <a:t>ScGM1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GM1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A1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cGMa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cGM1+ScGM3+ScGM5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240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effectLst/>
                          <a:latin typeface="Arial" panose="020B0604020202020204" pitchFamily="34" charset="0"/>
                        </a:rPr>
                        <a:t>pinot m/G240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G77 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FFC000"/>
                          </a:solidFill>
                          <a:effectLst/>
                          <a:latin typeface="Arial" panose="020B0604020202020204" pitchFamily="34" charset="0"/>
                        </a:rPr>
                        <a:t>ScGM2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GM2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A24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cGMb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cGM2+ScGM4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22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T41B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219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FFC000"/>
                          </a:solidFill>
                          <a:effectLst/>
                          <a:latin typeface="Arial" panose="020B0604020202020204" pitchFamily="34" charset="0"/>
                        </a:rPr>
                        <a:t>pinot m/G68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FFC000"/>
                          </a:solidFill>
                          <a:effectLst/>
                          <a:latin typeface="Arial" panose="020B0604020202020204" pitchFamily="34" charset="0"/>
                        </a:rPr>
                        <a:t>ScGM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GM3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B6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23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</a:rPr>
                        <a:t>pinot m/T41B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206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219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FFC000"/>
                          </a:solidFill>
                          <a:effectLst/>
                          <a:latin typeface="Arial" panose="020B0604020202020204" pitchFamily="34" charset="0"/>
                        </a:rPr>
                        <a:t>ScGM4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GM4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C17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621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7210" marR="7210" marT="721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FFC000"/>
                          </a:solidFill>
                          <a:effectLst/>
                          <a:latin typeface="Arial" panose="020B0604020202020204" pitchFamily="34" charset="0"/>
                        </a:rPr>
                        <a:t>pinot m/G68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77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inot m/G240</a:t>
                      </a:r>
                    </a:p>
                  </a:txBody>
                  <a:tcPr marL="7210" marR="7210" marT="72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FFC000"/>
                          </a:solidFill>
                          <a:effectLst/>
                          <a:latin typeface="Arial" panose="020B0604020202020204" pitchFamily="34" charset="0"/>
                        </a:rPr>
                        <a:t>ScGM5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SGM5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C22</a:t>
                      </a: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210" marR="7210" marT="72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784351" y="4848054"/>
            <a:ext cx="8004049" cy="2339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800" b="1" dirty="0" smtClean="0">
                <a:latin typeface="Helvetica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 S5 : Map of the Greenhouse</a:t>
            </a:r>
            <a:r>
              <a:rPr lang="en-US" sz="800" b="1" dirty="0" smtClean="0">
                <a:solidFill>
                  <a:srgbClr val="FF0000"/>
                </a:solidFill>
                <a:latin typeface="Helvetica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800" b="1" dirty="0">
                <a:latin typeface="Helvetica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800" b="1" dirty="0" smtClean="0">
                <a:latin typeface="Helvetica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say with location of each sample. </a:t>
            </a:r>
            <a:endParaRPr lang="en-US" sz="800" dirty="0">
              <a:latin typeface="Helvetica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587563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</TotalTime>
  <Words>995</Words>
  <Application>Microsoft Office PowerPoint</Application>
  <PresentationFormat>A4 Paper (210x297 mm)</PresentationFormat>
  <Paragraphs>536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Thème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mhily</dc:creator>
  <cp:lastModifiedBy>Ruddock, Jim - Oxford</cp:lastModifiedBy>
  <cp:revision>7</cp:revision>
  <dcterms:created xsi:type="dcterms:W3CDTF">2017-05-10T16:31:23Z</dcterms:created>
  <dcterms:modified xsi:type="dcterms:W3CDTF">2017-05-22T08:27:38Z</dcterms:modified>
</cp:coreProperties>
</file>